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  <Override PartName="/ppt/charts/style3.xml" ContentType="application/vnd.ms-office.chartstyle+xml"/>
  <Override PartName="/ppt/charts/colors3.xml" ContentType="application/vnd.ms-office.chartcolorstyle+xml"/>
  <Override PartName="/ppt/charts/style4.xml" ContentType="application/vnd.ms-office.chartstyle+xml"/>
  <Override PartName="/ppt/charts/colors4.xml" ContentType="application/vnd.ms-office.chartcolorstyle+xml"/>
  <Override PartName="/ppt/charts/style5.xml" ContentType="application/vnd.ms-office.chartstyle+xml"/>
  <Override PartName="/ppt/charts/colors5.xml" ContentType="application/vnd.ms-office.chartcolorstyle+xml"/>
  <Override PartName="/ppt/charts/style6.xml" ContentType="application/vnd.ms-office.chartstyle+xml"/>
  <Override PartName="/ppt/charts/colors6.xml" ContentType="application/vnd.ms-office.chartcolorstyle+xml"/>
  <Override PartName="/ppt/charts/style7.xml" ContentType="application/vnd.ms-office.chartstyle+xml"/>
  <Override PartName="/ppt/charts/colors7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handoutMasterIdLst>
    <p:handoutMasterId r:id="rId12"/>
  </p:handout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6" d="100"/>
          <a:sy n="156" d="100"/>
        </p:scale>
        <p:origin x="-3536" y="-143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handoutMaster" Target="handoutMasters/handoutMaster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4" Type="http://schemas.microsoft.com/office/2011/relationships/chartColorStyle" Target="colors1.xml"/><Relationship Id="rId1" Type="http://schemas.openxmlformats.org/officeDocument/2006/relationships/themeOverride" Target="../theme/themeOverride1.xml"/><Relationship Id="rId2" Type="http://schemas.openxmlformats.org/officeDocument/2006/relationships/oleObject" Target="file:///E:\Dropbox\OXBS%20project\oxBSiDMR&#12414;&#12392;&#12417;_20150710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4" Type="http://schemas.microsoft.com/office/2011/relationships/chartColorStyle" Target="colors2.xml"/><Relationship Id="rId1" Type="http://schemas.openxmlformats.org/officeDocument/2006/relationships/themeOverride" Target="../theme/themeOverride2.xml"/><Relationship Id="rId2" Type="http://schemas.openxmlformats.org/officeDocument/2006/relationships/oleObject" Target="file:///E:\Dropbox\OXBS%20project\oxBSiDMR&#12414;&#12392;&#12417;_20150710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4" Type="http://schemas.microsoft.com/office/2011/relationships/chartColorStyle" Target="colors3.xml"/><Relationship Id="rId1" Type="http://schemas.openxmlformats.org/officeDocument/2006/relationships/themeOverride" Target="../theme/themeOverride3.xml"/><Relationship Id="rId2" Type="http://schemas.openxmlformats.org/officeDocument/2006/relationships/oleObject" Target="file:///E:\Dropbox\OXBS%20project\oxBSiDMR&#12414;&#12392;&#12417;_20150710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4" Type="http://schemas.microsoft.com/office/2011/relationships/chartColorStyle" Target="colors4.xml"/><Relationship Id="rId1" Type="http://schemas.openxmlformats.org/officeDocument/2006/relationships/themeOverride" Target="../theme/themeOverride4.xml"/><Relationship Id="rId2" Type="http://schemas.openxmlformats.org/officeDocument/2006/relationships/oleObject" Target="file:///E:\Dropbox\OXBS%20project\oxBSiDMR&#12414;&#12392;&#12417;_20150710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4" Type="http://schemas.microsoft.com/office/2011/relationships/chartColorStyle" Target="colors5.xml"/><Relationship Id="rId1" Type="http://schemas.openxmlformats.org/officeDocument/2006/relationships/themeOverride" Target="../theme/themeOverride5.xml"/><Relationship Id="rId2" Type="http://schemas.openxmlformats.org/officeDocument/2006/relationships/oleObject" Target="file:///E:\Dropbox\OXBS%20project\oxBSiDMR&#12414;&#12392;&#12417;_20150710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4" Type="http://schemas.microsoft.com/office/2011/relationships/chartColorStyle" Target="colors6.xml"/><Relationship Id="rId1" Type="http://schemas.openxmlformats.org/officeDocument/2006/relationships/themeOverride" Target="../theme/themeOverride6.xml"/><Relationship Id="rId2" Type="http://schemas.openxmlformats.org/officeDocument/2006/relationships/oleObject" Target="file:///E:\Dropbox\OXBS%20project\oxBSiDMR&#12414;&#12392;&#12417;_20150710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4" Type="http://schemas.microsoft.com/office/2011/relationships/chartColorStyle" Target="colors7.xml"/><Relationship Id="rId1" Type="http://schemas.openxmlformats.org/officeDocument/2006/relationships/themeOverride" Target="../theme/themeOverride7.xml"/><Relationship Id="rId2" Type="http://schemas.openxmlformats.org/officeDocument/2006/relationships/oleObject" Target="file:///E:\Dropbox\OXBS%20project\oxBSiDMR&#12414;&#12392;&#12417;_201507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42093720973309"/>
          <c:y val="0.0312184421662157"/>
          <c:w val="0.916902575778676"/>
          <c:h val="0.519455691623548"/>
        </c:manualLayout>
      </c:layout>
      <c:lineChart>
        <c:grouping val="standard"/>
        <c:varyColors val="0"/>
        <c:ser>
          <c:idx val="0"/>
          <c:order val="0"/>
          <c:tx>
            <c:strRef>
              <c:f>Sheet4!$B$1</c:f>
              <c:strCache>
                <c:ptCount val="1"/>
                <c:pt idx="0">
                  <c:v>BS (Pt 1)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B$2:$B$33</c:f>
              <c:numCache>
                <c:formatCode>0.000_ </c:formatCode>
                <c:ptCount val="32"/>
                <c:pt idx="0">
                  <c:v>0.896135</c:v>
                </c:pt>
                <c:pt idx="1">
                  <c:v>0.66507235</c:v>
                </c:pt>
                <c:pt idx="2">
                  <c:v>0.65801125</c:v>
                </c:pt>
                <c:pt idx="3">
                  <c:v>0.82531685</c:v>
                </c:pt>
                <c:pt idx="4">
                  <c:v>0.89115965</c:v>
                </c:pt>
                <c:pt idx="5">
                  <c:v>0.75426975</c:v>
                </c:pt>
                <c:pt idx="6">
                  <c:v>0.7601147</c:v>
                </c:pt>
                <c:pt idx="7">
                  <c:v>0.89995345</c:v>
                </c:pt>
                <c:pt idx="8">
                  <c:v>0.85498535</c:v>
                </c:pt>
                <c:pt idx="9">
                  <c:v>0.87164825</c:v>
                </c:pt>
                <c:pt idx="10">
                  <c:v>0.71350275</c:v>
                </c:pt>
                <c:pt idx="11">
                  <c:v>0.69816595</c:v>
                </c:pt>
                <c:pt idx="12">
                  <c:v>0.79032935</c:v>
                </c:pt>
                <c:pt idx="13">
                  <c:v>0.91614375</c:v>
                </c:pt>
                <c:pt idx="14">
                  <c:v>0.6955497</c:v>
                </c:pt>
                <c:pt idx="15">
                  <c:v>0.72111125</c:v>
                </c:pt>
                <c:pt idx="16">
                  <c:v>0.7651332</c:v>
                </c:pt>
                <c:pt idx="17">
                  <c:v>0.8671583</c:v>
                </c:pt>
                <c:pt idx="18">
                  <c:v>0.7284674</c:v>
                </c:pt>
                <c:pt idx="19">
                  <c:v>0.75609565</c:v>
                </c:pt>
                <c:pt idx="20">
                  <c:v>0.81471885</c:v>
                </c:pt>
                <c:pt idx="21">
                  <c:v>0.8900348</c:v>
                </c:pt>
                <c:pt idx="22">
                  <c:v>0.8908228</c:v>
                </c:pt>
                <c:pt idx="23">
                  <c:v>0.81342045</c:v>
                </c:pt>
                <c:pt idx="24">
                  <c:v>0.81244575</c:v>
                </c:pt>
                <c:pt idx="25">
                  <c:v>0.75224395</c:v>
                </c:pt>
                <c:pt idx="26">
                  <c:v>0.8256007</c:v>
                </c:pt>
                <c:pt idx="27">
                  <c:v>0.8825991</c:v>
                </c:pt>
                <c:pt idx="28">
                  <c:v>0.76525065</c:v>
                </c:pt>
                <c:pt idx="29">
                  <c:v>0.6844121</c:v>
                </c:pt>
                <c:pt idx="30">
                  <c:v>0.6471028</c:v>
                </c:pt>
                <c:pt idx="31">
                  <c:v>0.8458159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4!$C$1</c:f>
              <c:strCache>
                <c:ptCount val="1"/>
                <c:pt idx="0">
                  <c:v>oxBS (Pt 1)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C$2:$C$33</c:f>
              <c:numCache>
                <c:formatCode>0.000_ </c:formatCode>
                <c:ptCount val="32"/>
                <c:pt idx="0">
                  <c:v>0.9127513</c:v>
                </c:pt>
                <c:pt idx="1">
                  <c:v>0.69887505</c:v>
                </c:pt>
                <c:pt idx="2">
                  <c:v>0.66873</c:v>
                </c:pt>
                <c:pt idx="3">
                  <c:v>0.82152225</c:v>
                </c:pt>
                <c:pt idx="4">
                  <c:v>0.87961535</c:v>
                </c:pt>
                <c:pt idx="5">
                  <c:v>0.7296537</c:v>
                </c:pt>
                <c:pt idx="6">
                  <c:v>0.76867255</c:v>
                </c:pt>
                <c:pt idx="7">
                  <c:v>0.8848814</c:v>
                </c:pt>
                <c:pt idx="8">
                  <c:v>0.77799425</c:v>
                </c:pt>
                <c:pt idx="9">
                  <c:v>0.8759693</c:v>
                </c:pt>
                <c:pt idx="10">
                  <c:v>0.78189455</c:v>
                </c:pt>
                <c:pt idx="11">
                  <c:v>0.74772575</c:v>
                </c:pt>
                <c:pt idx="12">
                  <c:v>0.74843</c:v>
                </c:pt>
                <c:pt idx="13">
                  <c:v>0.90843435</c:v>
                </c:pt>
                <c:pt idx="14">
                  <c:v>0.6467838</c:v>
                </c:pt>
                <c:pt idx="15">
                  <c:v>0.76976005</c:v>
                </c:pt>
                <c:pt idx="16">
                  <c:v>0.7471354</c:v>
                </c:pt>
                <c:pt idx="17">
                  <c:v>0.8573276</c:v>
                </c:pt>
                <c:pt idx="18">
                  <c:v>0.7318578</c:v>
                </c:pt>
                <c:pt idx="19">
                  <c:v>0.78279145</c:v>
                </c:pt>
                <c:pt idx="20">
                  <c:v>0.78507235</c:v>
                </c:pt>
                <c:pt idx="21">
                  <c:v>0.9156321</c:v>
                </c:pt>
                <c:pt idx="22">
                  <c:v>0.8898095</c:v>
                </c:pt>
                <c:pt idx="23">
                  <c:v>0.82472975</c:v>
                </c:pt>
                <c:pt idx="24">
                  <c:v>0.83722035</c:v>
                </c:pt>
                <c:pt idx="25">
                  <c:v>0.77724365</c:v>
                </c:pt>
                <c:pt idx="26">
                  <c:v>0.83563165</c:v>
                </c:pt>
                <c:pt idx="27">
                  <c:v>0.88972565</c:v>
                </c:pt>
                <c:pt idx="28">
                  <c:v>0.7636021</c:v>
                </c:pt>
                <c:pt idx="29">
                  <c:v>0.6965759</c:v>
                </c:pt>
                <c:pt idx="30">
                  <c:v>0.7085157</c:v>
                </c:pt>
                <c:pt idx="31">
                  <c:v>0.846122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4!$D$1</c:f>
              <c:strCache>
                <c:ptCount val="1"/>
                <c:pt idx="0">
                  <c:v>BS (Pt 2)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D$2:$D$33</c:f>
              <c:numCache>
                <c:formatCode>0.000_ </c:formatCode>
                <c:ptCount val="32"/>
                <c:pt idx="0">
                  <c:v>0.96596385</c:v>
                </c:pt>
                <c:pt idx="1">
                  <c:v>0.8152777</c:v>
                </c:pt>
                <c:pt idx="2">
                  <c:v>0.73497905</c:v>
                </c:pt>
                <c:pt idx="3">
                  <c:v>0.87030865</c:v>
                </c:pt>
                <c:pt idx="4">
                  <c:v>0.8826358</c:v>
                </c:pt>
                <c:pt idx="5">
                  <c:v>0.7849276</c:v>
                </c:pt>
                <c:pt idx="6">
                  <c:v>0.7535845</c:v>
                </c:pt>
                <c:pt idx="7">
                  <c:v>0.9660813</c:v>
                </c:pt>
                <c:pt idx="8">
                  <c:v>0.9035069</c:v>
                </c:pt>
                <c:pt idx="9">
                  <c:v>0.92747455</c:v>
                </c:pt>
                <c:pt idx="10">
                  <c:v>0.82863835</c:v>
                </c:pt>
                <c:pt idx="11">
                  <c:v>0.81661795</c:v>
                </c:pt>
                <c:pt idx="12">
                  <c:v>0.81579815</c:v>
                </c:pt>
                <c:pt idx="13">
                  <c:v>0.9629377</c:v>
                </c:pt>
                <c:pt idx="14">
                  <c:v>0.72031805</c:v>
                </c:pt>
                <c:pt idx="15">
                  <c:v>0.83378945</c:v>
                </c:pt>
                <c:pt idx="16">
                  <c:v>0.8478444</c:v>
                </c:pt>
                <c:pt idx="17">
                  <c:v>0.91224345</c:v>
                </c:pt>
                <c:pt idx="18">
                  <c:v>0.8616508</c:v>
                </c:pt>
                <c:pt idx="19">
                  <c:v>0.8826242</c:v>
                </c:pt>
                <c:pt idx="20">
                  <c:v>0.90439335</c:v>
                </c:pt>
                <c:pt idx="21">
                  <c:v>0.97364665</c:v>
                </c:pt>
                <c:pt idx="22">
                  <c:v>0.9454754</c:v>
                </c:pt>
                <c:pt idx="23">
                  <c:v>0.8644898</c:v>
                </c:pt>
                <c:pt idx="24">
                  <c:v>0.9219127</c:v>
                </c:pt>
                <c:pt idx="25">
                  <c:v>0.84371965</c:v>
                </c:pt>
                <c:pt idx="26">
                  <c:v>0.94454415</c:v>
                </c:pt>
                <c:pt idx="27">
                  <c:v>0.9670613</c:v>
                </c:pt>
                <c:pt idx="28">
                  <c:v>0.85207795</c:v>
                </c:pt>
                <c:pt idx="29">
                  <c:v>0.79317985</c:v>
                </c:pt>
                <c:pt idx="30">
                  <c:v>0.76481185</c:v>
                </c:pt>
                <c:pt idx="31">
                  <c:v>0.839098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4!$E$1</c:f>
              <c:strCache>
                <c:ptCount val="1"/>
                <c:pt idx="0">
                  <c:v>oxBS (Pt 2)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E$2:$E$33</c:f>
              <c:numCache>
                <c:formatCode>0.000_ </c:formatCode>
                <c:ptCount val="32"/>
                <c:pt idx="0">
                  <c:v>0.9736792</c:v>
                </c:pt>
                <c:pt idx="1">
                  <c:v>0.813905</c:v>
                </c:pt>
                <c:pt idx="2">
                  <c:v>0.7488907</c:v>
                </c:pt>
                <c:pt idx="3">
                  <c:v>0.8441735</c:v>
                </c:pt>
                <c:pt idx="4">
                  <c:v>0.8849502</c:v>
                </c:pt>
                <c:pt idx="5">
                  <c:v>0.7879837</c:v>
                </c:pt>
                <c:pt idx="6">
                  <c:v>0.8332668</c:v>
                </c:pt>
                <c:pt idx="7">
                  <c:v>0.9701293</c:v>
                </c:pt>
                <c:pt idx="8">
                  <c:v>0.84642495</c:v>
                </c:pt>
                <c:pt idx="9">
                  <c:v>0.95691045</c:v>
                </c:pt>
                <c:pt idx="10">
                  <c:v>0.81679435</c:v>
                </c:pt>
                <c:pt idx="11">
                  <c:v>0.79399975</c:v>
                </c:pt>
                <c:pt idx="12">
                  <c:v>0.85322815</c:v>
                </c:pt>
                <c:pt idx="13">
                  <c:v>0.9667309</c:v>
                </c:pt>
                <c:pt idx="14">
                  <c:v>0.62772635</c:v>
                </c:pt>
                <c:pt idx="15">
                  <c:v>0.8639712</c:v>
                </c:pt>
                <c:pt idx="16">
                  <c:v>0.85154215</c:v>
                </c:pt>
                <c:pt idx="17">
                  <c:v>0.8962918</c:v>
                </c:pt>
                <c:pt idx="18">
                  <c:v>0.85016815</c:v>
                </c:pt>
                <c:pt idx="19">
                  <c:v>0.86963635</c:v>
                </c:pt>
                <c:pt idx="20">
                  <c:v>0.8792015</c:v>
                </c:pt>
                <c:pt idx="21">
                  <c:v>0.96400855</c:v>
                </c:pt>
                <c:pt idx="22">
                  <c:v>0.9410324</c:v>
                </c:pt>
                <c:pt idx="23">
                  <c:v>0.8892592</c:v>
                </c:pt>
                <c:pt idx="24">
                  <c:v>0.9245694</c:v>
                </c:pt>
                <c:pt idx="25">
                  <c:v>0.8258463</c:v>
                </c:pt>
                <c:pt idx="26">
                  <c:v>0.95944405</c:v>
                </c:pt>
                <c:pt idx="27">
                  <c:v>0.97142445</c:v>
                </c:pt>
                <c:pt idx="28">
                  <c:v>0.87161195</c:v>
                </c:pt>
                <c:pt idx="29">
                  <c:v>0.8032494</c:v>
                </c:pt>
                <c:pt idx="30">
                  <c:v>0.7519722</c:v>
                </c:pt>
                <c:pt idx="31">
                  <c:v>0.8393651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4!$F$1</c:f>
              <c:strCache>
                <c:ptCount val="1"/>
                <c:pt idx="0">
                  <c:v>BS (Pt 3)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F$2:$F$33</c:f>
              <c:numCache>
                <c:formatCode>0.000_ </c:formatCode>
                <c:ptCount val="32"/>
                <c:pt idx="0">
                  <c:v>0.95721135</c:v>
                </c:pt>
                <c:pt idx="1">
                  <c:v>0.7835663</c:v>
                </c:pt>
                <c:pt idx="2">
                  <c:v>0.7154104</c:v>
                </c:pt>
                <c:pt idx="3">
                  <c:v>0.8062572</c:v>
                </c:pt>
                <c:pt idx="4">
                  <c:v>0.86337145</c:v>
                </c:pt>
                <c:pt idx="5">
                  <c:v>0.8204738</c:v>
                </c:pt>
                <c:pt idx="6">
                  <c:v>0.82341625</c:v>
                </c:pt>
                <c:pt idx="7">
                  <c:v>0.95043455</c:v>
                </c:pt>
                <c:pt idx="8">
                  <c:v>0.8493092</c:v>
                </c:pt>
                <c:pt idx="9">
                  <c:v>0.94594685</c:v>
                </c:pt>
                <c:pt idx="10">
                  <c:v>0.80841315</c:v>
                </c:pt>
                <c:pt idx="11">
                  <c:v>0.83524025</c:v>
                </c:pt>
                <c:pt idx="12">
                  <c:v>0.8403517</c:v>
                </c:pt>
                <c:pt idx="13">
                  <c:v>0.9527681</c:v>
                </c:pt>
                <c:pt idx="14">
                  <c:v>0.6919762</c:v>
                </c:pt>
                <c:pt idx="15">
                  <c:v>0.80217675</c:v>
                </c:pt>
                <c:pt idx="16">
                  <c:v>0.8422326</c:v>
                </c:pt>
                <c:pt idx="17">
                  <c:v>0.93150205</c:v>
                </c:pt>
                <c:pt idx="18">
                  <c:v>0.8569028</c:v>
                </c:pt>
                <c:pt idx="19">
                  <c:v>0.7962745</c:v>
                </c:pt>
                <c:pt idx="20">
                  <c:v>0.87886715</c:v>
                </c:pt>
                <c:pt idx="21">
                  <c:v>0.94229515</c:v>
                </c:pt>
                <c:pt idx="22">
                  <c:v>0.93096105</c:v>
                </c:pt>
                <c:pt idx="23">
                  <c:v>0.82746355</c:v>
                </c:pt>
                <c:pt idx="24">
                  <c:v>0.8989276</c:v>
                </c:pt>
                <c:pt idx="25">
                  <c:v>0.8383036</c:v>
                </c:pt>
                <c:pt idx="26">
                  <c:v>0.94002315</c:v>
                </c:pt>
                <c:pt idx="27">
                  <c:v>0.95678145</c:v>
                </c:pt>
                <c:pt idx="28">
                  <c:v>0.85313635</c:v>
                </c:pt>
                <c:pt idx="29">
                  <c:v>0.75722535</c:v>
                </c:pt>
                <c:pt idx="30">
                  <c:v>0.7760434</c:v>
                </c:pt>
                <c:pt idx="31">
                  <c:v>0.8649926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Sheet4!$G$1</c:f>
              <c:strCache>
                <c:ptCount val="1"/>
                <c:pt idx="0">
                  <c:v>oxBS (Pt 3)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G$2:$G$33</c:f>
              <c:numCache>
                <c:formatCode>0.000_ </c:formatCode>
                <c:ptCount val="32"/>
                <c:pt idx="0">
                  <c:v>0.9485409</c:v>
                </c:pt>
                <c:pt idx="1">
                  <c:v>0.7825039</c:v>
                </c:pt>
                <c:pt idx="2">
                  <c:v>0.7184989</c:v>
                </c:pt>
                <c:pt idx="3">
                  <c:v>0.8539833</c:v>
                </c:pt>
                <c:pt idx="4">
                  <c:v>0.88389475</c:v>
                </c:pt>
                <c:pt idx="5">
                  <c:v>0.7938443</c:v>
                </c:pt>
                <c:pt idx="6">
                  <c:v>0.8394771</c:v>
                </c:pt>
                <c:pt idx="7">
                  <c:v>0.95901325</c:v>
                </c:pt>
                <c:pt idx="8">
                  <c:v>0.85199785</c:v>
                </c:pt>
                <c:pt idx="9">
                  <c:v>0.91069765</c:v>
                </c:pt>
                <c:pt idx="10">
                  <c:v>0.8485341</c:v>
                </c:pt>
                <c:pt idx="11">
                  <c:v>0.8220696</c:v>
                </c:pt>
                <c:pt idx="12">
                  <c:v>0.84925325</c:v>
                </c:pt>
                <c:pt idx="13">
                  <c:v>0.95588475</c:v>
                </c:pt>
                <c:pt idx="14">
                  <c:v>0.7371539</c:v>
                </c:pt>
                <c:pt idx="15">
                  <c:v>0.8080086</c:v>
                </c:pt>
                <c:pt idx="16">
                  <c:v>0.8223272</c:v>
                </c:pt>
                <c:pt idx="17">
                  <c:v>0.9295158</c:v>
                </c:pt>
                <c:pt idx="18">
                  <c:v>0.83921725</c:v>
                </c:pt>
                <c:pt idx="19">
                  <c:v>0.87690415</c:v>
                </c:pt>
                <c:pt idx="20">
                  <c:v>0.89649915</c:v>
                </c:pt>
                <c:pt idx="21">
                  <c:v>0.9676649</c:v>
                </c:pt>
                <c:pt idx="22">
                  <c:v>0.9545635</c:v>
                </c:pt>
                <c:pt idx="23">
                  <c:v>0.87278255</c:v>
                </c:pt>
                <c:pt idx="24">
                  <c:v>0.9144605</c:v>
                </c:pt>
                <c:pt idx="25">
                  <c:v>0.8617587</c:v>
                </c:pt>
                <c:pt idx="26">
                  <c:v>0.941946</c:v>
                </c:pt>
                <c:pt idx="27">
                  <c:v>0.95269845</c:v>
                </c:pt>
                <c:pt idx="28">
                  <c:v>0.8543157</c:v>
                </c:pt>
                <c:pt idx="29">
                  <c:v>0.8126917</c:v>
                </c:pt>
                <c:pt idx="30">
                  <c:v>0.7694348</c:v>
                </c:pt>
                <c:pt idx="31">
                  <c:v>0.842334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Sheet4!$H$1</c:f>
              <c:strCache>
                <c:ptCount val="1"/>
                <c:pt idx="0">
                  <c:v>BS (Cont)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>
                  <a:alpha val="99000"/>
                </a:srgbClr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H$2:$H$33</c:f>
              <c:numCache>
                <c:formatCode>0.000_ </c:formatCode>
                <c:ptCount val="32"/>
                <c:pt idx="0">
                  <c:v>0.6107707</c:v>
                </c:pt>
                <c:pt idx="1">
                  <c:v>0.3824322</c:v>
                </c:pt>
                <c:pt idx="2">
                  <c:v>0.44789655</c:v>
                </c:pt>
                <c:pt idx="3">
                  <c:v>0.40804995</c:v>
                </c:pt>
                <c:pt idx="4">
                  <c:v>0.6109297</c:v>
                </c:pt>
                <c:pt idx="5">
                  <c:v>0.37578775</c:v>
                </c:pt>
                <c:pt idx="6">
                  <c:v>0.37702105</c:v>
                </c:pt>
                <c:pt idx="7">
                  <c:v>0.5503575</c:v>
                </c:pt>
                <c:pt idx="8">
                  <c:v>0.39858895</c:v>
                </c:pt>
                <c:pt idx="9">
                  <c:v>0.5199197</c:v>
                </c:pt>
                <c:pt idx="10">
                  <c:v>0.4114067</c:v>
                </c:pt>
                <c:pt idx="11">
                  <c:v>0.45773575</c:v>
                </c:pt>
                <c:pt idx="12">
                  <c:v>0.3960306</c:v>
                </c:pt>
                <c:pt idx="13">
                  <c:v>0.5895963</c:v>
                </c:pt>
                <c:pt idx="14">
                  <c:v>0.3767715</c:v>
                </c:pt>
                <c:pt idx="15">
                  <c:v>0.409878</c:v>
                </c:pt>
                <c:pt idx="16">
                  <c:v>0.3933383</c:v>
                </c:pt>
                <c:pt idx="17">
                  <c:v>0.4470745</c:v>
                </c:pt>
                <c:pt idx="18">
                  <c:v>0.25664335</c:v>
                </c:pt>
                <c:pt idx="19">
                  <c:v>0.24279035</c:v>
                </c:pt>
                <c:pt idx="20">
                  <c:v>0.2877189</c:v>
                </c:pt>
                <c:pt idx="21">
                  <c:v>0.44589095</c:v>
                </c:pt>
                <c:pt idx="22">
                  <c:v>0.4608624</c:v>
                </c:pt>
                <c:pt idx="23">
                  <c:v>0.32270625</c:v>
                </c:pt>
                <c:pt idx="24">
                  <c:v>0.4212793</c:v>
                </c:pt>
                <c:pt idx="25">
                  <c:v>0.3086818</c:v>
                </c:pt>
                <c:pt idx="26">
                  <c:v>0.3862915</c:v>
                </c:pt>
                <c:pt idx="27">
                  <c:v>0.44612385</c:v>
                </c:pt>
                <c:pt idx="28">
                  <c:v>0.3713742</c:v>
                </c:pt>
                <c:pt idx="29">
                  <c:v>0.3432235</c:v>
                </c:pt>
                <c:pt idx="30">
                  <c:v>0.388595</c:v>
                </c:pt>
                <c:pt idx="31">
                  <c:v>0.4004457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Sheet4!$I$1</c:f>
              <c:strCache>
                <c:ptCount val="1"/>
                <c:pt idx="0">
                  <c:v>oxBS (Cont)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I$2:$I$33</c:f>
              <c:numCache>
                <c:formatCode>0.000_ </c:formatCode>
                <c:ptCount val="32"/>
                <c:pt idx="0">
                  <c:v>0.62808095</c:v>
                </c:pt>
                <c:pt idx="1">
                  <c:v>0.39505745</c:v>
                </c:pt>
                <c:pt idx="2">
                  <c:v>0.3919024</c:v>
                </c:pt>
                <c:pt idx="3">
                  <c:v>0.37790115</c:v>
                </c:pt>
                <c:pt idx="4">
                  <c:v>0.5833208</c:v>
                </c:pt>
                <c:pt idx="5">
                  <c:v>0.38924775</c:v>
                </c:pt>
                <c:pt idx="6">
                  <c:v>0.3510109</c:v>
                </c:pt>
                <c:pt idx="7">
                  <c:v>0.55728575</c:v>
                </c:pt>
                <c:pt idx="8">
                  <c:v>0.3677872</c:v>
                </c:pt>
                <c:pt idx="9">
                  <c:v>0.4860276</c:v>
                </c:pt>
                <c:pt idx="10">
                  <c:v>0.39976145</c:v>
                </c:pt>
                <c:pt idx="11">
                  <c:v>0.4740007</c:v>
                </c:pt>
                <c:pt idx="12">
                  <c:v>0.33405445</c:v>
                </c:pt>
                <c:pt idx="13">
                  <c:v>0.5907302</c:v>
                </c:pt>
                <c:pt idx="14">
                  <c:v>0.37881705</c:v>
                </c:pt>
                <c:pt idx="15">
                  <c:v>0.4478729</c:v>
                </c:pt>
                <c:pt idx="16">
                  <c:v>0.3723679</c:v>
                </c:pt>
                <c:pt idx="17">
                  <c:v>0.48738395</c:v>
                </c:pt>
                <c:pt idx="18">
                  <c:v>0.2967987</c:v>
                </c:pt>
                <c:pt idx="19">
                  <c:v>0.30371035</c:v>
                </c:pt>
                <c:pt idx="20">
                  <c:v>0.31701405</c:v>
                </c:pt>
                <c:pt idx="21">
                  <c:v>0.4341622</c:v>
                </c:pt>
                <c:pt idx="22">
                  <c:v>0.4293449</c:v>
                </c:pt>
                <c:pt idx="23">
                  <c:v>0.34722505</c:v>
                </c:pt>
                <c:pt idx="24">
                  <c:v>0.3780144</c:v>
                </c:pt>
                <c:pt idx="25">
                  <c:v>0.3204529</c:v>
                </c:pt>
                <c:pt idx="26">
                  <c:v>0.41374385</c:v>
                </c:pt>
                <c:pt idx="27">
                  <c:v>0.45711825</c:v>
                </c:pt>
                <c:pt idx="28">
                  <c:v>0.33452275</c:v>
                </c:pt>
                <c:pt idx="29">
                  <c:v>0.32904975</c:v>
                </c:pt>
                <c:pt idx="30">
                  <c:v>0.3715009</c:v>
                </c:pt>
                <c:pt idx="31">
                  <c:v>0.5118849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Sheet4!$J$1</c:f>
              <c:strCache>
                <c:ptCount val="1"/>
                <c:pt idx="0">
                  <c:v>BS (Brain)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J$2:$J$33</c:f>
              <c:numCache>
                <c:formatCode>0.000_ </c:formatCode>
                <c:ptCount val="32"/>
                <c:pt idx="0">
                  <c:v>0.5704127</c:v>
                </c:pt>
                <c:pt idx="1">
                  <c:v>0.327652</c:v>
                </c:pt>
                <c:pt idx="2">
                  <c:v>0.3938575</c:v>
                </c:pt>
                <c:pt idx="3">
                  <c:v>0.39133685</c:v>
                </c:pt>
                <c:pt idx="4">
                  <c:v>0.6564845</c:v>
                </c:pt>
                <c:pt idx="5">
                  <c:v>0.32509265</c:v>
                </c:pt>
                <c:pt idx="6">
                  <c:v>0.4121063</c:v>
                </c:pt>
                <c:pt idx="7">
                  <c:v>0.6659634</c:v>
                </c:pt>
                <c:pt idx="8">
                  <c:v>0.3100528</c:v>
                </c:pt>
                <c:pt idx="9">
                  <c:v>0.50371395</c:v>
                </c:pt>
                <c:pt idx="10">
                  <c:v>0.4394673</c:v>
                </c:pt>
                <c:pt idx="11">
                  <c:v>0.49831295</c:v>
                </c:pt>
                <c:pt idx="12">
                  <c:v>0.3585705</c:v>
                </c:pt>
                <c:pt idx="13">
                  <c:v>0.60887495</c:v>
                </c:pt>
                <c:pt idx="14">
                  <c:v>0.3915626</c:v>
                </c:pt>
                <c:pt idx="15">
                  <c:v>0.4639261</c:v>
                </c:pt>
                <c:pt idx="16">
                  <c:v>0.35353995</c:v>
                </c:pt>
                <c:pt idx="17">
                  <c:v>0.2550116</c:v>
                </c:pt>
                <c:pt idx="18">
                  <c:v>0.2005656</c:v>
                </c:pt>
                <c:pt idx="19">
                  <c:v>0.21948725</c:v>
                </c:pt>
                <c:pt idx="20">
                  <c:v>0.2992478</c:v>
                </c:pt>
                <c:pt idx="21">
                  <c:v>0.3591242</c:v>
                </c:pt>
                <c:pt idx="22">
                  <c:v>0.28898705</c:v>
                </c:pt>
                <c:pt idx="23">
                  <c:v>0.29647085</c:v>
                </c:pt>
                <c:pt idx="24">
                  <c:v>0.3939771</c:v>
                </c:pt>
                <c:pt idx="25">
                  <c:v>0.2611969</c:v>
                </c:pt>
                <c:pt idx="26">
                  <c:v>0.3581589</c:v>
                </c:pt>
                <c:pt idx="27">
                  <c:v>0.38288745</c:v>
                </c:pt>
                <c:pt idx="28">
                  <c:v>0.27943395</c:v>
                </c:pt>
                <c:pt idx="29">
                  <c:v>0.30417315</c:v>
                </c:pt>
                <c:pt idx="30">
                  <c:v>0.31174555</c:v>
                </c:pt>
                <c:pt idx="31">
                  <c:v>0.3042213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Sheet4!$K$1</c:f>
              <c:strCache>
                <c:ptCount val="1"/>
                <c:pt idx="0">
                  <c:v>oxBS (Brain)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Sheet4!$A$2:$A$33</c:f>
              <c:strCache>
                <c:ptCount val="32"/>
                <c:pt idx="0">
                  <c:v>cg00764369</c:v>
                </c:pt>
                <c:pt idx="1">
                  <c:v>cg10515315</c:v>
                </c:pt>
                <c:pt idx="2">
                  <c:v>cg15991553</c:v>
                </c:pt>
                <c:pt idx="3">
                  <c:v>cg23870378</c:v>
                </c:pt>
                <c:pt idx="4">
                  <c:v>cg14034270</c:v>
                </c:pt>
                <c:pt idx="5">
                  <c:v>cg16567044</c:v>
                </c:pt>
                <c:pt idx="6">
                  <c:v>cg10540302</c:v>
                </c:pt>
                <c:pt idx="7">
                  <c:v>cg02313552</c:v>
                </c:pt>
                <c:pt idx="8">
                  <c:v>cg02982753</c:v>
                </c:pt>
                <c:pt idx="9">
                  <c:v>cg02888166</c:v>
                </c:pt>
                <c:pt idx="10">
                  <c:v>cg24089209</c:v>
                </c:pt>
                <c:pt idx="11">
                  <c:v>cg16738180</c:v>
                </c:pt>
                <c:pt idx="12">
                  <c:v>cg19643803</c:v>
                </c:pt>
                <c:pt idx="13">
                  <c:v>cg10943497</c:v>
                </c:pt>
                <c:pt idx="14">
                  <c:v>cg10065153</c:v>
                </c:pt>
                <c:pt idx="15">
                  <c:v>cg09280976</c:v>
                </c:pt>
                <c:pt idx="16">
                  <c:v>cg22940816</c:v>
                </c:pt>
                <c:pt idx="17">
                  <c:v>cg14070323</c:v>
                </c:pt>
                <c:pt idx="18">
                  <c:v>cg14119337</c:v>
                </c:pt>
                <c:pt idx="19">
                  <c:v>cg20952167</c:v>
                </c:pt>
                <c:pt idx="20">
                  <c:v>cg12967319</c:v>
                </c:pt>
                <c:pt idx="21">
                  <c:v>cg04304932</c:v>
                </c:pt>
                <c:pt idx="22">
                  <c:v>cg04576764</c:v>
                </c:pt>
                <c:pt idx="23">
                  <c:v>cg25836301</c:v>
                </c:pt>
                <c:pt idx="24">
                  <c:v>cg09926418</c:v>
                </c:pt>
                <c:pt idx="25">
                  <c:v>cg23176399</c:v>
                </c:pt>
                <c:pt idx="26">
                  <c:v>cg05711886</c:v>
                </c:pt>
                <c:pt idx="27">
                  <c:v>cg15419911</c:v>
                </c:pt>
                <c:pt idx="28">
                  <c:v>cg15373285</c:v>
                </c:pt>
                <c:pt idx="29">
                  <c:v>cg14123427</c:v>
                </c:pt>
                <c:pt idx="30">
                  <c:v>cg15101633</c:v>
                </c:pt>
                <c:pt idx="31">
                  <c:v>cg26374305</c:v>
                </c:pt>
              </c:strCache>
            </c:strRef>
          </c:cat>
          <c:val>
            <c:numRef>
              <c:f>Sheet4!$K$2:$K$33</c:f>
              <c:numCache>
                <c:formatCode>0.000_ </c:formatCode>
                <c:ptCount val="32"/>
                <c:pt idx="0">
                  <c:v>0.54400225</c:v>
                </c:pt>
                <c:pt idx="1">
                  <c:v>0.2676784</c:v>
                </c:pt>
                <c:pt idx="2">
                  <c:v>0.38378885</c:v>
                </c:pt>
                <c:pt idx="3">
                  <c:v>0.36848365</c:v>
                </c:pt>
                <c:pt idx="4">
                  <c:v>0.4680197</c:v>
                </c:pt>
                <c:pt idx="5">
                  <c:v>0.29780605</c:v>
                </c:pt>
                <c:pt idx="6">
                  <c:v>0.34548525</c:v>
                </c:pt>
                <c:pt idx="7">
                  <c:v>0.5615594</c:v>
                </c:pt>
                <c:pt idx="8">
                  <c:v>0.28859585</c:v>
                </c:pt>
                <c:pt idx="9">
                  <c:v>0.27878215</c:v>
                </c:pt>
                <c:pt idx="10">
                  <c:v>0.4582338</c:v>
                </c:pt>
                <c:pt idx="11">
                  <c:v>0.5007204</c:v>
                </c:pt>
                <c:pt idx="12">
                  <c:v>0.2713753</c:v>
                </c:pt>
                <c:pt idx="13">
                  <c:v>0.51517505</c:v>
                </c:pt>
                <c:pt idx="14">
                  <c:v>0.29250915</c:v>
                </c:pt>
                <c:pt idx="15">
                  <c:v>0.42846565</c:v>
                </c:pt>
                <c:pt idx="16">
                  <c:v>0.3705788</c:v>
                </c:pt>
                <c:pt idx="17">
                  <c:v>0.5322464</c:v>
                </c:pt>
                <c:pt idx="18">
                  <c:v>0.29204615</c:v>
                </c:pt>
                <c:pt idx="19">
                  <c:v>0.2852203</c:v>
                </c:pt>
                <c:pt idx="20">
                  <c:v>0.3435834</c:v>
                </c:pt>
                <c:pt idx="21">
                  <c:v>0.43537825</c:v>
                </c:pt>
                <c:pt idx="22">
                  <c:v>0.4490314</c:v>
                </c:pt>
                <c:pt idx="23">
                  <c:v>0.36347195</c:v>
                </c:pt>
                <c:pt idx="24">
                  <c:v>0.3384296</c:v>
                </c:pt>
                <c:pt idx="25">
                  <c:v>0.30232295</c:v>
                </c:pt>
                <c:pt idx="26">
                  <c:v>0.3620754</c:v>
                </c:pt>
                <c:pt idx="27">
                  <c:v>0.3711782</c:v>
                </c:pt>
                <c:pt idx="28">
                  <c:v>0.3480694</c:v>
                </c:pt>
                <c:pt idx="29">
                  <c:v>0.30906145</c:v>
                </c:pt>
                <c:pt idx="30">
                  <c:v>0.3269014</c:v>
                </c:pt>
                <c:pt idx="31">
                  <c:v>0.2698431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5585608"/>
        <c:axId val="-2123607416"/>
      </c:lineChart>
      <c:catAx>
        <c:axId val="-2125585608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23607416"/>
        <c:crosses val="autoZero"/>
        <c:auto val="1"/>
        <c:lblAlgn val="ctr"/>
        <c:lblOffset val="100"/>
        <c:noMultiLvlLbl val="0"/>
      </c:catAx>
      <c:valAx>
        <c:axId val="-2123607416"/>
        <c:scaling>
          <c:orientation val="minMax"/>
          <c:max val="1.0"/>
          <c:min val="0.0"/>
        </c:scaling>
        <c:delete val="0"/>
        <c:axPos val="l"/>
        <c:numFmt formatCode="0.000_ " sourceLinked="1"/>
        <c:majorTickMark val="cross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255856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6653576112095"/>
          <c:y val="0.122062050958955"/>
          <c:w val="0.830583254916923"/>
          <c:h val="0.614296391187305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1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F$2:$F$18</c:f>
              <c:numCache>
                <c:formatCode>General</c:formatCode>
                <c:ptCount val="17"/>
                <c:pt idx="0">
                  <c:v>0.58473725</c:v>
                </c:pt>
                <c:pt idx="1">
                  <c:v>0.34118505</c:v>
                </c:pt>
                <c:pt idx="2">
                  <c:v>0.2891073</c:v>
                </c:pt>
                <c:pt idx="3">
                  <c:v>0.3418078</c:v>
                </c:pt>
                <c:pt idx="4">
                  <c:v>0.3027146</c:v>
                </c:pt>
                <c:pt idx="5">
                  <c:v>0.43332715</c:v>
                </c:pt>
                <c:pt idx="6">
                  <c:v>0.4397772</c:v>
                </c:pt>
                <c:pt idx="7">
                  <c:v>0.384774</c:v>
                </c:pt>
                <c:pt idx="8">
                  <c:v>0.2942884</c:v>
                </c:pt>
                <c:pt idx="9">
                  <c:v>0.28653615</c:v>
                </c:pt>
                <c:pt idx="10">
                  <c:v>0.41334165</c:v>
                </c:pt>
                <c:pt idx="11">
                  <c:v>0.3018873</c:v>
                </c:pt>
                <c:pt idx="12">
                  <c:v>0.33140635</c:v>
                </c:pt>
                <c:pt idx="13">
                  <c:v>0.34351135</c:v>
                </c:pt>
                <c:pt idx="14">
                  <c:v>0.34778895</c:v>
                </c:pt>
                <c:pt idx="15">
                  <c:v>0.23469315</c:v>
                </c:pt>
                <c:pt idx="16">
                  <c:v>0.4639107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1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G$2:$G$18</c:f>
              <c:numCache>
                <c:formatCode>General</c:formatCode>
                <c:ptCount val="17"/>
                <c:pt idx="0">
                  <c:v>0.58598</c:v>
                </c:pt>
                <c:pt idx="1">
                  <c:v>0.3403994</c:v>
                </c:pt>
                <c:pt idx="2">
                  <c:v>0.22667335</c:v>
                </c:pt>
                <c:pt idx="3">
                  <c:v>0.2612344</c:v>
                </c:pt>
                <c:pt idx="4">
                  <c:v>0.26759405</c:v>
                </c:pt>
                <c:pt idx="5">
                  <c:v>0.4086629</c:v>
                </c:pt>
                <c:pt idx="6">
                  <c:v>0.38669915</c:v>
                </c:pt>
                <c:pt idx="7">
                  <c:v>0.29206095</c:v>
                </c:pt>
                <c:pt idx="8">
                  <c:v>0.17374705</c:v>
                </c:pt>
                <c:pt idx="9">
                  <c:v>0.3150585</c:v>
                </c:pt>
                <c:pt idx="10">
                  <c:v>0.41105805</c:v>
                </c:pt>
                <c:pt idx="11">
                  <c:v>0.2936691</c:v>
                </c:pt>
                <c:pt idx="12">
                  <c:v>0.29266295</c:v>
                </c:pt>
                <c:pt idx="13">
                  <c:v>0.3287173</c:v>
                </c:pt>
                <c:pt idx="14">
                  <c:v>0.35659135</c:v>
                </c:pt>
                <c:pt idx="15">
                  <c:v>0.24560675</c:v>
                </c:pt>
                <c:pt idx="16">
                  <c:v>0.4312032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1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H$2:$H$18</c:f>
              <c:numCache>
                <c:formatCode>General</c:formatCode>
                <c:ptCount val="17"/>
                <c:pt idx="0">
                  <c:v>0.55420395</c:v>
                </c:pt>
                <c:pt idx="1">
                  <c:v>0.35940155</c:v>
                </c:pt>
                <c:pt idx="2">
                  <c:v>0.20817755</c:v>
                </c:pt>
                <c:pt idx="3">
                  <c:v>0.2076981</c:v>
                </c:pt>
                <c:pt idx="4">
                  <c:v>0.25024405</c:v>
                </c:pt>
                <c:pt idx="5">
                  <c:v>0.4351632</c:v>
                </c:pt>
                <c:pt idx="6">
                  <c:v>0.4254786</c:v>
                </c:pt>
                <c:pt idx="7">
                  <c:v>0.3346567</c:v>
                </c:pt>
                <c:pt idx="8">
                  <c:v>0.269326</c:v>
                </c:pt>
                <c:pt idx="9">
                  <c:v>0.30090295</c:v>
                </c:pt>
                <c:pt idx="10">
                  <c:v>0.45523345</c:v>
                </c:pt>
                <c:pt idx="11">
                  <c:v>0.32044955</c:v>
                </c:pt>
                <c:pt idx="12">
                  <c:v>0.41844765</c:v>
                </c:pt>
                <c:pt idx="13">
                  <c:v>0.4060395</c:v>
                </c:pt>
                <c:pt idx="14">
                  <c:v>0.35978485</c:v>
                </c:pt>
                <c:pt idx="15">
                  <c:v>0.416333</c:v>
                </c:pt>
                <c:pt idx="16">
                  <c:v>0.485627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1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  <a:prstDash val="sysDot"/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I$2:$I$18</c:f>
              <c:numCache>
                <c:formatCode>General</c:formatCode>
                <c:ptCount val="17"/>
                <c:pt idx="0">
                  <c:v>0.5479697</c:v>
                </c:pt>
                <c:pt idx="1">
                  <c:v>0.34842875</c:v>
                </c:pt>
                <c:pt idx="2">
                  <c:v>0.2518078</c:v>
                </c:pt>
                <c:pt idx="3">
                  <c:v>0.2338064</c:v>
                </c:pt>
                <c:pt idx="4">
                  <c:v>0.24319795</c:v>
                </c:pt>
                <c:pt idx="5">
                  <c:v>0.41285855</c:v>
                </c:pt>
                <c:pt idx="6">
                  <c:v>0.4401587</c:v>
                </c:pt>
                <c:pt idx="7">
                  <c:v>0.351358</c:v>
                </c:pt>
                <c:pt idx="8">
                  <c:v>0.26613845</c:v>
                </c:pt>
                <c:pt idx="9">
                  <c:v>0.30876465</c:v>
                </c:pt>
                <c:pt idx="10">
                  <c:v>0.4724786</c:v>
                </c:pt>
                <c:pt idx="11">
                  <c:v>0.3324548</c:v>
                </c:pt>
                <c:pt idx="12">
                  <c:v>0.3561762</c:v>
                </c:pt>
                <c:pt idx="13">
                  <c:v>0.33593695</c:v>
                </c:pt>
                <c:pt idx="14">
                  <c:v>0.35926495</c:v>
                </c:pt>
                <c:pt idx="15">
                  <c:v>0.2895725</c:v>
                </c:pt>
                <c:pt idx="16">
                  <c:v>0.4684607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1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99CC"/>
              </a:solidFill>
              <a:prstDash val="solid"/>
              <a:round/>
            </a:ln>
            <a:effectLst/>
          </c:spPr>
          <c:marker>
            <c:symbol val="circle"/>
            <c:size val="6"/>
            <c:spPr>
              <a:solidFill>
                <a:srgbClr val="0099CC"/>
              </a:solidFill>
              <a:ln w="9525">
                <a:solidFill>
                  <a:srgbClr val="0099CC"/>
                </a:solidFill>
              </a:ln>
              <a:effectLst/>
            </c:spPr>
          </c:marker>
          <c:dPt>
            <c:idx val="0"/>
            <c:marker>
              <c:spPr>
                <a:solidFill>
                  <a:srgbClr val="0066CC"/>
                </a:solidFill>
                <a:ln w="9525">
                  <a:solidFill>
                    <a:srgbClr val="0066CC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rgbClr val="0066CC"/>
                </a:solidFill>
                <a:prstDash val="solid"/>
                <a:round/>
              </a:ln>
              <a:effectLst/>
            </c:spPr>
          </c:dPt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J$2:$J$18</c:f>
              <c:numCache>
                <c:formatCode>General</c:formatCode>
                <c:ptCount val="17"/>
                <c:pt idx="0">
                  <c:v>0.51430595</c:v>
                </c:pt>
                <c:pt idx="1">
                  <c:v>0.34644455</c:v>
                </c:pt>
                <c:pt idx="2">
                  <c:v>0.2774592</c:v>
                </c:pt>
                <c:pt idx="3">
                  <c:v>0.294009</c:v>
                </c:pt>
                <c:pt idx="4">
                  <c:v>0.33954575</c:v>
                </c:pt>
                <c:pt idx="5">
                  <c:v>0.4455447</c:v>
                </c:pt>
                <c:pt idx="6">
                  <c:v>0.46524695</c:v>
                </c:pt>
                <c:pt idx="7">
                  <c:v>0.31240595</c:v>
                </c:pt>
                <c:pt idx="8">
                  <c:v>0.25512575</c:v>
                </c:pt>
                <c:pt idx="9">
                  <c:v>0.32345485</c:v>
                </c:pt>
                <c:pt idx="10">
                  <c:v>0.4643073</c:v>
                </c:pt>
                <c:pt idx="11">
                  <c:v>0.3487656</c:v>
                </c:pt>
                <c:pt idx="12">
                  <c:v>0.3109702</c:v>
                </c:pt>
                <c:pt idx="13">
                  <c:v>0.32504535</c:v>
                </c:pt>
                <c:pt idx="14">
                  <c:v>0.35810195</c:v>
                </c:pt>
                <c:pt idx="15">
                  <c:v>0.2520286</c:v>
                </c:pt>
                <c:pt idx="16">
                  <c:v>0.441745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1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>
                  <a:alpha val="99000"/>
                </a:schemeClr>
              </a:solidFill>
              <a:ln w="9525">
                <a:solidFill>
                  <a:srgbClr val="0066CC">
                    <a:alpha val="94000"/>
                  </a:srgbClr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K$2:$K$18</c:f>
              <c:numCache>
                <c:formatCode>General</c:formatCode>
                <c:ptCount val="17"/>
                <c:pt idx="0">
                  <c:v>0.58231235</c:v>
                </c:pt>
                <c:pt idx="1">
                  <c:v>0.3196748</c:v>
                </c:pt>
                <c:pt idx="2">
                  <c:v>0.2614371</c:v>
                </c:pt>
                <c:pt idx="3">
                  <c:v>0.22894475</c:v>
                </c:pt>
                <c:pt idx="4">
                  <c:v>0.23550795</c:v>
                </c:pt>
                <c:pt idx="5">
                  <c:v>0.43348305</c:v>
                </c:pt>
                <c:pt idx="6">
                  <c:v>0.40820325</c:v>
                </c:pt>
                <c:pt idx="7">
                  <c:v>0.36044345</c:v>
                </c:pt>
                <c:pt idx="8">
                  <c:v>0.28126065</c:v>
                </c:pt>
                <c:pt idx="9">
                  <c:v>0.36037505</c:v>
                </c:pt>
                <c:pt idx="10">
                  <c:v>0.4807674</c:v>
                </c:pt>
                <c:pt idx="11">
                  <c:v>0.38548175</c:v>
                </c:pt>
                <c:pt idx="12">
                  <c:v>0.2886923</c:v>
                </c:pt>
                <c:pt idx="13">
                  <c:v>0.3097083</c:v>
                </c:pt>
                <c:pt idx="14">
                  <c:v>0.39794955</c:v>
                </c:pt>
                <c:pt idx="15">
                  <c:v>0.24518</c:v>
                </c:pt>
                <c:pt idx="16">
                  <c:v>0.4089693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1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L$2:$L$18</c:f>
              <c:numCache>
                <c:formatCode>General</c:formatCode>
                <c:ptCount val="17"/>
                <c:pt idx="0">
                  <c:v>0.62498635</c:v>
                </c:pt>
                <c:pt idx="1">
                  <c:v>0.38622885</c:v>
                </c:pt>
                <c:pt idx="2">
                  <c:v>0.31428275</c:v>
                </c:pt>
                <c:pt idx="3">
                  <c:v>0.2995098</c:v>
                </c:pt>
                <c:pt idx="4">
                  <c:v>0.27199235</c:v>
                </c:pt>
                <c:pt idx="5">
                  <c:v>0.42457645</c:v>
                </c:pt>
                <c:pt idx="6">
                  <c:v>0.44976235</c:v>
                </c:pt>
                <c:pt idx="7">
                  <c:v>0.34693985</c:v>
                </c:pt>
                <c:pt idx="8">
                  <c:v>0.2454321</c:v>
                </c:pt>
                <c:pt idx="9">
                  <c:v>0.3438293</c:v>
                </c:pt>
                <c:pt idx="10">
                  <c:v>0.43532315</c:v>
                </c:pt>
                <c:pt idx="11">
                  <c:v>0.3100922</c:v>
                </c:pt>
                <c:pt idx="12">
                  <c:v>0.3219905</c:v>
                </c:pt>
                <c:pt idx="13">
                  <c:v>0.3608557</c:v>
                </c:pt>
                <c:pt idx="14">
                  <c:v>0.3322381</c:v>
                </c:pt>
                <c:pt idx="15">
                  <c:v>0.32273005</c:v>
                </c:pt>
                <c:pt idx="16">
                  <c:v>0.4596973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1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M$2:$M$18</c:f>
              <c:numCache>
                <c:formatCode>General</c:formatCode>
                <c:ptCount val="17"/>
                <c:pt idx="0">
                  <c:v>0.6443174</c:v>
                </c:pt>
                <c:pt idx="1">
                  <c:v>0.4003389</c:v>
                </c:pt>
                <c:pt idx="2">
                  <c:v>0.3119257</c:v>
                </c:pt>
                <c:pt idx="3">
                  <c:v>0.27374965</c:v>
                </c:pt>
                <c:pt idx="4">
                  <c:v>0.26027335</c:v>
                </c:pt>
                <c:pt idx="5">
                  <c:v>0.4253922</c:v>
                </c:pt>
                <c:pt idx="6">
                  <c:v>0.44570265</c:v>
                </c:pt>
                <c:pt idx="7">
                  <c:v>0.40130035</c:v>
                </c:pt>
                <c:pt idx="8">
                  <c:v>0.2947844</c:v>
                </c:pt>
                <c:pt idx="9">
                  <c:v>0.4235085</c:v>
                </c:pt>
                <c:pt idx="10">
                  <c:v>0.50592775</c:v>
                </c:pt>
                <c:pt idx="11">
                  <c:v>0.4241626</c:v>
                </c:pt>
                <c:pt idx="12">
                  <c:v>0.3658686</c:v>
                </c:pt>
                <c:pt idx="13">
                  <c:v>0.36387075</c:v>
                </c:pt>
                <c:pt idx="14">
                  <c:v>0.41086375</c:v>
                </c:pt>
                <c:pt idx="15">
                  <c:v>0.31551295</c:v>
                </c:pt>
                <c:pt idx="16">
                  <c:v>0.5002509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1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N$2:$N$18</c:f>
              <c:numCache>
                <c:formatCode>General</c:formatCode>
                <c:ptCount val="17"/>
                <c:pt idx="0">
                  <c:v>0.6158492</c:v>
                </c:pt>
                <c:pt idx="1">
                  <c:v>0.4307133</c:v>
                </c:pt>
                <c:pt idx="2">
                  <c:v>0.30998545</c:v>
                </c:pt>
                <c:pt idx="3">
                  <c:v>0.236627</c:v>
                </c:pt>
                <c:pt idx="4">
                  <c:v>0.26175425</c:v>
                </c:pt>
                <c:pt idx="5">
                  <c:v>0.34880915</c:v>
                </c:pt>
                <c:pt idx="6">
                  <c:v>0.2714521</c:v>
                </c:pt>
                <c:pt idx="7">
                  <c:v>0.2544443</c:v>
                </c:pt>
                <c:pt idx="8">
                  <c:v>0.17240305</c:v>
                </c:pt>
                <c:pt idx="9">
                  <c:v>0.2032365</c:v>
                </c:pt>
                <c:pt idx="10">
                  <c:v>0.40930215</c:v>
                </c:pt>
                <c:pt idx="11">
                  <c:v>0.2797204</c:v>
                </c:pt>
                <c:pt idx="12">
                  <c:v>0.28654125</c:v>
                </c:pt>
                <c:pt idx="13">
                  <c:v>0.30160695</c:v>
                </c:pt>
                <c:pt idx="14">
                  <c:v>0.33252705</c:v>
                </c:pt>
                <c:pt idx="15">
                  <c:v>0.2709266</c:v>
                </c:pt>
                <c:pt idx="16">
                  <c:v>0.457411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1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:$E$18</c:f>
              <c:strCache>
                <c:ptCount val="17"/>
                <c:pt idx="0">
                  <c:v>cg09730369</c:v>
                </c:pt>
                <c:pt idx="1">
                  <c:v>cg17865602</c:v>
                </c:pt>
                <c:pt idx="2">
                  <c:v>cg25350411</c:v>
                </c:pt>
                <c:pt idx="3">
                  <c:v>cg07077459</c:v>
                </c:pt>
                <c:pt idx="4">
                  <c:v>cg22378065</c:v>
                </c:pt>
                <c:pt idx="5">
                  <c:v>cg10007452</c:v>
                </c:pt>
                <c:pt idx="6">
                  <c:v>cg22352234</c:v>
                </c:pt>
                <c:pt idx="7">
                  <c:v>cg00702231</c:v>
                </c:pt>
                <c:pt idx="8">
                  <c:v>cg12757684</c:v>
                </c:pt>
                <c:pt idx="9">
                  <c:v>cg21526238</c:v>
                </c:pt>
                <c:pt idx="10">
                  <c:v>cg21952820</c:v>
                </c:pt>
                <c:pt idx="11">
                  <c:v>cg05326984</c:v>
                </c:pt>
                <c:pt idx="12">
                  <c:v>cg08263357</c:v>
                </c:pt>
                <c:pt idx="13">
                  <c:v>cg11532302</c:v>
                </c:pt>
                <c:pt idx="14">
                  <c:v>cg27216384</c:v>
                </c:pt>
                <c:pt idx="15">
                  <c:v>cg17895149</c:v>
                </c:pt>
                <c:pt idx="16">
                  <c:v>cg23460430</c:v>
                </c:pt>
              </c:strCache>
            </c:strRef>
          </c:cat>
          <c:val>
            <c:numRef>
              <c:f>revise_data!$O$2:$O$18</c:f>
              <c:numCache>
                <c:formatCode>General</c:formatCode>
                <c:ptCount val="17"/>
                <c:pt idx="0">
                  <c:v>0.62229455</c:v>
                </c:pt>
                <c:pt idx="1">
                  <c:v>0.39507325</c:v>
                </c:pt>
                <c:pt idx="2">
                  <c:v>0.2592293</c:v>
                </c:pt>
                <c:pt idx="3">
                  <c:v>0.24174725</c:v>
                </c:pt>
                <c:pt idx="4">
                  <c:v>0.2112981</c:v>
                </c:pt>
                <c:pt idx="5">
                  <c:v>0.3948283</c:v>
                </c:pt>
                <c:pt idx="6">
                  <c:v>0.3865274</c:v>
                </c:pt>
                <c:pt idx="7">
                  <c:v>0.12822655</c:v>
                </c:pt>
                <c:pt idx="8">
                  <c:v>0.12821055</c:v>
                </c:pt>
                <c:pt idx="9">
                  <c:v>0.3281034</c:v>
                </c:pt>
                <c:pt idx="10">
                  <c:v>0.4762281</c:v>
                </c:pt>
                <c:pt idx="11">
                  <c:v>0.35597245</c:v>
                </c:pt>
                <c:pt idx="12">
                  <c:v>0.3312826</c:v>
                </c:pt>
                <c:pt idx="13">
                  <c:v>0.3479117</c:v>
                </c:pt>
                <c:pt idx="14">
                  <c:v>0.4020256</c:v>
                </c:pt>
                <c:pt idx="15">
                  <c:v>0.28197705</c:v>
                </c:pt>
                <c:pt idx="16">
                  <c:v>0.4257646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0832008"/>
        <c:axId val="2041197800"/>
      </c:lineChart>
      <c:dateAx>
        <c:axId val="204083200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41197800"/>
        <c:crosses val="autoZero"/>
        <c:auto val="0"/>
        <c:lblOffset val="100"/>
        <c:baseTimeUnit val="days"/>
      </c:dateAx>
      <c:valAx>
        <c:axId val="204119780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40832008"/>
        <c:crosses val="autoZero"/>
        <c:crossBetween val="between"/>
        <c:majorUnit val="0.5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486711836329199"/>
          <c:y val="0.1398337270643"/>
          <c:w val="0.934680356117725"/>
          <c:h val="0.609728116572241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20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F$21:$F$74</c:f>
              <c:numCache>
                <c:formatCode>General</c:formatCode>
                <c:ptCount val="54"/>
                <c:pt idx="0">
                  <c:v>0.1726372</c:v>
                </c:pt>
                <c:pt idx="1">
                  <c:v>0.2862165</c:v>
                </c:pt>
                <c:pt idx="2">
                  <c:v>0.44304335</c:v>
                </c:pt>
                <c:pt idx="3">
                  <c:v>0.4605031</c:v>
                </c:pt>
                <c:pt idx="4">
                  <c:v>0.38355315</c:v>
                </c:pt>
                <c:pt idx="5">
                  <c:v>0.45851215</c:v>
                </c:pt>
                <c:pt idx="6">
                  <c:v>0.45100385</c:v>
                </c:pt>
                <c:pt idx="7">
                  <c:v>0.3480238</c:v>
                </c:pt>
                <c:pt idx="8">
                  <c:v>0.4398048</c:v>
                </c:pt>
                <c:pt idx="9">
                  <c:v>0.373881</c:v>
                </c:pt>
                <c:pt idx="10">
                  <c:v>0.33164685</c:v>
                </c:pt>
                <c:pt idx="11">
                  <c:v>0.245355</c:v>
                </c:pt>
                <c:pt idx="12">
                  <c:v>0.27124785</c:v>
                </c:pt>
                <c:pt idx="13">
                  <c:v>0.08628956</c:v>
                </c:pt>
                <c:pt idx="14">
                  <c:v>0.3421298</c:v>
                </c:pt>
                <c:pt idx="15">
                  <c:v>0.392268</c:v>
                </c:pt>
                <c:pt idx="16">
                  <c:v>0.28720565</c:v>
                </c:pt>
                <c:pt idx="17">
                  <c:v>0.29262565</c:v>
                </c:pt>
                <c:pt idx="18">
                  <c:v>0.26115165</c:v>
                </c:pt>
                <c:pt idx="19">
                  <c:v>0.26469855</c:v>
                </c:pt>
                <c:pt idx="20">
                  <c:v>0.4638664</c:v>
                </c:pt>
                <c:pt idx="21">
                  <c:v>0.42272235</c:v>
                </c:pt>
                <c:pt idx="22">
                  <c:v>0.40094365</c:v>
                </c:pt>
                <c:pt idx="23">
                  <c:v>0.4029965</c:v>
                </c:pt>
                <c:pt idx="24">
                  <c:v>0.4451232</c:v>
                </c:pt>
                <c:pt idx="25">
                  <c:v>0.3572488</c:v>
                </c:pt>
                <c:pt idx="26">
                  <c:v>0.4804127</c:v>
                </c:pt>
                <c:pt idx="27">
                  <c:v>0.4902928</c:v>
                </c:pt>
                <c:pt idx="28">
                  <c:v>0.4890336</c:v>
                </c:pt>
                <c:pt idx="29">
                  <c:v>0.41764925</c:v>
                </c:pt>
                <c:pt idx="30">
                  <c:v>0.4319967</c:v>
                </c:pt>
                <c:pt idx="31">
                  <c:v>0.47623425</c:v>
                </c:pt>
                <c:pt idx="32">
                  <c:v>0.4720551</c:v>
                </c:pt>
                <c:pt idx="33">
                  <c:v>0.50520615</c:v>
                </c:pt>
                <c:pt idx="34">
                  <c:v>0.4930719</c:v>
                </c:pt>
                <c:pt idx="35">
                  <c:v>0.37862115</c:v>
                </c:pt>
                <c:pt idx="36">
                  <c:v>0.4310278</c:v>
                </c:pt>
                <c:pt idx="37">
                  <c:v>0.50341515</c:v>
                </c:pt>
                <c:pt idx="38">
                  <c:v>0.4998411</c:v>
                </c:pt>
                <c:pt idx="39">
                  <c:v>0.4673185</c:v>
                </c:pt>
                <c:pt idx="40">
                  <c:v>0.5063994</c:v>
                </c:pt>
                <c:pt idx="41">
                  <c:v>0.45614475</c:v>
                </c:pt>
                <c:pt idx="42">
                  <c:v>0.4215307</c:v>
                </c:pt>
                <c:pt idx="43">
                  <c:v>0.34895865</c:v>
                </c:pt>
                <c:pt idx="44">
                  <c:v>0.3599317</c:v>
                </c:pt>
                <c:pt idx="45">
                  <c:v>0.35926325</c:v>
                </c:pt>
                <c:pt idx="46">
                  <c:v>0.4339113</c:v>
                </c:pt>
                <c:pt idx="47">
                  <c:v>0.38225535</c:v>
                </c:pt>
                <c:pt idx="48">
                  <c:v>0.50483945</c:v>
                </c:pt>
                <c:pt idx="49">
                  <c:v>0.37260425</c:v>
                </c:pt>
                <c:pt idx="50">
                  <c:v>0.3815767</c:v>
                </c:pt>
                <c:pt idx="51">
                  <c:v>0.13605315</c:v>
                </c:pt>
                <c:pt idx="52">
                  <c:v>0.10556805</c:v>
                </c:pt>
                <c:pt idx="53">
                  <c:v>0.177770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20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G$21:$G$74</c:f>
              <c:numCache>
                <c:formatCode>General</c:formatCode>
                <c:ptCount val="54"/>
                <c:pt idx="0">
                  <c:v>0.19498315</c:v>
                </c:pt>
                <c:pt idx="1">
                  <c:v>0.2296758</c:v>
                </c:pt>
                <c:pt idx="2">
                  <c:v>0.420416</c:v>
                </c:pt>
                <c:pt idx="3">
                  <c:v>0.4331848</c:v>
                </c:pt>
                <c:pt idx="4">
                  <c:v>0.3395608</c:v>
                </c:pt>
                <c:pt idx="5">
                  <c:v>0.4193484</c:v>
                </c:pt>
                <c:pt idx="6">
                  <c:v>0.410579</c:v>
                </c:pt>
                <c:pt idx="7">
                  <c:v>0.30563895</c:v>
                </c:pt>
                <c:pt idx="8">
                  <c:v>0.37738885</c:v>
                </c:pt>
                <c:pt idx="9">
                  <c:v>0.4012105</c:v>
                </c:pt>
                <c:pt idx="10">
                  <c:v>0.24498925</c:v>
                </c:pt>
                <c:pt idx="11">
                  <c:v>0.1844018</c:v>
                </c:pt>
                <c:pt idx="12">
                  <c:v>0.2149874</c:v>
                </c:pt>
                <c:pt idx="13">
                  <c:v>0.085467285</c:v>
                </c:pt>
                <c:pt idx="14">
                  <c:v>0.43700305</c:v>
                </c:pt>
                <c:pt idx="15">
                  <c:v>0.4912898</c:v>
                </c:pt>
                <c:pt idx="16">
                  <c:v>0.39996405</c:v>
                </c:pt>
                <c:pt idx="17">
                  <c:v>0.3924739</c:v>
                </c:pt>
                <c:pt idx="18">
                  <c:v>0.2763875</c:v>
                </c:pt>
                <c:pt idx="19">
                  <c:v>0.2853752</c:v>
                </c:pt>
                <c:pt idx="20">
                  <c:v>0.3977579</c:v>
                </c:pt>
                <c:pt idx="21">
                  <c:v>0.45078995</c:v>
                </c:pt>
                <c:pt idx="22">
                  <c:v>0.39281825</c:v>
                </c:pt>
                <c:pt idx="23">
                  <c:v>0.3847098</c:v>
                </c:pt>
                <c:pt idx="24">
                  <c:v>0.4374639</c:v>
                </c:pt>
                <c:pt idx="25">
                  <c:v>0.34475345</c:v>
                </c:pt>
                <c:pt idx="26">
                  <c:v>0.4746541</c:v>
                </c:pt>
                <c:pt idx="27">
                  <c:v>0.49674845</c:v>
                </c:pt>
                <c:pt idx="28">
                  <c:v>0.4734483</c:v>
                </c:pt>
                <c:pt idx="29">
                  <c:v>0.41798985</c:v>
                </c:pt>
                <c:pt idx="30">
                  <c:v>0.4628739</c:v>
                </c:pt>
                <c:pt idx="31">
                  <c:v>0.48860855</c:v>
                </c:pt>
                <c:pt idx="32">
                  <c:v>0.50095525</c:v>
                </c:pt>
                <c:pt idx="33">
                  <c:v>0.4959964</c:v>
                </c:pt>
                <c:pt idx="34">
                  <c:v>0.5089357</c:v>
                </c:pt>
                <c:pt idx="35">
                  <c:v>0.3599596</c:v>
                </c:pt>
                <c:pt idx="36">
                  <c:v>0.4572221</c:v>
                </c:pt>
                <c:pt idx="37">
                  <c:v>0.52621165</c:v>
                </c:pt>
                <c:pt idx="38">
                  <c:v>0.5230652</c:v>
                </c:pt>
                <c:pt idx="39">
                  <c:v>0.4670663</c:v>
                </c:pt>
                <c:pt idx="40">
                  <c:v>0.4748904</c:v>
                </c:pt>
                <c:pt idx="41">
                  <c:v>0.4636115</c:v>
                </c:pt>
                <c:pt idx="42">
                  <c:v>0.41795795</c:v>
                </c:pt>
                <c:pt idx="43">
                  <c:v>0.3589147</c:v>
                </c:pt>
                <c:pt idx="44">
                  <c:v>0.3196839</c:v>
                </c:pt>
                <c:pt idx="45">
                  <c:v>0.4008505</c:v>
                </c:pt>
                <c:pt idx="46">
                  <c:v>0.3584317</c:v>
                </c:pt>
                <c:pt idx="47">
                  <c:v>0.4097609</c:v>
                </c:pt>
                <c:pt idx="48">
                  <c:v>0.4649405</c:v>
                </c:pt>
                <c:pt idx="49">
                  <c:v>0.34364855</c:v>
                </c:pt>
                <c:pt idx="50">
                  <c:v>0.361447</c:v>
                </c:pt>
                <c:pt idx="51">
                  <c:v>0.14857395</c:v>
                </c:pt>
                <c:pt idx="52">
                  <c:v>0.10125577</c:v>
                </c:pt>
                <c:pt idx="53">
                  <c:v>0.194051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20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H$21:$H$74</c:f>
              <c:numCache>
                <c:formatCode>General</c:formatCode>
                <c:ptCount val="54"/>
                <c:pt idx="0">
                  <c:v>0.16269465</c:v>
                </c:pt>
                <c:pt idx="1">
                  <c:v>0.31349035</c:v>
                </c:pt>
                <c:pt idx="2">
                  <c:v>0.42071515</c:v>
                </c:pt>
                <c:pt idx="3">
                  <c:v>0.42664865</c:v>
                </c:pt>
                <c:pt idx="4">
                  <c:v>0.3353816</c:v>
                </c:pt>
                <c:pt idx="5">
                  <c:v>0.431416</c:v>
                </c:pt>
                <c:pt idx="6">
                  <c:v>0.4131071</c:v>
                </c:pt>
                <c:pt idx="7">
                  <c:v>0.2821876</c:v>
                </c:pt>
                <c:pt idx="8">
                  <c:v>0.37246925</c:v>
                </c:pt>
                <c:pt idx="9">
                  <c:v>0.38049265</c:v>
                </c:pt>
                <c:pt idx="10">
                  <c:v>0.2719261</c:v>
                </c:pt>
                <c:pt idx="11">
                  <c:v>0.16504465</c:v>
                </c:pt>
                <c:pt idx="12">
                  <c:v>0.18099505</c:v>
                </c:pt>
                <c:pt idx="13">
                  <c:v>0.070000005</c:v>
                </c:pt>
                <c:pt idx="14">
                  <c:v>0.38722885</c:v>
                </c:pt>
                <c:pt idx="15">
                  <c:v>0.4214121</c:v>
                </c:pt>
                <c:pt idx="16">
                  <c:v>0.30836445</c:v>
                </c:pt>
                <c:pt idx="17">
                  <c:v>0.30120215</c:v>
                </c:pt>
                <c:pt idx="18">
                  <c:v>0.2499506</c:v>
                </c:pt>
                <c:pt idx="19">
                  <c:v>0.25845755</c:v>
                </c:pt>
                <c:pt idx="20">
                  <c:v>0.4591368</c:v>
                </c:pt>
                <c:pt idx="21">
                  <c:v>0.42134635</c:v>
                </c:pt>
                <c:pt idx="22">
                  <c:v>0.4084163</c:v>
                </c:pt>
                <c:pt idx="23">
                  <c:v>0.36536195</c:v>
                </c:pt>
                <c:pt idx="24">
                  <c:v>0.42254715</c:v>
                </c:pt>
                <c:pt idx="25">
                  <c:v>0.35656075</c:v>
                </c:pt>
                <c:pt idx="26">
                  <c:v>0.4787269</c:v>
                </c:pt>
                <c:pt idx="27">
                  <c:v>0.47471355</c:v>
                </c:pt>
                <c:pt idx="28">
                  <c:v>0.52154225</c:v>
                </c:pt>
                <c:pt idx="29">
                  <c:v>0.40763995</c:v>
                </c:pt>
                <c:pt idx="30">
                  <c:v>0.4661146</c:v>
                </c:pt>
                <c:pt idx="31">
                  <c:v>0.51117205</c:v>
                </c:pt>
                <c:pt idx="32">
                  <c:v>0.5065387</c:v>
                </c:pt>
                <c:pt idx="33">
                  <c:v>0.5209321</c:v>
                </c:pt>
                <c:pt idx="34">
                  <c:v>0.53381165</c:v>
                </c:pt>
                <c:pt idx="35">
                  <c:v>0.4316151</c:v>
                </c:pt>
                <c:pt idx="36">
                  <c:v>0.47099135</c:v>
                </c:pt>
                <c:pt idx="37">
                  <c:v>0.53637405</c:v>
                </c:pt>
                <c:pt idx="38">
                  <c:v>0.5574681</c:v>
                </c:pt>
                <c:pt idx="39">
                  <c:v>0.52759655</c:v>
                </c:pt>
                <c:pt idx="40">
                  <c:v>0.5320966</c:v>
                </c:pt>
                <c:pt idx="41">
                  <c:v>0.4640082</c:v>
                </c:pt>
                <c:pt idx="42">
                  <c:v>0.4283148</c:v>
                </c:pt>
                <c:pt idx="43">
                  <c:v>0.3721228</c:v>
                </c:pt>
                <c:pt idx="44">
                  <c:v>0.3466595</c:v>
                </c:pt>
                <c:pt idx="45">
                  <c:v>0.3724113</c:v>
                </c:pt>
                <c:pt idx="46">
                  <c:v>0.40531125</c:v>
                </c:pt>
                <c:pt idx="47">
                  <c:v>0.3459241</c:v>
                </c:pt>
                <c:pt idx="48">
                  <c:v>0.3777374</c:v>
                </c:pt>
                <c:pt idx="49">
                  <c:v>0.37712095</c:v>
                </c:pt>
                <c:pt idx="50">
                  <c:v>0.3822784</c:v>
                </c:pt>
                <c:pt idx="51">
                  <c:v>0.1728579</c:v>
                </c:pt>
                <c:pt idx="52">
                  <c:v>0.12545645</c:v>
                </c:pt>
                <c:pt idx="53">
                  <c:v>0.1993023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20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I$21:$I$74</c:f>
              <c:numCache>
                <c:formatCode>General</c:formatCode>
                <c:ptCount val="54"/>
                <c:pt idx="0">
                  <c:v>0.1221034</c:v>
                </c:pt>
                <c:pt idx="1">
                  <c:v>0.2262139</c:v>
                </c:pt>
                <c:pt idx="2">
                  <c:v>0.43088705</c:v>
                </c:pt>
                <c:pt idx="3">
                  <c:v>0.43273615</c:v>
                </c:pt>
                <c:pt idx="4">
                  <c:v>0.38651415</c:v>
                </c:pt>
                <c:pt idx="5">
                  <c:v>0.44610575</c:v>
                </c:pt>
                <c:pt idx="6">
                  <c:v>0.44818805</c:v>
                </c:pt>
                <c:pt idx="7">
                  <c:v>0.35079365</c:v>
                </c:pt>
                <c:pt idx="8">
                  <c:v>0.41167205</c:v>
                </c:pt>
                <c:pt idx="9">
                  <c:v>0.32497635</c:v>
                </c:pt>
                <c:pt idx="10">
                  <c:v>0.25453565</c:v>
                </c:pt>
                <c:pt idx="11">
                  <c:v>0.206152</c:v>
                </c:pt>
                <c:pt idx="12">
                  <c:v>0.18272105</c:v>
                </c:pt>
                <c:pt idx="13">
                  <c:v>0.063784445</c:v>
                </c:pt>
                <c:pt idx="14">
                  <c:v>0.30163155</c:v>
                </c:pt>
                <c:pt idx="15">
                  <c:v>0.34727005</c:v>
                </c:pt>
                <c:pt idx="16">
                  <c:v>0.23414585</c:v>
                </c:pt>
                <c:pt idx="17">
                  <c:v>0.2363686</c:v>
                </c:pt>
                <c:pt idx="18">
                  <c:v>0.279944</c:v>
                </c:pt>
                <c:pt idx="19">
                  <c:v>0.30487205</c:v>
                </c:pt>
                <c:pt idx="20">
                  <c:v>0.44133295</c:v>
                </c:pt>
                <c:pt idx="21">
                  <c:v>0.3673273</c:v>
                </c:pt>
                <c:pt idx="22">
                  <c:v>0.3405872</c:v>
                </c:pt>
                <c:pt idx="23">
                  <c:v>0.3447248</c:v>
                </c:pt>
                <c:pt idx="24">
                  <c:v>0.40476435</c:v>
                </c:pt>
                <c:pt idx="25">
                  <c:v>0.32678585</c:v>
                </c:pt>
                <c:pt idx="26">
                  <c:v>0.45374815</c:v>
                </c:pt>
                <c:pt idx="27">
                  <c:v>0.49668955</c:v>
                </c:pt>
                <c:pt idx="28">
                  <c:v>0.5032868</c:v>
                </c:pt>
                <c:pt idx="29">
                  <c:v>0.39195605</c:v>
                </c:pt>
                <c:pt idx="30">
                  <c:v>0.4038591</c:v>
                </c:pt>
                <c:pt idx="31">
                  <c:v>0.45627465</c:v>
                </c:pt>
                <c:pt idx="32">
                  <c:v>0.45321605</c:v>
                </c:pt>
                <c:pt idx="33">
                  <c:v>0.52161165</c:v>
                </c:pt>
                <c:pt idx="34">
                  <c:v>0.53241565</c:v>
                </c:pt>
                <c:pt idx="35">
                  <c:v>0.41308375</c:v>
                </c:pt>
                <c:pt idx="36">
                  <c:v>0.4668798</c:v>
                </c:pt>
                <c:pt idx="37">
                  <c:v>0.52652125</c:v>
                </c:pt>
                <c:pt idx="38">
                  <c:v>0.53203995</c:v>
                </c:pt>
                <c:pt idx="39">
                  <c:v>0.48021495</c:v>
                </c:pt>
                <c:pt idx="40">
                  <c:v>0.54444535</c:v>
                </c:pt>
                <c:pt idx="41">
                  <c:v>0.49319335</c:v>
                </c:pt>
                <c:pt idx="42">
                  <c:v>0.45160595</c:v>
                </c:pt>
                <c:pt idx="43">
                  <c:v>0.4316795</c:v>
                </c:pt>
                <c:pt idx="44">
                  <c:v>0.3654874</c:v>
                </c:pt>
                <c:pt idx="45">
                  <c:v>0.3099599</c:v>
                </c:pt>
                <c:pt idx="46">
                  <c:v>0.399256</c:v>
                </c:pt>
                <c:pt idx="47">
                  <c:v>0.3992733</c:v>
                </c:pt>
                <c:pt idx="48">
                  <c:v>0.42132325</c:v>
                </c:pt>
                <c:pt idx="49">
                  <c:v>0.3730974</c:v>
                </c:pt>
                <c:pt idx="50">
                  <c:v>0.38137105</c:v>
                </c:pt>
                <c:pt idx="51">
                  <c:v>0.13644845</c:v>
                </c:pt>
                <c:pt idx="52">
                  <c:v>0.1210706</c:v>
                </c:pt>
                <c:pt idx="53">
                  <c:v>0.2026121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20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J$21:$J$74</c:f>
              <c:numCache>
                <c:formatCode>General</c:formatCode>
                <c:ptCount val="54"/>
                <c:pt idx="0">
                  <c:v>0.16547445</c:v>
                </c:pt>
                <c:pt idx="1">
                  <c:v>0.26638235</c:v>
                </c:pt>
                <c:pt idx="2">
                  <c:v>0.4465376</c:v>
                </c:pt>
                <c:pt idx="3">
                  <c:v>0.44048565</c:v>
                </c:pt>
                <c:pt idx="4">
                  <c:v>0.35719865</c:v>
                </c:pt>
                <c:pt idx="5">
                  <c:v>0.44488745</c:v>
                </c:pt>
                <c:pt idx="6">
                  <c:v>0.4308773</c:v>
                </c:pt>
                <c:pt idx="7">
                  <c:v>0.3380118</c:v>
                </c:pt>
                <c:pt idx="8">
                  <c:v>0.4089511</c:v>
                </c:pt>
                <c:pt idx="9">
                  <c:v>0.4044442</c:v>
                </c:pt>
                <c:pt idx="10">
                  <c:v>0.292168</c:v>
                </c:pt>
                <c:pt idx="11">
                  <c:v>0.2043929</c:v>
                </c:pt>
                <c:pt idx="12">
                  <c:v>0.20624165</c:v>
                </c:pt>
                <c:pt idx="13">
                  <c:v>0.09367862</c:v>
                </c:pt>
                <c:pt idx="14">
                  <c:v>0.38007815</c:v>
                </c:pt>
                <c:pt idx="15">
                  <c:v>0.4003278</c:v>
                </c:pt>
                <c:pt idx="16">
                  <c:v>0.33137865</c:v>
                </c:pt>
                <c:pt idx="17">
                  <c:v>0.28471675</c:v>
                </c:pt>
                <c:pt idx="18">
                  <c:v>0.200865</c:v>
                </c:pt>
                <c:pt idx="19">
                  <c:v>0.24051625</c:v>
                </c:pt>
                <c:pt idx="20">
                  <c:v>0.4961194</c:v>
                </c:pt>
                <c:pt idx="21">
                  <c:v>0.36812315</c:v>
                </c:pt>
                <c:pt idx="22">
                  <c:v>0.3640297</c:v>
                </c:pt>
                <c:pt idx="23">
                  <c:v>0.34216135</c:v>
                </c:pt>
                <c:pt idx="24">
                  <c:v>0.3847164</c:v>
                </c:pt>
                <c:pt idx="25">
                  <c:v>0.37569965</c:v>
                </c:pt>
                <c:pt idx="26">
                  <c:v>0.48824625</c:v>
                </c:pt>
                <c:pt idx="27">
                  <c:v>0.46303455</c:v>
                </c:pt>
                <c:pt idx="28">
                  <c:v>0.5216797</c:v>
                </c:pt>
                <c:pt idx="29">
                  <c:v>0.3624136</c:v>
                </c:pt>
                <c:pt idx="30">
                  <c:v>0.4374489</c:v>
                </c:pt>
                <c:pt idx="31">
                  <c:v>0.46151935</c:v>
                </c:pt>
                <c:pt idx="32">
                  <c:v>0.4440097</c:v>
                </c:pt>
                <c:pt idx="33">
                  <c:v>0.4862313</c:v>
                </c:pt>
                <c:pt idx="34">
                  <c:v>0.5027898</c:v>
                </c:pt>
                <c:pt idx="35">
                  <c:v>0.4151144</c:v>
                </c:pt>
                <c:pt idx="36">
                  <c:v>0.42913825</c:v>
                </c:pt>
                <c:pt idx="37">
                  <c:v>0.52490755</c:v>
                </c:pt>
                <c:pt idx="38">
                  <c:v>0.5051779</c:v>
                </c:pt>
                <c:pt idx="39">
                  <c:v>0.4748314</c:v>
                </c:pt>
                <c:pt idx="40">
                  <c:v>0.5272477</c:v>
                </c:pt>
                <c:pt idx="41">
                  <c:v>0.45665345</c:v>
                </c:pt>
                <c:pt idx="42">
                  <c:v>0.4538615</c:v>
                </c:pt>
                <c:pt idx="43">
                  <c:v>0.38583745</c:v>
                </c:pt>
                <c:pt idx="44">
                  <c:v>0.34179845</c:v>
                </c:pt>
                <c:pt idx="45">
                  <c:v>0.417248</c:v>
                </c:pt>
                <c:pt idx="46">
                  <c:v>0.4538144</c:v>
                </c:pt>
                <c:pt idx="47">
                  <c:v>0.3793208</c:v>
                </c:pt>
                <c:pt idx="48">
                  <c:v>0.4063443</c:v>
                </c:pt>
                <c:pt idx="49">
                  <c:v>0.3631035</c:v>
                </c:pt>
                <c:pt idx="50">
                  <c:v>0.3810236</c:v>
                </c:pt>
                <c:pt idx="51">
                  <c:v>0.1538529</c:v>
                </c:pt>
                <c:pt idx="52">
                  <c:v>0.094465505</c:v>
                </c:pt>
                <c:pt idx="53">
                  <c:v>0.169967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20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K$21:$K$74</c:f>
              <c:numCache>
                <c:formatCode>General</c:formatCode>
                <c:ptCount val="54"/>
                <c:pt idx="0">
                  <c:v>0.176382115</c:v>
                </c:pt>
                <c:pt idx="1">
                  <c:v>0.26191955</c:v>
                </c:pt>
                <c:pt idx="2">
                  <c:v>0.44076745</c:v>
                </c:pt>
                <c:pt idx="3">
                  <c:v>0.43346015</c:v>
                </c:pt>
                <c:pt idx="4">
                  <c:v>0.34812965</c:v>
                </c:pt>
                <c:pt idx="5">
                  <c:v>0.45720875</c:v>
                </c:pt>
                <c:pt idx="6">
                  <c:v>0.45493005</c:v>
                </c:pt>
                <c:pt idx="7">
                  <c:v>0.3565659</c:v>
                </c:pt>
                <c:pt idx="8">
                  <c:v>0.4335737</c:v>
                </c:pt>
                <c:pt idx="9">
                  <c:v>0.37462775</c:v>
                </c:pt>
                <c:pt idx="10">
                  <c:v>0.25940755</c:v>
                </c:pt>
                <c:pt idx="11">
                  <c:v>0.20814475</c:v>
                </c:pt>
                <c:pt idx="12">
                  <c:v>0.1476625</c:v>
                </c:pt>
                <c:pt idx="13">
                  <c:v>0.092135815</c:v>
                </c:pt>
                <c:pt idx="14">
                  <c:v>0.32238915</c:v>
                </c:pt>
                <c:pt idx="15">
                  <c:v>0.41101495</c:v>
                </c:pt>
                <c:pt idx="16">
                  <c:v>0.2963375</c:v>
                </c:pt>
                <c:pt idx="17">
                  <c:v>0.3174658</c:v>
                </c:pt>
                <c:pt idx="18">
                  <c:v>0.2283754</c:v>
                </c:pt>
                <c:pt idx="19">
                  <c:v>0.25557035</c:v>
                </c:pt>
                <c:pt idx="20">
                  <c:v>0.41469795</c:v>
                </c:pt>
                <c:pt idx="21">
                  <c:v>0.45081475</c:v>
                </c:pt>
                <c:pt idx="22">
                  <c:v>0.36005625</c:v>
                </c:pt>
                <c:pt idx="23">
                  <c:v>0.3634129</c:v>
                </c:pt>
                <c:pt idx="24">
                  <c:v>0.4216095</c:v>
                </c:pt>
                <c:pt idx="25">
                  <c:v>0.3458826</c:v>
                </c:pt>
                <c:pt idx="26">
                  <c:v>0.47773935</c:v>
                </c:pt>
                <c:pt idx="27">
                  <c:v>0.4805284</c:v>
                </c:pt>
                <c:pt idx="28">
                  <c:v>0.513171</c:v>
                </c:pt>
                <c:pt idx="29">
                  <c:v>0.3738184</c:v>
                </c:pt>
                <c:pt idx="30">
                  <c:v>0.41931405</c:v>
                </c:pt>
                <c:pt idx="31">
                  <c:v>0.45514865</c:v>
                </c:pt>
                <c:pt idx="32">
                  <c:v>0.4514484</c:v>
                </c:pt>
                <c:pt idx="33">
                  <c:v>0.51893645</c:v>
                </c:pt>
                <c:pt idx="34">
                  <c:v>0.5412824</c:v>
                </c:pt>
                <c:pt idx="35">
                  <c:v>0.4012762</c:v>
                </c:pt>
                <c:pt idx="36">
                  <c:v>0.47302975</c:v>
                </c:pt>
                <c:pt idx="37">
                  <c:v>0.5427675</c:v>
                </c:pt>
                <c:pt idx="38">
                  <c:v>0.5192514</c:v>
                </c:pt>
                <c:pt idx="39">
                  <c:v>0.47158375</c:v>
                </c:pt>
                <c:pt idx="40">
                  <c:v>0.5196642</c:v>
                </c:pt>
                <c:pt idx="41">
                  <c:v>0.4624112</c:v>
                </c:pt>
                <c:pt idx="42">
                  <c:v>0.46275345</c:v>
                </c:pt>
                <c:pt idx="43">
                  <c:v>0.4636129</c:v>
                </c:pt>
                <c:pt idx="44">
                  <c:v>0.3625921</c:v>
                </c:pt>
                <c:pt idx="45">
                  <c:v>0.43421445</c:v>
                </c:pt>
                <c:pt idx="46">
                  <c:v>0.42538205</c:v>
                </c:pt>
                <c:pt idx="47">
                  <c:v>0.3830116</c:v>
                </c:pt>
                <c:pt idx="48">
                  <c:v>0.40109115</c:v>
                </c:pt>
                <c:pt idx="49">
                  <c:v>0.3516142</c:v>
                </c:pt>
                <c:pt idx="50">
                  <c:v>0.386883</c:v>
                </c:pt>
                <c:pt idx="51">
                  <c:v>0.10540169</c:v>
                </c:pt>
                <c:pt idx="52">
                  <c:v>0.076715725</c:v>
                </c:pt>
                <c:pt idx="53">
                  <c:v>0.153868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20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L$21:$L$74</c:f>
              <c:numCache>
                <c:formatCode>General</c:formatCode>
                <c:ptCount val="54"/>
                <c:pt idx="0">
                  <c:v>0.16239155</c:v>
                </c:pt>
                <c:pt idx="1">
                  <c:v>0.29258245</c:v>
                </c:pt>
                <c:pt idx="2">
                  <c:v>0.427844</c:v>
                </c:pt>
                <c:pt idx="3">
                  <c:v>0.43248335</c:v>
                </c:pt>
                <c:pt idx="4">
                  <c:v>0.36362335</c:v>
                </c:pt>
                <c:pt idx="5">
                  <c:v>0.45381865</c:v>
                </c:pt>
                <c:pt idx="6">
                  <c:v>0.43605875</c:v>
                </c:pt>
                <c:pt idx="7">
                  <c:v>0.30288275</c:v>
                </c:pt>
                <c:pt idx="8">
                  <c:v>0.4072166</c:v>
                </c:pt>
                <c:pt idx="9">
                  <c:v>0.3891916</c:v>
                </c:pt>
                <c:pt idx="10">
                  <c:v>0.29225885</c:v>
                </c:pt>
                <c:pt idx="11">
                  <c:v>0.2405017</c:v>
                </c:pt>
                <c:pt idx="12">
                  <c:v>0.26007815</c:v>
                </c:pt>
                <c:pt idx="13">
                  <c:v>0.088352775</c:v>
                </c:pt>
                <c:pt idx="14">
                  <c:v>0.3722188</c:v>
                </c:pt>
                <c:pt idx="15">
                  <c:v>0.4347652</c:v>
                </c:pt>
                <c:pt idx="16">
                  <c:v>0.33846625</c:v>
                </c:pt>
                <c:pt idx="17">
                  <c:v>0.31664545</c:v>
                </c:pt>
                <c:pt idx="18">
                  <c:v>0.26152875</c:v>
                </c:pt>
                <c:pt idx="19">
                  <c:v>0.2739076</c:v>
                </c:pt>
                <c:pt idx="20">
                  <c:v>0.40488125</c:v>
                </c:pt>
                <c:pt idx="21">
                  <c:v>0.42761035</c:v>
                </c:pt>
                <c:pt idx="22">
                  <c:v>0.4158937</c:v>
                </c:pt>
                <c:pt idx="23">
                  <c:v>0.3890263</c:v>
                </c:pt>
                <c:pt idx="24">
                  <c:v>0.44854365</c:v>
                </c:pt>
                <c:pt idx="25">
                  <c:v>0.2915322</c:v>
                </c:pt>
                <c:pt idx="26">
                  <c:v>0.445994</c:v>
                </c:pt>
                <c:pt idx="27">
                  <c:v>0.46902065</c:v>
                </c:pt>
                <c:pt idx="28">
                  <c:v>0.49756635</c:v>
                </c:pt>
                <c:pt idx="29">
                  <c:v>0.3904136</c:v>
                </c:pt>
                <c:pt idx="30">
                  <c:v>0.4295704</c:v>
                </c:pt>
                <c:pt idx="31">
                  <c:v>0.43439485</c:v>
                </c:pt>
                <c:pt idx="32">
                  <c:v>0.45444735</c:v>
                </c:pt>
                <c:pt idx="33">
                  <c:v>0.4591714</c:v>
                </c:pt>
                <c:pt idx="34">
                  <c:v>0.4713384</c:v>
                </c:pt>
                <c:pt idx="35">
                  <c:v>0.37190755</c:v>
                </c:pt>
                <c:pt idx="36">
                  <c:v>0.44418275</c:v>
                </c:pt>
                <c:pt idx="37">
                  <c:v>0.4907778</c:v>
                </c:pt>
                <c:pt idx="38">
                  <c:v>0.4994177</c:v>
                </c:pt>
                <c:pt idx="39">
                  <c:v>0.4880691</c:v>
                </c:pt>
                <c:pt idx="40">
                  <c:v>0.5105385</c:v>
                </c:pt>
                <c:pt idx="41">
                  <c:v>0.43465735</c:v>
                </c:pt>
                <c:pt idx="42">
                  <c:v>0.41363195</c:v>
                </c:pt>
                <c:pt idx="43">
                  <c:v>0.38509025</c:v>
                </c:pt>
                <c:pt idx="44">
                  <c:v>0.3218878</c:v>
                </c:pt>
                <c:pt idx="45">
                  <c:v>0.32430115</c:v>
                </c:pt>
                <c:pt idx="46">
                  <c:v>0.37454135</c:v>
                </c:pt>
                <c:pt idx="47">
                  <c:v>0.32663395</c:v>
                </c:pt>
                <c:pt idx="48">
                  <c:v>0.36645225</c:v>
                </c:pt>
                <c:pt idx="49">
                  <c:v>0.3807461</c:v>
                </c:pt>
                <c:pt idx="50">
                  <c:v>0.38161835</c:v>
                </c:pt>
                <c:pt idx="51">
                  <c:v>0.15141545</c:v>
                </c:pt>
                <c:pt idx="52">
                  <c:v>0.11539215</c:v>
                </c:pt>
                <c:pt idx="53">
                  <c:v>0.1855481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20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M$21:$M$74</c:f>
              <c:numCache>
                <c:formatCode>General</c:formatCode>
                <c:ptCount val="54"/>
                <c:pt idx="0">
                  <c:v>0.1522053</c:v>
                </c:pt>
                <c:pt idx="1">
                  <c:v>0.27218915</c:v>
                </c:pt>
                <c:pt idx="2">
                  <c:v>0.43675385</c:v>
                </c:pt>
                <c:pt idx="3">
                  <c:v>0.44550725</c:v>
                </c:pt>
                <c:pt idx="4">
                  <c:v>0.3717227</c:v>
                </c:pt>
                <c:pt idx="5">
                  <c:v>0.46138805</c:v>
                </c:pt>
                <c:pt idx="6">
                  <c:v>0.43497305</c:v>
                </c:pt>
                <c:pt idx="7">
                  <c:v>0.3183332</c:v>
                </c:pt>
                <c:pt idx="8">
                  <c:v>0.4250857</c:v>
                </c:pt>
                <c:pt idx="9">
                  <c:v>0.38086245</c:v>
                </c:pt>
                <c:pt idx="10">
                  <c:v>0.2899523</c:v>
                </c:pt>
                <c:pt idx="11">
                  <c:v>0.24097565</c:v>
                </c:pt>
                <c:pt idx="12">
                  <c:v>0.22186065</c:v>
                </c:pt>
                <c:pt idx="13">
                  <c:v>0.09410045</c:v>
                </c:pt>
                <c:pt idx="14">
                  <c:v>0.3459112</c:v>
                </c:pt>
                <c:pt idx="15">
                  <c:v>0.4007093</c:v>
                </c:pt>
                <c:pt idx="16">
                  <c:v>0.3275387</c:v>
                </c:pt>
                <c:pt idx="17">
                  <c:v>0.30211365</c:v>
                </c:pt>
                <c:pt idx="18">
                  <c:v>0.2727601</c:v>
                </c:pt>
                <c:pt idx="19">
                  <c:v>0.29662785</c:v>
                </c:pt>
                <c:pt idx="20">
                  <c:v>0.45961585</c:v>
                </c:pt>
                <c:pt idx="21">
                  <c:v>0.42852505</c:v>
                </c:pt>
                <c:pt idx="22">
                  <c:v>0.3966432</c:v>
                </c:pt>
                <c:pt idx="23">
                  <c:v>0.3922953</c:v>
                </c:pt>
                <c:pt idx="24">
                  <c:v>0.4331904</c:v>
                </c:pt>
                <c:pt idx="25">
                  <c:v>0.3069935</c:v>
                </c:pt>
                <c:pt idx="26">
                  <c:v>0.45892625</c:v>
                </c:pt>
                <c:pt idx="27">
                  <c:v>0.473787</c:v>
                </c:pt>
                <c:pt idx="28">
                  <c:v>0.4912667</c:v>
                </c:pt>
                <c:pt idx="29">
                  <c:v>0.39174325</c:v>
                </c:pt>
                <c:pt idx="30">
                  <c:v>0.48212085</c:v>
                </c:pt>
                <c:pt idx="31">
                  <c:v>0.51393325</c:v>
                </c:pt>
                <c:pt idx="32">
                  <c:v>0.50834665</c:v>
                </c:pt>
                <c:pt idx="33">
                  <c:v>0.4645571</c:v>
                </c:pt>
                <c:pt idx="34">
                  <c:v>0.4697983</c:v>
                </c:pt>
                <c:pt idx="35">
                  <c:v>0.44178245</c:v>
                </c:pt>
                <c:pt idx="36">
                  <c:v>0.4862089</c:v>
                </c:pt>
                <c:pt idx="37">
                  <c:v>0.5270914</c:v>
                </c:pt>
                <c:pt idx="38">
                  <c:v>0.52076555</c:v>
                </c:pt>
                <c:pt idx="39">
                  <c:v>0.4974611</c:v>
                </c:pt>
                <c:pt idx="40">
                  <c:v>0.4922572</c:v>
                </c:pt>
                <c:pt idx="41">
                  <c:v>0.4812242</c:v>
                </c:pt>
                <c:pt idx="42">
                  <c:v>0.4577022</c:v>
                </c:pt>
                <c:pt idx="43">
                  <c:v>0.41103905</c:v>
                </c:pt>
                <c:pt idx="44">
                  <c:v>0.3368708</c:v>
                </c:pt>
                <c:pt idx="45">
                  <c:v>0.36883035</c:v>
                </c:pt>
                <c:pt idx="46">
                  <c:v>0.41836455</c:v>
                </c:pt>
                <c:pt idx="47">
                  <c:v>0.3997164</c:v>
                </c:pt>
                <c:pt idx="48">
                  <c:v>0.43507405</c:v>
                </c:pt>
                <c:pt idx="49">
                  <c:v>0.3771881</c:v>
                </c:pt>
                <c:pt idx="50">
                  <c:v>0.38495145</c:v>
                </c:pt>
                <c:pt idx="51">
                  <c:v>0.1363145</c:v>
                </c:pt>
                <c:pt idx="52">
                  <c:v>0.08885081</c:v>
                </c:pt>
                <c:pt idx="53">
                  <c:v>0.1690489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20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N$21:$N$74</c:f>
              <c:numCache>
                <c:formatCode>General</c:formatCode>
                <c:ptCount val="54"/>
                <c:pt idx="0">
                  <c:v>0.09604624</c:v>
                </c:pt>
                <c:pt idx="1">
                  <c:v>0.2189725</c:v>
                </c:pt>
                <c:pt idx="2">
                  <c:v>0.3875987</c:v>
                </c:pt>
                <c:pt idx="3">
                  <c:v>0.3884493</c:v>
                </c:pt>
                <c:pt idx="4">
                  <c:v>0.29077715</c:v>
                </c:pt>
                <c:pt idx="5">
                  <c:v>0.43117765</c:v>
                </c:pt>
                <c:pt idx="6">
                  <c:v>0.414615</c:v>
                </c:pt>
                <c:pt idx="7">
                  <c:v>0.28232005</c:v>
                </c:pt>
                <c:pt idx="8">
                  <c:v>0.3864789</c:v>
                </c:pt>
                <c:pt idx="9">
                  <c:v>0.37247365</c:v>
                </c:pt>
                <c:pt idx="10">
                  <c:v>0.20194915</c:v>
                </c:pt>
                <c:pt idx="11">
                  <c:v>0.16262645</c:v>
                </c:pt>
                <c:pt idx="12">
                  <c:v>0.090333875</c:v>
                </c:pt>
                <c:pt idx="13">
                  <c:v>0.0446398</c:v>
                </c:pt>
                <c:pt idx="14">
                  <c:v>0.27708695</c:v>
                </c:pt>
                <c:pt idx="15">
                  <c:v>0.3516775</c:v>
                </c:pt>
                <c:pt idx="16">
                  <c:v>0.26223895</c:v>
                </c:pt>
                <c:pt idx="17">
                  <c:v>0.25036785</c:v>
                </c:pt>
                <c:pt idx="18">
                  <c:v>0.22502215</c:v>
                </c:pt>
                <c:pt idx="19">
                  <c:v>0.24886635</c:v>
                </c:pt>
                <c:pt idx="20">
                  <c:v>0.42646555</c:v>
                </c:pt>
                <c:pt idx="21">
                  <c:v>0.37796815</c:v>
                </c:pt>
                <c:pt idx="22">
                  <c:v>0.37727395</c:v>
                </c:pt>
                <c:pt idx="23">
                  <c:v>0.3469208</c:v>
                </c:pt>
                <c:pt idx="24">
                  <c:v>0.3975564</c:v>
                </c:pt>
                <c:pt idx="25">
                  <c:v>0.26779535</c:v>
                </c:pt>
                <c:pt idx="26">
                  <c:v>0.4586366</c:v>
                </c:pt>
                <c:pt idx="27">
                  <c:v>0.4952365</c:v>
                </c:pt>
                <c:pt idx="28">
                  <c:v>0.50636905</c:v>
                </c:pt>
                <c:pt idx="29">
                  <c:v>0.3350979</c:v>
                </c:pt>
                <c:pt idx="30">
                  <c:v>0.4189132</c:v>
                </c:pt>
                <c:pt idx="31">
                  <c:v>0.44478405</c:v>
                </c:pt>
                <c:pt idx="32">
                  <c:v>0.451685</c:v>
                </c:pt>
                <c:pt idx="33">
                  <c:v>0.51900785</c:v>
                </c:pt>
                <c:pt idx="34">
                  <c:v>0.5173988</c:v>
                </c:pt>
                <c:pt idx="35">
                  <c:v>0.4370601</c:v>
                </c:pt>
                <c:pt idx="36">
                  <c:v>0.48755245</c:v>
                </c:pt>
                <c:pt idx="37">
                  <c:v>0.52637515</c:v>
                </c:pt>
                <c:pt idx="38">
                  <c:v>0.5268866</c:v>
                </c:pt>
                <c:pt idx="39">
                  <c:v>0.4978854</c:v>
                </c:pt>
                <c:pt idx="40">
                  <c:v>0.5083403</c:v>
                </c:pt>
                <c:pt idx="41">
                  <c:v>0.44344695</c:v>
                </c:pt>
                <c:pt idx="42">
                  <c:v>0.48188905</c:v>
                </c:pt>
                <c:pt idx="43">
                  <c:v>0.4592897</c:v>
                </c:pt>
                <c:pt idx="44">
                  <c:v>0.2953993</c:v>
                </c:pt>
                <c:pt idx="45">
                  <c:v>0.39871585</c:v>
                </c:pt>
                <c:pt idx="46">
                  <c:v>0.5479477</c:v>
                </c:pt>
                <c:pt idx="47">
                  <c:v>0.4946813</c:v>
                </c:pt>
                <c:pt idx="48">
                  <c:v>0.46665765</c:v>
                </c:pt>
                <c:pt idx="49">
                  <c:v>0.33933355</c:v>
                </c:pt>
                <c:pt idx="50">
                  <c:v>0.3317619</c:v>
                </c:pt>
                <c:pt idx="51">
                  <c:v>0.08391819</c:v>
                </c:pt>
                <c:pt idx="52">
                  <c:v>0.049891785</c:v>
                </c:pt>
                <c:pt idx="53">
                  <c:v>0.09805118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20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1:$E$74</c:f>
              <c:strCache>
                <c:ptCount val="54"/>
                <c:pt idx="0">
                  <c:v>cg19107595</c:v>
                </c:pt>
                <c:pt idx="1">
                  <c:v>cg19924104</c:v>
                </c:pt>
                <c:pt idx="2">
                  <c:v>cg11589966</c:v>
                </c:pt>
                <c:pt idx="3">
                  <c:v>cg27435646</c:v>
                </c:pt>
                <c:pt idx="4">
                  <c:v>cg01566785</c:v>
                </c:pt>
                <c:pt idx="5">
                  <c:v>cg05819130</c:v>
                </c:pt>
                <c:pt idx="6">
                  <c:v>cg10105290</c:v>
                </c:pt>
                <c:pt idx="7">
                  <c:v>cg19079047</c:v>
                </c:pt>
                <c:pt idx="8">
                  <c:v>cg02965180</c:v>
                </c:pt>
                <c:pt idx="9">
                  <c:v>cg05277165</c:v>
                </c:pt>
                <c:pt idx="10">
                  <c:v>cg13660372</c:v>
                </c:pt>
                <c:pt idx="11">
                  <c:v>cg06674062</c:v>
                </c:pt>
                <c:pt idx="12">
                  <c:v>cg21778340</c:v>
                </c:pt>
                <c:pt idx="13">
                  <c:v>cg07921535</c:v>
                </c:pt>
                <c:pt idx="14">
                  <c:v>cg09910998</c:v>
                </c:pt>
                <c:pt idx="15">
                  <c:v>cg27393730</c:v>
                </c:pt>
                <c:pt idx="16">
                  <c:v>cg08291000</c:v>
                </c:pt>
                <c:pt idx="17">
                  <c:v>cg27230044</c:v>
                </c:pt>
                <c:pt idx="18">
                  <c:v>cg24885794</c:v>
                </c:pt>
                <c:pt idx="19">
                  <c:v>cg26997085</c:v>
                </c:pt>
                <c:pt idx="20">
                  <c:v>cg22331138</c:v>
                </c:pt>
                <c:pt idx="21">
                  <c:v>cg16492735</c:v>
                </c:pt>
                <c:pt idx="22">
                  <c:v>cg09512080</c:v>
                </c:pt>
                <c:pt idx="23">
                  <c:v>cg00906934</c:v>
                </c:pt>
                <c:pt idx="24">
                  <c:v>cg26503018</c:v>
                </c:pt>
                <c:pt idx="25">
                  <c:v>cg27120649</c:v>
                </c:pt>
                <c:pt idx="26">
                  <c:v>cg21771834</c:v>
                </c:pt>
                <c:pt idx="27">
                  <c:v>cg27001184</c:v>
                </c:pt>
                <c:pt idx="28">
                  <c:v>cg23342787</c:v>
                </c:pt>
                <c:pt idx="29">
                  <c:v>cg14873490</c:v>
                </c:pt>
                <c:pt idx="30">
                  <c:v>cg03384175</c:v>
                </c:pt>
                <c:pt idx="31">
                  <c:v>cg11985632</c:v>
                </c:pt>
                <c:pt idx="32">
                  <c:v>cg13797824</c:v>
                </c:pt>
                <c:pt idx="33">
                  <c:v>cg11175683</c:v>
                </c:pt>
                <c:pt idx="34">
                  <c:v>cg04521244</c:v>
                </c:pt>
                <c:pt idx="35">
                  <c:v>cg11562309</c:v>
                </c:pt>
                <c:pt idx="36">
                  <c:v>cg18898992</c:v>
                </c:pt>
                <c:pt idx="37">
                  <c:v>cg05096321</c:v>
                </c:pt>
                <c:pt idx="38">
                  <c:v>cg19663555</c:v>
                </c:pt>
                <c:pt idx="39">
                  <c:v>cg06695761</c:v>
                </c:pt>
                <c:pt idx="40">
                  <c:v>cg21853542</c:v>
                </c:pt>
                <c:pt idx="41">
                  <c:v>cg04634483</c:v>
                </c:pt>
                <c:pt idx="42">
                  <c:v>cg09890341</c:v>
                </c:pt>
                <c:pt idx="43">
                  <c:v>cg20041873</c:v>
                </c:pt>
                <c:pt idx="44">
                  <c:v>cg04303139</c:v>
                </c:pt>
                <c:pt idx="45">
                  <c:v>cg03436478</c:v>
                </c:pt>
                <c:pt idx="46">
                  <c:v>cg05509218</c:v>
                </c:pt>
                <c:pt idx="47">
                  <c:v>cg22924867</c:v>
                </c:pt>
                <c:pt idx="48">
                  <c:v>cg01169624</c:v>
                </c:pt>
                <c:pt idx="49">
                  <c:v>cg03682823</c:v>
                </c:pt>
                <c:pt idx="50">
                  <c:v>cg18139769</c:v>
                </c:pt>
                <c:pt idx="51">
                  <c:v>cg12397924</c:v>
                </c:pt>
                <c:pt idx="52">
                  <c:v>cg15696408</c:v>
                </c:pt>
                <c:pt idx="53">
                  <c:v>cg22820921</c:v>
                </c:pt>
              </c:strCache>
            </c:strRef>
          </c:cat>
          <c:val>
            <c:numRef>
              <c:f>revise_data!$O$21:$O$74</c:f>
              <c:numCache>
                <c:formatCode>General</c:formatCode>
                <c:ptCount val="54"/>
                <c:pt idx="0">
                  <c:v>0.07458837</c:v>
                </c:pt>
                <c:pt idx="1">
                  <c:v>0.10068924</c:v>
                </c:pt>
                <c:pt idx="2">
                  <c:v>0.2305034</c:v>
                </c:pt>
                <c:pt idx="3">
                  <c:v>0.2086423</c:v>
                </c:pt>
                <c:pt idx="4">
                  <c:v>0.110966635</c:v>
                </c:pt>
                <c:pt idx="5">
                  <c:v>0.26103635</c:v>
                </c:pt>
                <c:pt idx="6">
                  <c:v>0.21345205</c:v>
                </c:pt>
                <c:pt idx="7">
                  <c:v>0.106469255</c:v>
                </c:pt>
                <c:pt idx="8">
                  <c:v>0.138641015</c:v>
                </c:pt>
                <c:pt idx="9">
                  <c:v>0.2180922</c:v>
                </c:pt>
                <c:pt idx="10">
                  <c:v>0.13248907</c:v>
                </c:pt>
                <c:pt idx="11">
                  <c:v>0.09944756</c:v>
                </c:pt>
                <c:pt idx="12">
                  <c:v>0.07081178</c:v>
                </c:pt>
                <c:pt idx="13">
                  <c:v>0.02144688</c:v>
                </c:pt>
                <c:pt idx="14">
                  <c:v>0.094169</c:v>
                </c:pt>
                <c:pt idx="15">
                  <c:v>0.17768785</c:v>
                </c:pt>
                <c:pt idx="16">
                  <c:v>0.1287067</c:v>
                </c:pt>
                <c:pt idx="17">
                  <c:v>0.095372265</c:v>
                </c:pt>
                <c:pt idx="18">
                  <c:v>0.11428815</c:v>
                </c:pt>
                <c:pt idx="19">
                  <c:v>0.14700115</c:v>
                </c:pt>
                <c:pt idx="20">
                  <c:v>0.26119065</c:v>
                </c:pt>
                <c:pt idx="21">
                  <c:v>0.2819446</c:v>
                </c:pt>
                <c:pt idx="22">
                  <c:v>0.24174965</c:v>
                </c:pt>
                <c:pt idx="23">
                  <c:v>0.2504408</c:v>
                </c:pt>
                <c:pt idx="24">
                  <c:v>0.3090201</c:v>
                </c:pt>
                <c:pt idx="25">
                  <c:v>0.19273495</c:v>
                </c:pt>
                <c:pt idx="26">
                  <c:v>0.41785295</c:v>
                </c:pt>
                <c:pt idx="27">
                  <c:v>0.43777315</c:v>
                </c:pt>
                <c:pt idx="28">
                  <c:v>0.46119485</c:v>
                </c:pt>
                <c:pt idx="29">
                  <c:v>0.26336885</c:v>
                </c:pt>
                <c:pt idx="30">
                  <c:v>0.3483902</c:v>
                </c:pt>
                <c:pt idx="31">
                  <c:v>0.363479</c:v>
                </c:pt>
                <c:pt idx="32">
                  <c:v>0.32511765</c:v>
                </c:pt>
                <c:pt idx="33">
                  <c:v>0.44285925</c:v>
                </c:pt>
                <c:pt idx="34">
                  <c:v>0.4594844</c:v>
                </c:pt>
                <c:pt idx="35">
                  <c:v>0.2921407</c:v>
                </c:pt>
                <c:pt idx="36">
                  <c:v>0.3884066</c:v>
                </c:pt>
                <c:pt idx="37">
                  <c:v>0.4971363</c:v>
                </c:pt>
                <c:pt idx="38">
                  <c:v>0.50785755</c:v>
                </c:pt>
                <c:pt idx="39">
                  <c:v>0.4250069</c:v>
                </c:pt>
                <c:pt idx="40">
                  <c:v>0.46759715</c:v>
                </c:pt>
                <c:pt idx="41">
                  <c:v>0.41709825</c:v>
                </c:pt>
                <c:pt idx="42">
                  <c:v>0.26417045</c:v>
                </c:pt>
                <c:pt idx="43">
                  <c:v>0.21488405</c:v>
                </c:pt>
                <c:pt idx="44">
                  <c:v>0.193345</c:v>
                </c:pt>
                <c:pt idx="45">
                  <c:v>0.17412385</c:v>
                </c:pt>
                <c:pt idx="46">
                  <c:v>0.2584405</c:v>
                </c:pt>
                <c:pt idx="47">
                  <c:v>0.28321475</c:v>
                </c:pt>
                <c:pt idx="48">
                  <c:v>0.4372324</c:v>
                </c:pt>
                <c:pt idx="49">
                  <c:v>0.31978495</c:v>
                </c:pt>
                <c:pt idx="50">
                  <c:v>0.328608</c:v>
                </c:pt>
                <c:pt idx="51">
                  <c:v>0.07623223</c:v>
                </c:pt>
                <c:pt idx="52">
                  <c:v>0.067274525</c:v>
                </c:pt>
                <c:pt idx="53">
                  <c:v>0.0946281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25889736"/>
        <c:axId val="-2123552440"/>
      </c:lineChart>
      <c:catAx>
        <c:axId val="212588973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23552440"/>
        <c:crosses val="autoZero"/>
        <c:auto val="1"/>
        <c:lblAlgn val="ctr"/>
        <c:lblOffset val="100"/>
        <c:noMultiLvlLbl val="0"/>
      </c:catAx>
      <c:valAx>
        <c:axId val="-212355244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125889736"/>
        <c:crosses val="autoZero"/>
        <c:crossBetween val="between"/>
        <c:majorUnit val="0.5"/>
        <c:minorUnit val="0.5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506414639983852"/>
          <c:y val="0.135169298245614"/>
          <c:w val="0.932260009861427"/>
          <c:h val="0.649064035087719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76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F$77:$F$138</c:f>
              <c:numCache>
                <c:formatCode>General</c:formatCode>
                <c:ptCount val="62"/>
                <c:pt idx="0">
                  <c:v>0.6415335</c:v>
                </c:pt>
                <c:pt idx="1">
                  <c:v>0.6647381</c:v>
                </c:pt>
                <c:pt idx="2">
                  <c:v>0.4370579</c:v>
                </c:pt>
                <c:pt idx="3">
                  <c:v>0.31236205</c:v>
                </c:pt>
                <c:pt idx="4">
                  <c:v>0.5053535</c:v>
                </c:pt>
                <c:pt idx="5">
                  <c:v>0.39641765</c:v>
                </c:pt>
                <c:pt idx="6">
                  <c:v>0.5434839</c:v>
                </c:pt>
                <c:pt idx="7">
                  <c:v>0.5107575</c:v>
                </c:pt>
                <c:pt idx="8">
                  <c:v>0.45922405</c:v>
                </c:pt>
                <c:pt idx="9">
                  <c:v>0.4361631</c:v>
                </c:pt>
                <c:pt idx="10">
                  <c:v>0.5789774</c:v>
                </c:pt>
                <c:pt idx="11">
                  <c:v>0.3644496</c:v>
                </c:pt>
                <c:pt idx="12">
                  <c:v>0.36436695</c:v>
                </c:pt>
                <c:pt idx="13">
                  <c:v>0.27655645</c:v>
                </c:pt>
                <c:pt idx="14">
                  <c:v>0.2429819</c:v>
                </c:pt>
                <c:pt idx="15">
                  <c:v>0.3444664</c:v>
                </c:pt>
                <c:pt idx="16">
                  <c:v>0.1865507</c:v>
                </c:pt>
                <c:pt idx="17">
                  <c:v>0.21594075</c:v>
                </c:pt>
                <c:pt idx="18">
                  <c:v>0.24861835</c:v>
                </c:pt>
                <c:pt idx="19">
                  <c:v>0.2502493</c:v>
                </c:pt>
                <c:pt idx="20">
                  <c:v>0.35145235</c:v>
                </c:pt>
                <c:pt idx="21">
                  <c:v>0.30827675</c:v>
                </c:pt>
                <c:pt idx="22">
                  <c:v>0.3161206</c:v>
                </c:pt>
                <c:pt idx="23">
                  <c:v>0.2942675</c:v>
                </c:pt>
                <c:pt idx="24">
                  <c:v>0.3878341</c:v>
                </c:pt>
                <c:pt idx="25">
                  <c:v>0.38388415</c:v>
                </c:pt>
                <c:pt idx="26">
                  <c:v>0.3505084</c:v>
                </c:pt>
                <c:pt idx="27">
                  <c:v>0.42719995</c:v>
                </c:pt>
                <c:pt idx="28">
                  <c:v>0.44917405</c:v>
                </c:pt>
                <c:pt idx="29">
                  <c:v>0.28177175</c:v>
                </c:pt>
                <c:pt idx="30">
                  <c:v>0.38941785</c:v>
                </c:pt>
                <c:pt idx="31">
                  <c:v>0.2453348</c:v>
                </c:pt>
                <c:pt idx="32">
                  <c:v>0.34009275</c:v>
                </c:pt>
                <c:pt idx="33">
                  <c:v>0.2246143</c:v>
                </c:pt>
                <c:pt idx="34">
                  <c:v>0.30418975</c:v>
                </c:pt>
                <c:pt idx="35">
                  <c:v>0.24009885</c:v>
                </c:pt>
                <c:pt idx="36">
                  <c:v>0.2644845</c:v>
                </c:pt>
                <c:pt idx="37">
                  <c:v>0.25218535</c:v>
                </c:pt>
                <c:pt idx="38">
                  <c:v>0.3232863</c:v>
                </c:pt>
                <c:pt idx="39">
                  <c:v>0.3916523</c:v>
                </c:pt>
                <c:pt idx="40">
                  <c:v>0.3937016</c:v>
                </c:pt>
                <c:pt idx="41">
                  <c:v>0.33929115</c:v>
                </c:pt>
                <c:pt idx="42">
                  <c:v>0.33511645</c:v>
                </c:pt>
                <c:pt idx="43">
                  <c:v>0.28347035</c:v>
                </c:pt>
                <c:pt idx="44">
                  <c:v>0.3673231</c:v>
                </c:pt>
                <c:pt idx="45">
                  <c:v>0.39564455</c:v>
                </c:pt>
                <c:pt idx="46">
                  <c:v>0.4183478</c:v>
                </c:pt>
                <c:pt idx="47">
                  <c:v>0.2782988</c:v>
                </c:pt>
                <c:pt idx="48">
                  <c:v>0.36325565</c:v>
                </c:pt>
                <c:pt idx="49">
                  <c:v>0.2318773</c:v>
                </c:pt>
                <c:pt idx="50">
                  <c:v>0.3083526</c:v>
                </c:pt>
                <c:pt idx="51">
                  <c:v>0.34021395</c:v>
                </c:pt>
                <c:pt idx="52">
                  <c:v>0.48979955</c:v>
                </c:pt>
                <c:pt idx="53">
                  <c:v>0.4128841</c:v>
                </c:pt>
                <c:pt idx="54">
                  <c:v>0.45291265</c:v>
                </c:pt>
                <c:pt idx="55">
                  <c:v>0.20632585</c:v>
                </c:pt>
                <c:pt idx="56">
                  <c:v>0.25768515</c:v>
                </c:pt>
                <c:pt idx="57">
                  <c:v>0.463609</c:v>
                </c:pt>
                <c:pt idx="58">
                  <c:v>0.3828852</c:v>
                </c:pt>
                <c:pt idx="59">
                  <c:v>0.3862206</c:v>
                </c:pt>
                <c:pt idx="60">
                  <c:v>0.49246405</c:v>
                </c:pt>
                <c:pt idx="61">
                  <c:v>0.4626864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76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G$77:$G$138</c:f>
              <c:numCache>
                <c:formatCode>General</c:formatCode>
                <c:ptCount val="62"/>
                <c:pt idx="0">
                  <c:v>0.5967036</c:v>
                </c:pt>
                <c:pt idx="1">
                  <c:v>0.63477895</c:v>
                </c:pt>
                <c:pt idx="2">
                  <c:v>0.44570295</c:v>
                </c:pt>
                <c:pt idx="3">
                  <c:v>0.3106876</c:v>
                </c:pt>
                <c:pt idx="4">
                  <c:v>0.4579635</c:v>
                </c:pt>
                <c:pt idx="5">
                  <c:v>0.38847785</c:v>
                </c:pt>
                <c:pt idx="6">
                  <c:v>0.52518165</c:v>
                </c:pt>
                <c:pt idx="7">
                  <c:v>0.37692075</c:v>
                </c:pt>
                <c:pt idx="8">
                  <c:v>0.41605735</c:v>
                </c:pt>
                <c:pt idx="9">
                  <c:v>0.39948365</c:v>
                </c:pt>
                <c:pt idx="10">
                  <c:v>0.5820408</c:v>
                </c:pt>
                <c:pt idx="11">
                  <c:v>0.3750791</c:v>
                </c:pt>
                <c:pt idx="12">
                  <c:v>0.3954141</c:v>
                </c:pt>
                <c:pt idx="13">
                  <c:v>0.29341635</c:v>
                </c:pt>
                <c:pt idx="14">
                  <c:v>0.3225615</c:v>
                </c:pt>
                <c:pt idx="15">
                  <c:v>0.28580085</c:v>
                </c:pt>
                <c:pt idx="16">
                  <c:v>0.1776302</c:v>
                </c:pt>
                <c:pt idx="17">
                  <c:v>0.26550775</c:v>
                </c:pt>
                <c:pt idx="18">
                  <c:v>0.3172417</c:v>
                </c:pt>
                <c:pt idx="19">
                  <c:v>0.28318665</c:v>
                </c:pt>
                <c:pt idx="20">
                  <c:v>0.2966906</c:v>
                </c:pt>
                <c:pt idx="21">
                  <c:v>0.2508262</c:v>
                </c:pt>
                <c:pt idx="22">
                  <c:v>0.2949392</c:v>
                </c:pt>
                <c:pt idx="23">
                  <c:v>0.2499796</c:v>
                </c:pt>
                <c:pt idx="24">
                  <c:v>0.3282476</c:v>
                </c:pt>
                <c:pt idx="25">
                  <c:v>0.32162665</c:v>
                </c:pt>
                <c:pt idx="26">
                  <c:v>0.4171093</c:v>
                </c:pt>
                <c:pt idx="27">
                  <c:v>0.43005505</c:v>
                </c:pt>
                <c:pt idx="28">
                  <c:v>0.4274604</c:v>
                </c:pt>
                <c:pt idx="29">
                  <c:v>0.43936525</c:v>
                </c:pt>
                <c:pt idx="30">
                  <c:v>0.354862</c:v>
                </c:pt>
                <c:pt idx="31">
                  <c:v>0.39256255</c:v>
                </c:pt>
                <c:pt idx="32">
                  <c:v>0.37447985</c:v>
                </c:pt>
                <c:pt idx="33">
                  <c:v>0.29516775</c:v>
                </c:pt>
                <c:pt idx="34">
                  <c:v>0.29151355</c:v>
                </c:pt>
                <c:pt idx="35">
                  <c:v>0.2122205</c:v>
                </c:pt>
                <c:pt idx="36">
                  <c:v>0.2435652</c:v>
                </c:pt>
                <c:pt idx="37">
                  <c:v>0.25685005</c:v>
                </c:pt>
                <c:pt idx="38">
                  <c:v>0.17906715</c:v>
                </c:pt>
                <c:pt idx="39">
                  <c:v>0.20780105</c:v>
                </c:pt>
                <c:pt idx="40">
                  <c:v>0.20870145</c:v>
                </c:pt>
                <c:pt idx="41">
                  <c:v>0.19025165</c:v>
                </c:pt>
                <c:pt idx="42">
                  <c:v>0.21120625</c:v>
                </c:pt>
                <c:pt idx="43">
                  <c:v>0.13161675</c:v>
                </c:pt>
                <c:pt idx="44">
                  <c:v>0.3651659</c:v>
                </c:pt>
                <c:pt idx="45">
                  <c:v>0.41473825</c:v>
                </c:pt>
                <c:pt idx="46">
                  <c:v>0.38547905</c:v>
                </c:pt>
                <c:pt idx="47">
                  <c:v>0.33685295</c:v>
                </c:pt>
                <c:pt idx="48">
                  <c:v>0.36550875</c:v>
                </c:pt>
                <c:pt idx="49">
                  <c:v>0.22641205</c:v>
                </c:pt>
                <c:pt idx="50">
                  <c:v>0.268976</c:v>
                </c:pt>
                <c:pt idx="51">
                  <c:v>0.3139847</c:v>
                </c:pt>
                <c:pt idx="52">
                  <c:v>0.47614345</c:v>
                </c:pt>
                <c:pt idx="53">
                  <c:v>0.3850647</c:v>
                </c:pt>
                <c:pt idx="54">
                  <c:v>0.4234745</c:v>
                </c:pt>
                <c:pt idx="55">
                  <c:v>0.2299854</c:v>
                </c:pt>
                <c:pt idx="56">
                  <c:v>0.2740488</c:v>
                </c:pt>
                <c:pt idx="57">
                  <c:v>0.43255835</c:v>
                </c:pt>
                <c:pt idx="58">
                  <c:v>0.397106</c:v>
                </c:pt>
                <c:pt idx="59">
                  <c:v>0.34173505</c:v>
                </c:pt>
                <c:pt idx="60">
                  <c:v>0.4955969</c:v>
                </c:pt>
                <c:pt idx="61">
                  <c:v>0.4121879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76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H$77:$H$138</c:f>
              <c:numCache>
                <c:formatCode>General</c:formatCode>
                <c:ptCount val="62"/>
                <c:pt idx="0">
                  <c:v>0.6437867</c:v>
                </c:pt>
                <c:pt idx="1">
                  <c:v>0.63300965</c:v>
                </c:pt>
                <c:pt idx="2">
                  <c:v>0.4965937</c:v>
                </c:pt>
                <c:pt idx="3">
                  <c:v>0.26765175</c:v>
                </c:pt>
                <c:pt idx="4">
                  <c:v>0.4913243</c:v>
                </c:pt>
                <c:pt idx="5">
                  <c:v>0.42519275</c:v>
                </c:pt>
                <c:pt idx="6">
                  <c:v>0.42122835</c:v>
                </c:pt>
                <c:pt idx="7">
                  <c:v>0.3778423</c:v>
                </c:pt>
                <c:pt idx="8">
                  <c:v>0.3614359</c:v>
                </c:pt>
                <c:pt idx="9">
                  <c:v>0.35850635</c:v>
                </c:pt>
                <c:pt idx="10">
                  <c:v>0.50307425</c:v>
                </c:pt>
                <c:pt idx="11">
                  <c:v>0.3455781</c:v>
                </c:pt>
                <c:pt idx="12">
                  <c:v>0.34123935</c:v>
                </c:pt>
                <c:pt idx="13">
                  <c:v>0.29512845</c:v>
                </c:pt>
                <c:pt idx="14">
                  <c:v>0.32120965</c:v>
                </c:pt>
                <c:pt idx="15">
                  <c:v>0.35733975</c:v>
                </c:pt>
                <c:pt idx="16">
                  <c:v>0.2604865</c:v>
                </c:pt>
                <c:pt idx="17">
                  <c:v>0.28013395</c:v>
                </c:pt>
                <c:pt idx="18">
                  <c:v>0.30479705</c:v>
                </c:pt>
                <c:pt idx="19">
                  <c:v>0.26817935</c:v>
                </c:pt>
                <c:pt idx="20">
                  <c:v>0.3068701</c:v>
                </c:pt>
                <c:pt idx="21">
                  <c:v>0.27848035</c:v>
                </c:pt>
                <c:pt idx="22">
                  <c:v>0.29984025</c:v>
                </c:pt>
                <c:pt idx="23">
                  <c:v>0.28329305</c:v>
                </c:pt>
                <c:pt idx="24">
                  <c:v>0.26688615</c:v>
                </c:pt>
                <c:pt idx="25">
                  <c:v>0.3437442</c:v>
                </c:pt>
                <c:pt idx="26">
                  <c:v>0.5196329</c:v>
                </c:pt>
                <c:pt idx="27">
                  <c:v>0.4253391</c:v>
                </c:pt>
                <c:pt idx="28">
                  <c:v>0.4538101</c:v>
                </c:pt>
                <c:pt idx="29">
                  <c:v>0.3162902</c:v>
                </c:pt>
                <c:pt idx="30">
                  <c:v>0.3643886</c:v>
                </c:pt>
                <c:pt idx="31">
                  <c:v>0.4013444</c:v>
                </c:pt>
                <c:pt idx="32">
                  <c:v>0.3817191</c:v>
                </c:pt>
                <c:pt idx="33">
                  <c:v>0.2802228</c:v>
                </c:pt>
                <c:pt idx="34">
                  <c:v>0.2985221</c:v>
                </c:pt>
                <c:pt idx="35">
                  <c:v>0.20214115</c:v>
                </c:pt>
                <c:pt idx="36">
                  <c:v>0.24025775</c:v>
                </c:pt>
                <c:pt idx="37">
                  <c:v>0.20145885</c:v>
                </c:pt>
                <c:pt idx="38">
                  <c:v>0.2492025</c:v>
                </c:pt>
                <c:pt idx="39">
                  <c:v>0.3237495</c:v>
                </c:pt>
                <c:pt idx="40">
                  <c:v>0.2686809</c:v>
                </c:pt>
                <c:pt idx="41">
                  <c:v>0.2583731</c:v>
                </c:pt>
                <c:pt idx="42">
                  <c:v>0.2967453</c:v>
                </c:pt>
                <c:pt idx="43">
                  <c:v>0.20959775</c:v>
                </c:pt>
                <c:pt idx="44">
                  <c:v>0.37973035</c:v>
                </c:pt>
                <c:pt idx="45">
                  <c:v>0.40884875</c:v>
                </c:pt>
                <c:pt idx="46">
                  <c:v>0.4107987</c:v>
                </c:pt>
                <c:pt idx="47">
                  <c:v>0.33507205</c:v>
                </c:pt>
                <c:pt idx="48">
                  <c:v>0.4041192</c:v>
                </c:pt>
                <c:pt idx="49">
                  <c:v>0.27013645</c:v>
                </c:pt>
                <c:pt idx="50">
                  <c:v>0.35018555</c:v>
                </c:pt>
                <c:pt idx="51">
                  <c:v>0.3619517</c:v>
                </c:pt>
                <c:pt idx="52">
                  <c:v>0.52392445</c:v>
                </c:pt>
                <c:pt idx="53">
                  <c:v>0.4116748</c:v>
                </c:pt>
                <c:pt idx="54">
                  <c:v>0.4278691</c:v>
                </c:pt>
                <c:pt idx="55">
                  <c:v>0.2462255</c:v>
                </c:pt>
                <c:pt idx="56">
                  <c:v>0.29941945</c:v>
                </c:pt>
                <c:pt idx="57">
                  <c:v>0.39797595</c:v>
                </c:pt>
                <c:pt idx="58">
                  <c:v>0.4454287</c:v>
                </c:pt>
                <c:pt idx="59">
                  <c:v>0.3211127</c:v>
                </c:pt>
                <c:pt idx="60">
                  <c:v>0.52533525</c:v>
                </c:pt>
                <c:pt idx="61">
                  <c:v>0.5276058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76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  <a:alpha val="98000"/>
                  </a:schemeClr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I$77:$I$138</c:f>
              <c:numCache>
                <c:formatCode>General</c:formatCode>
                <c:ptCount val="62"/>
                <c:pt idx="0">
                  <c:v>0.53012835</c:v>
                </c:pt>
                <c:pt idx="1">
                  <c:v>0.5492214</c:v>
                </c:pt>
                <c:pt idx="2">
                  <c:v>0.39230805</c:v>
                </c:pt>
                <c:pt idx="3">
                  <c:v>0.25606575</c:v>
                </c:pt>
                <c:pt idx="4">
                  <c:v>0.47048115</c:v>
                </c:pt>
                <c:pt idx="5">
                  <c:v>0.42821645</c:v>
                </c:pt>
                <c:pt idx="6">
                  <c:v>0.4656562</c:v>
                </c:pt>
                <c:pt idx="7">
                  <c:v>0.4540231</c:v>
                </c:pt>
                <c:pt idx="8">
                  <c:v>0.36722795</c:v>
                </c:pt>
                <c:pt idx="9">
                  <c:v>0.3560546</c:v>
                </c:pt>
                <c:pt idx="10">
                  <c:v>0.4609696</c:v>
                </c:pt>
                <c:pt idx="11">
                  <c:v>0.3386003</c:v>
                </c:pt>
                <c:pt idx="12">
                  <c:v>0.2880368</c:v>
                </c:pt>
                <c:pt idx="13">
                  <c:v>0.2464578</c:v>
                </c:pt>
                <c:pt idx="14">
                  <c:v>0.17513365</c:v>
                </c:pt>
                <c:pt idx="15">
                  <c:v>0.38153555</c:v>
                </c:pt>
                <c:pt idx="16">
                  <c:v>0.23417465</c:v>
                </c:pt>
                <c:pt idx="17">
                  <c:v>0.27036475</c:v>
                </c:pt>
                <c:pt idx="18">
                  <c:v>0.3037684</c:v>
                </c:pt>
                <c:pt idx="19">
                  <c:v>0.2743369</c:v>
                </c:pt>
                <c:pt idx="20">
                  <c:v>0.3016626</c:v>
                </c:pt>
                <c:pt idx="21">
                  <c:v>0.31707025</c:v>
                </c:pt>
                <c:pt idx="22">
                  <c:v>0.35448085</c:v>
                </c:pt>
                <c:pt idx="23">
                  <c:v>0.34422265</c:v>
                </c:pt>
                <c:pt idx="24">
                  <c:v>0.3645919</c:v>
                </c:pt>
                <c:pt idx="25">
                  <c:v>0.42262705</c:v>
                </c:pt>
                <c:pt idx="26">
                  <c:v>0.4781942</c:v>
                </c:pt>
                <c:pt idx="27">
                  <c:v>0.4429506</c:v>
                </c:pt>
                <c:pt idx="28">
                  <c:v>0.44722225</c:v>
                </c:pt>
                <c:pt idx="29">
                  <c:v>0.3496</c:v>
                </c:pt>
                <c:pt idx="30">
                  <c:v>0.3825387</c:v>
                </c:pt>
                <c:pt idx="31">
                  <c:v>0.31303845</c:v>
                </c:pt>
                <c:pt idx="32">
                  <c:v>0.39633345</c:v>
                </c:pt>
                <c:pt idx="33">
                  <c:v>0.30862435</c:v>
                </c:pt>
                <c:pt idx="34">
                  <c:v>0.3050024</c:v>
                </c:pt>
                <c:pt idx="35">
                  <c:v>0.2424431</c:v>
                </c:pt>
                <c:pt idx="36">
                  <c:v>0.30465955</c:v>
                </c:pt>
                <c:pt idx="37">
                  <c:v>0.28593245</c:v>
                </c:pt>
                <c:pt idx="38">
                  <c:v>0.22104915</c:v>
                </c:pt>
                <c:pt idx="39">
                  <c:v>0.2511368</c:v>
                </c:pt>
                <c:pt idx="40">
                  <c:v>0.2364479</c:v>
                </c:pt>
                <c:pt idx="41">
                  <c:v>0.2139817</c:v>
                </c:pt>
                <c:pt idx="42">
                  <c:v>0.2501511</c:v>
                </c:pt>
                <c:pt idx="43">
                  <c:v>0.1772186</c:v>
                </c:pt>
                <c:pt idx="44">
                  <c:v>0.3601751</c:v>
                </c:pt>
                <c:pt idx="45">
                  <c:v>0.38678735</c:v>
                </c:pt>
                <c:pt idx="46">
                  <c:v>0.38615805</c:v>
                </c:pt>
                <c:pt idx="47">
                  <c:v>0.32920775</c:v>
                </c:pt>
                <c:pt idx="48">
                  <c:v>0.3898144</c:v>
                </c:pt>
                <c:pt idx="49">
                  <c:v>0.2491286</c:v>
                </c:pt>
                <c:pt idx="50">
                  <c:v>0.28277135</c:v>
                </c:pt>
                <c:pt idx="51">
                  <c:v>0.3674562</c:v>
                </c:pt>
                <c:pt idx="52">
                  <c:v>0.47457155</c:v>
                </c:pt>
                <c:pt idx="53">
                  <c:v>0.3799282</c:v>
                </c:pt>
                <c:pt idx="54">
                  <c:v>0.4073122</c:v>
                </c:pt>
                <c:pt idx="55">
                  <c:v>0.2377119</c:v>
                </c:pt>
                <c:pt idx="56">
                  <c:v>0.2733191</c:v>
                </c:pt>
                <c:pt idx="57">
                  <c:v>0.44193995</c:v>
                </c:pt>
                <c:pt idx="58">
                  <c:v>0.35183775</c:v>
                </c:pt>
                <c:pt idx="59">
                  <c:v>0.3996651</c:v>
                </c:pt>
                <c:pt idx="60">
                  <c:v>0.5068724</c:v>
                </c:pt>
                <c:pt idx="61">
                  <c:v>0.5257828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76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>
                    <a:alpha val="95000"/>
                  </a:srgbClr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J$77:$J$138</c:f>
              <c:numCache>
                <c:formatCode>General</c:formatCode>
                <c:ptCount val="62"/>
                <c:pt idx="0">
                  <c:v>0.634626</c:v>
                </c:pt>
                <c:pt idx="1">
                  <c:v>0.5913047</c:v>
                </c:pt>
                <c:pt idx="2">
                  <c:v>0.49191195</c:v>
                </c:pt>
                <c:pt idx="3">
                  <c:v>0.29478285</c:v>
                </c:pt>
                <c:pt idx="4">
                  <c:v>0.44359255</c:v>
                </c:pt>
                <c:pt idx="5">
                  <c:v>0.40236025</c:v>
                </c:pt>
                <c:pt idx="6">
                  <c:v>0.44621765</c:v>
                </c:pt>
                <c:pt idx="7">
                  <c:v>0.42268255</c:v>
                </c:pt>
                <c:pt idx="8">
                  <c:v>0.38975575</c:v>
                </c:pt>
                <c:pt idx="9">
                  <c:v>0.39110635</c:v>
                </c:pt>
                <c:pt idx="10">
                  <c:v>0.5706548</c:v>
                </c:pt>
                <c:pt idx="11">
                  <c:v>0.3252391</c:v>
                </c:pt>
                <c:pt idx="12">
                  <c:v>0.35763875</c:v>
                </c:pt>
                <c:pt idx="13">
                  <c:v>0.35993005</c:v>
                </c:pt>
                <c:pt idx="14">
                  <c:v>0.313072</c:v>
                </c:pt>
                <c:pt idx="15">
                  <c:v>0.2882487</c:v>
                </c:pt>
                <c:pt idx="16">
                  <c:v>0.2053846</c:v>
                </c:pt>
                <c:pt idx="17">
                  <c:v>0.219938</c:v>
                </c:pt>
                <c:pt idx="18">
                  <c:v>0.22993895</c:v>
                </c:pt>
                <c:pt idx="19">
                  <c:v>0.250066</c:v>
                </c:pt>
                <c:pt idx="20">
                  <c:v>0.29486465</c:v>
                </c:pt>
                <c:pt idx="21">
                  <c:v>0.3129668</c:v>
                </c:pt>
                <c:pt idx="22">
                  <c:v>0.3297642</c:v>
                </c:pt>
                <c:pt idx="23">
                  <c:v>0.30914555</c:v>
                </c:pt>
                <c:pt idx="24">
                  <c:v>0.2855941</c:v>
                </c:pt>
                <c:pt idx="25">
                  <c:v>0.31033435</c:v>
                </c:pt>
                <c:pt idx="26">
                  <c:v>0.4445484</c:v>
                </c:pt>
                <c:pt idx="27">
                  <c:v>0.4603833</c:v>
                </c:pt>
                <c:pt idx="28">
                  <c:v>0.4547738</c:v>
                </c:pt>
                <c:pt idx="29">
                  <c:v>0.29703155</c:v>
                </c:pt>
                <c:pt idx="30">
                  <c:v>0.3884099</c:v>
                </c:pt>
                <c:pt idx="31">
                  <c:v>0.4066411</c:v>
                </c:pt>
                <c:pt idx="32">
                  <c:v>0.41290205</c:v>
                </c:pt>
                <c:pt idx="33">
                  <c:v>0.3303352</c:v>
                </c:pt>
                <c:pt idx="34">
                  <c:v>0.3108866</c:v>
                </c:pt>
                <c:pt idx="35">
                  <c:v>0.2438443</c:v>
                </c:pt>
                <c:pt idx="36">
                  <c:v>0.2548348</c:v>
                </c:pt>
                <c:pt idx="37">
                  <c:v>0.18990635</c:v>
                </c:pt>
                <c:pt idx="38">
                  <c:v>0.24211335</c:v>
                </c:pt>
                <c:pt idx="39">
                  <c:v>0.3210529</c:v>
                </c:pt>
                <c:pt idx="40">
                  <c:v>0.2706762</c:v>
                </c:pt>
                <c:pt idx="41">
                  <c:v>0.2737387</c:v>
                </c:pt>
                <c:pt idx="42">
                  <c:v>0.2941894</c:v>
                </c:pt>
                <c:pt idx="43">
                  <c:v>0.24978085</c:v>
                </c:pt>
                <c:pt idx="44">
                  <c:v>0.389697</c:v>
                </c:pt>
                <c:pt idx="45">
                  <c:v>0.4077265</c:v>
                </c:pt>
                <c:pt idx="46">
                  <c:v>0.3992782</c:v>
                </c:pt>
                <c:pt idx="47">
                  <c:v>0.2634646</c:v>
                </c:pt>
                <c:pt idx="48">
                  <c:v>0.35844475</c:v>
                </c:pt>
                <c:pt idx="49">
                  <c:v>0.15719744</c:v>
                </c:pt>
                <c:pt idx="50">
                  <c:v>0.34507005</c:v>
                </c:pt>
                <c:pt idx="51">
                  <c:v>0.34124025</c:v>
                </c:pt>
                <c:pt idx="52">
                  <c:v>0.50266795</c:v>
                </c:pt>
                <c:pt idx="53">
                  <c:v>0.4411878</c:v>
                </c:pt>
                <c:pt idx="54">
                  <c:v>0.4671626</c:v>
                </c:pt>
                <c:pt idx="55">
                  <c:v>0.1950985</c:v>
                </c:pt>
                <c:pt idx="56">
                  <c:v>0.2691293</c:v>
                </c:pt>
                <c:pt idx="57">
                  <c:v>0.44521475</c:v>
                </c:pt>
                <c:pt idx="58">
                  <c:v>0.4431159</c:v>
                </c:pt>
                <c:pt idx="59">
                  <c:v>0.3597381</c:v>
                </c:pt>
                <c:pt idx="60">
                  <c:v>0.55064555</c:v>
                </c:pt>
                <c:pt idx="61">
                  <c:v>0.5123159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76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K$77:$K$138</c:f>
              <c:numCache>
                <c:formatCode>General</c:formatCode>
                <c:ptCount val="62"/>
                <c:pt idx="0">
                  <c:v>0.52666825</c:v>
                </c:pt>
                <c:pt idx="1">
                  <c:v>0.5767713</c:v>
                </c:pt>
                <c:pt idx="2">
                  <c:v>0.43868305</c:v>
                </c:pt>
                <c:pt idx="3">
                  <c:v>0.23880255</c:v>
                </c:pt>
                <c:pt idx="4">
                  <c:v>0.4026458</c:v>
                </c:pt>
                <c:pt idx="5">
                  <c:v>0.351173</c:v>
                </c:pt>
                <c:pt idx="6">
                  <c:v>0.46832815</c:v>
                </c:pt>
                <c:pt idx="7">
                  <c:v>0.3665902</c:v>
                </c:pt>
                <c:pt idx="8">
                  <c:v>0.36415395</c:v>
                </c:pt>
                <c:pt idx="9">
                  <c:v>0.3456785</c:v>
                </c:pt>
                <c:pt idx="10">
                  <c:v>0.45590135</c:v>
                </c:pt>
                <c:pt idx="11">
                  <c:v>0.2988796</c:v>
                </c:pt>
                <c:pt idx="12">
                  <c:v>0.26152775</c:v>
                </c:pt>
                <c:pt idx="13">
                  <c:v>0.2872403</c:v>
                </c:pt>
                <c:pt idx="14">
                  <c:v>0.20362995</c:v>
                </c:pt>
                <c:pt idx="15">
                  <c:v>0.2996312</c:v>
                </c:pt>
                <c:pt idx="16">
                  <c:v>0.1875318</c:v>
                </c:pt>
                <c:pt idx="17">
                  <c:v>0.2219027</c:v>
                </c:pt>
                <c:pt idx="18">
                  <c:v>0.2633474</c:v>
                </c:pt>
                <c:pt idx="19">
                  <c:v>0.27583675</c:v>
                </c:pt>
                <c:pt idx="20">
                  <c:v>0.25454845</c:v>
                </c:pt>
                <c:pt idx="21">
                  <c:v>0.28088775</c:v>
                </c:pt>
                <c:pt idx="22">
                  <c:v>0.3076695</c:v>
                </c:pt>
                <c:pt idx="23">
                  <c:v>0.26310005</c:v>
                </c:pt>
                <c:pt idx="24">
                  <c:v>0.33787635</c:v>
                </c:pt>
                <c:pt idx="25">
                  <c:v>0.32409665</c:v>
                </c:pt>
                <c:pt idx="26">
                  <c:v>0.433153</c:v>
                </c:pt>
                <c:pt idx="27">
                  <c:v>0.43891865</c:v>
                </c:pt>
                <c:pt idx="28">
                  <c:v>0.44489175</c:v>
                </c:pt>
                <c:pt idx="29">
                  <c:v>0.32849415</c:v>
                </c:pt>
                <c:pt idx="30">
                  <c:v>0.3451375</c:v>
                </c:pt>
                <c:pt idx="31">
                  <c:v>0.367239</c:v>
                </c:pt>
                <c:pt idx="32">
                  <c:v>0.3681712</c:v>
                </c:pt>
                <c:pt idx="33">
                  <c:v>0.18529255</c:v>
                </c:pt>
                <c:pt idx="34">
                  <c:v>0.29256375</c:v>
                </c:pt>
                <c:pt idx="35">
                  <c:v>0.22708245</c:v>
                </c:pt>
                <c:pt idx="36">
                  <c:v>0.2168967</c:v>
                </c:pt>
                <c:pt idx="37">
                  <c:v>0.1866081</c:v>
                </c:pt>
                <c:pt idx="38">
                  <c:v>0.2456817</c:v>
                </c:pt>
                <c:pt idx="39">
                  <c:v>0.30407155</c:v>
                </c:pt>
                <c:pt idx="40">
                  <c:v>0.2549306</c:v>
                </c:pt>
                <c:pt idx="41">
                  <c:v>0.24029725</c:v>
                </c:pt>
                <c:pt idx="42">
                  <c:v>0.2643719</c:v>
                </c:pt>
                <c:pt idx="43">
                  <c:v>0.1829202</c:v>
                </c:pt>
                <c:pt idx="44">
                  <c:v>0.4014134</c:v>
                </c:pt>
                <c:pt idx="45">
                  <c:v>0.40593685</c:v>
                </c:pt>
                <c:pt idx="46">
                  <c:v>0.3791784</c:v>
                </c:pt>
                <c:pt idx="47">
                  <c:v>0.2858283</c:v>
                </c:pt>
                <c:pt idx="48">
                  <c:v>0.3675575</c:v>
                </c:pt>
                <c:pt idx="49">
                  <c:v>0.19547415</c:v>
                </c:pt>
                <c:pt idx="50">
                  <c:v>0.2819352</c:v>
                </c:pt>
                <c:pt idx="51">
                  <c:v>0.31461335</c:v>
                </c:pt>
                <c:pt idx="52">
                  <c:v>0.4762575</c:v>
                </c:pt>
                <c:pt idx="53">
                  <c:v>0.3926069</c:v>
                </c:pt>
                <c:pt idx="54">
                  <c:v>0.42102</c:v>
                </c:pt>
                <c:pt idx="55">
                  <c:v>0.2050026</c:v>
                </c:pt>
                <c:pt idx="56">
                  <c:v>0.2368909</c:v>
                </c:pt>
                <c:pt idx="57">
                  <c:v>0.444998</c:v>
                </c:pt>
                <c:pt idx="58">
                  <c:v>0.52293205</c:v>
                </c:pt>
                <c:pt idx="59">
                  <c:v>0.3882134</c:v>
                </c:pt>
                <c:pt idx="60">
                  <c:v>0.50391825</c:v>
                </c:pt>
                <c:pt idx="61">
                  <c:v>0.4747927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76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L$77:$L$138</c:f>
              <c:numCache>
                <c:formatCode>General</c:formatCode>
                <c:ptCount val="62"/>
                <c:pt idx="0">
                  <c:v>0.5729548</c:v>
                </c:pt>
                <c:pt idx="1">
                  <c:v>0.6548768</c:v>
                </c:pt>
                <c:pt idx="2">
                  <c:v>0.45891195</c:v>
                </c:pt>
                <c:pt idx="3">
                  <c:v>0.3636677</c:v>
                </c:pt>
                <c:pt idx="4">
                  <c:v>0.580677</c:v>
                </c:pt>
                <c:pt idx="5">
                  <c:v>0.40437725</c:v>
                </c:pt>
                <c:pt idx="6">
                  <c:v>0.52838235</c:v>
                </c:pt>
                <c:pt idx="7">
                  <c:v>0.34716775</c:v>
                </c:pt>
                <c:pt idx="8">
                  <c:v>0.432661</c:v>
                </c:pt>
                <c:pt idx="9">
                  <c:v>0.4141653</c:v>
                </c:pt>
                <c:pt idx="10">
                  <c:v>0.5084912</c:v>
                </c:pt>
                <c:pt idx="11">
                  <c:v>0.3718774</c:v>
                </c:pt>
                <c:pt idx="12">
                  <c:v>0.31800775</c:v>
                </c:pt>
                <c:pt idx="13">
                  <c:v>0.29393155</c:v>
                </c:pt>
                <c:pt idx="14">
                  <c:v>0.20162775</c:v>
                </c:pt>
                <c:pt idx="15">
                  <c:v>0.3596569</c:v>
                </c:pt>
                <c:pt idx="16">
                  <c:v>0.2035786</c:v>
                </c:pt>
                <c:pt idx="17">
                  <c:v>0.22467595</c:v>
                </c:pt>
                <c:pt idx="18">
                  <c:v>0.26256575</c:v>
                </c:pt>
                <c:pt idx="19">
                  <c:v>0.24397295</c:v>
                </c:pt>
                <c:pt idx="20">
                  <c:v>0.2110646</c:v>
                </c:pt>
                <c:pt idx="21">
                  <c:v>0.3366259</c:v>
                </c:pt>
                <c:pt idx="22">
                  <c:v>0.35559895</c:v>
                </c:pt>
                <c:pt idx="23">
                  <c:v>0.33786615</c:v>
                </c:pt>
                <c:pt idx="24">
                  <c:v>0.2893958</c:v>
                </c:pt>
                <c:pt idx="25">
                  <c:v>0.2898337</c:v>
                </c:pt>
                <c:pt idx="26">
                  <c:v>0.37005405</c:v>
                </c:pt>
                <c:pt idx="27">
                  <c:v>0.4549654</c:v>
                </c:pt>
                <c:pt idx="28">
                  <c:v>0.45968065</c:v>
                </c:pt>
                <c:pt idx="29">
                  <c:v>0.32101225</c:v>
                </c:pt>
                <c:pt idx="30">
                  <c:v>0.3819541</c:v>
                </c:pt>
                <c:pt idx="31">
                  <c:v>0.34654865</c:v>
                </c:pt>
                <c:pt idx="32">
                  <c:v>0.31649305</c:v>
                </c:pt>
                <c:pt idx="33">
                  <c:v>0.32487855</c:v>
                </c:pt>
                <c:pt idx="34">
                  <c:v>0.3115945</c:v>
                </c:pt>
                <c:pt idx="35">
                  <c:v>0.2229051</c:v>
                </c:pt>
                <c:pt idx="36">
                  <c:v>0.25594925</c:v>
                </c:pt>
                <c:pt idx="37">
                  <c:v>0.2067368</c:v>
                </c:pt>
                <c:pt idx="38">
                  <c:v>0.2300166</c:v>
                </c:pt>
                <c:pt idx="39">
                  <c:v>0.3043304</c:v>
                </c:pt>
                <c:pt idx="40">
                  <c:v>0.2731558</c:v>
                </c:pt>
                <c:pt idx="41">
                  <c:v>0.2643176</c:v>
                </c:pt>
                <c:pt idx="42">
                  <c:v>0.2521429</c:v>
                </c:pt>
                <c:pt idx="43">
                  <c:v>0.2184621</c:v>
                </c:pt>
                <c:pt idx="44">
                  <c:v>0.3602463</c:v>
                </c:pt>
                <c:pt idx="45">
                  <c:v>0.3942628</c:v>
                </c:pt>
                <c:pt idx="46">
                  <c:v>0.3798993</c:v>
                </c:pt>
                <c:pt idx="47">
                  <c:v>0.2851728</c:v>
                </c:pt>
                <c:pt idx="48">
                  <c:v>0.35487295</c:v>
                </c:pt>
                <c:pt idx="49">
                  <c:v>0.1784886</c:v>
                </c:pt>
                <c:pt idx="50">
                  <c:v>0.28516215</c:v>
                </c:pt>
                <c:pt idx="51">
                  <c:v>0.3185201</c:v>
                </c:pt>
                <c:pt idx="52">
                  <c:v>0.53683235</c:v>
                </c:pt>
                <c:pt idx="53">
                  <c:v>0.4620542</c:v>
                </c:pt>
                <c:pt idx="54">
                  <c:v>0.46618445</c:v>
                </c:pt>
                <c:pt idx="55">
                  <c:v>0.1921763</c:v>
                </c:pt>
                <c:pt idx="56">
                  <c:v>0.2457816</c:v>
                </c:pt>
                <c:pt idx="57">
                  <c:v>0.4636367</c:v>
                </c:pt>
                <c:pt idx="58">
                  <c:v>0.4003536</c:v>
                </c:pt>
                <c:pt idx="59">
                  <c:v>0.39595715</c:v>
                </c:pt>
                <c:pt idx="60">
                  <c:v>0.6210368</c:v>
                </c:pt>
                <c:pt idx="61">
                  <c:v>0.5334071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76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>
                    <a:alpha val="98000"/>
                  </a:srgbClr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M$77:$M$138</c:f>
              <c:numCache>
                <c:formatCode>General</c:formatCode>
                <c:ptCount val="62"/>
                <c:pt idx="0">
                  <c:v>0.5795152</c:v>
                </c:pt>
                <c:pt idx="1">
                  <c:v>0.6225579</c:v>
                </c:pt>
                <c:pt idx="2">
                  <c:v>0.5229186</c:v>
                </c:pt>
                <c:pt idx="3">
                  <c:v>0.28544875</c:v>
                </c:pt>
                <c:pt idx="4">
                  <c:v>0.55550995</c:v>
                </c:pt>
                <c:pt idx="5">
                  <c:v>0.48429045</c:v>
                </c:pt>
                <c:pt idx="6">
                  <c:v>0.48908885</c:v>
                </c:pt>
                <c:pt idx="7">
                  <c:v>0.468974</c:v>
                </c:pt>
                <c:pt idx="8">
                  <c:v>0.45425555</c:v>
                </c:pt>
                <c:pt idx="9">
                  <c:v>0.4339667</c:v>
                </c:pt>
                <c:pt idx="10">
                  <c:v>0.50393495</c:v>
                </c:pt>
                <c:pt idx="11">
                  <c:v>0.3366703</c:v>
                </c:pt>
                <c:pt idx="12">
                  <c:v>0.3795464</c:v>
                </c:pt>
                <c:pt idx="13">
                  <c:v>0.28860695</c:v>
                </c:pt>
                <c:pt idx="14">
                  <c:v>0.2838373</c:v>
                </c:pt>
                <c:pt idx="15">
                  <c:v>0.35530205</c:v>
                </c:pt>
                <c:pt idx="16">
                  <c:v>0.22980735</c:v>
                </c:pt>
                <c:pt idx="17">
                  <c:v>0.2564342</c:v>
                </c:pt>
                <c:pt idx="18">
                  <c:v>0.3045171</c:v>
                </c:pt>
                <c:pt idx="19">
                  <c:v>0.26910325</c:v>
                </c:pt>
                <c:pt idx="20">
                  <c:v>0.2629151</c:v>
                </c:pt>
                <c:pt idx="21">
                  <c:v>0.3435464</c:v>
                </c:pt>
                <c:pt idx="22">
                  <c:v>0.3523748</c:v>
                </c:pt>
                <c:pt idx="23">
                  <c:v>0.3324899</c:v>
                </c:pt>
                <c:pt idx="24">
                  <c:v>0.3356725</c:v>
                </c:pt>
                <c:pt idx="25">
                  <c:v>0.3501732</c:v>
                </c:pt>
                <c:pt idx="26">
                  <c:v>0.45089595</c:v>
                </c:pt>
                <c:pt idx="27">
                  <c:v>0.448394</c:v>
                </c:pt>
                <c:pt idx="28">
                  <c:v>0.4647579</c:v>
                </c:pt>
                <c:pt idx="29">
                  <c:v>0.34115995</c:v>
                </c:pt>
                <c:pt idx="30">
                  <c:v>0.38178965</c:v>
                </c:pt>
                <c:pt idx="31">
                  <c:v>0.3362433</c:v>
                </c:pt>
                <c:pt idx="32">
                  <c:v>0.35588885</c:v>
                </c:pt>
                <c:pt idx="33">
                  <c:v>0.2395188</c:v>
                </c:pt>
                <c:pt idx="34">
                  <c:v>0.3076808</c:v>
                </c:pt>
                <c:pt idx="35">
                  <c:v>0.2202166</c:v>
                </c:pt>
                <c:pt idx="36">
                  <c:v>0.24494225</c:v>
                </c:pt>
                <c:pt idx="37">
                  <c:v>0.2532614</c:v>
                </c:pt>
                <c:pt idx="38">
                  <c:v>0.3155032</c:v>
                </c:pt>
                <c:pt idx="39">
                  <c:v>0.36408585</c:v>
                </c:pt>
                <c:pt idx="40">
                  <c:v>0.34495825</c:v>
                </c:pt>
                <c:pt idx="41">
                  <c:v>0.3183667</c:v>
                </c:pt>
                <c:pt idx="42">
                  <c:v>0.30652975</c:v>
                </c:pt>
                <c:pt idx="43">
                  <c:v>0.2107111</c:v>
                </c:pt>
                <c:pt idx="44">
                  <c:v>0.35953605</c:v>
                </c:pt>
                <c:pt idx="45">
                  <c:v>0.392724</c:v>
                </c:pt>
                <c:pt idx="46">
                  <c:v>0.4266966</c:v>
                </c:pt>
                <c:pt idx="47">
                  <c:v>0.34391585</c:v>
                </c:pt>
                <c:pt idx="48">
                  <c:v>0.40362095</c:v>
                </c:pt>
                <c:pt idx="49">
                  <c:v>0.2628357</c:v>
                </c:pt>
                <c:pt idx="50">
                  <c:v>0.30945675</c:v>
                </c:pt>
                <c:pt idx="51">
                  <c:v>0.3869609</c:v>
                </c:pt>
                <c:pt idx="52">
                  <c:v>0.5489433</c:v>
                </c:pt>
                <c:pt idx="53">
                  <c:v>0.5319772</c:v>
                </c:pt>
                <c:pt idx="54">
                  <c:v>0.5494191</c:v>
                </c:pt>
                <c:pt idx="55">
                  <c:v>0.24777</c:v>
                </c:pt>
                <c:pt idx="56">
                  <c:v>0.3677513</c:v>
                </c:pt>
                <c:pt idx="57">
                  <c:v>0.5208042</c:v>
                </c:pt>
                <c:pt idx="58">
                  <c:v>0.417394</c:v>
                </c:pt>
                <c:pt idx="59">
                  <c:v>0.4344357</c:v>
                </c:pt>
                <c:pt idx="60">
                  <c:v>0.59013825</c:v>
                </c:pt>
                <c:pt idx="61">
                  <c:v>0.5659172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76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N$77:$N$138</c:f>
              <c:numCache>
                <c:formatCode>General</c:formatCode>
                <c:ptCount val="62"/>
                <c:pt idx="0">
                  <c:v>0.4186514</c:v>
                </c:pt>
                <c:pt idx="1">
                  <c:v>0.5591012</c:v>
                </c:pt>
                <c:pt idx="2">
                  <c:v>0.462617</c:v>
                </c:pt>
                <c:pt idx="3">
                  <c:v>0.2316542</c:v>
                </c:pt>
                <c:pt idx="4">
                  <c:v>0.42546415</c:v>
                </c:pt>
                <c:pt idx="5">
                  <c:v>0.28284795</c:v>
                </c:pt>
                <c:pt idx="6">
                  <c:v>0.49415945</c:v>
                </c:pt>
                <c:pt idx="7">
                  <c:v>0.295391</c:v>
                </c:pt>
                <c:pt idx="8">
                  <c:v>0.36420115</c:v>
                </c:pt>
                <c:pt idx="9">
                  <c:v>0.3848308</c:v>
                </c:pt>
                <c:pt idx="10">
                  <c:v>0.60667805</c:v>
                </c:pt>
                <c:pt idx="11">
                  <c:v>0.32596115</c:v>
                </c:pt>
                <c:pt idx="12">
                  <c:v>0.3449101</c:v>
                </c:pt>
                <c:pt idx="13">
                  <c:v>0.30789395</c:v>
                </c:pt>
                <c:pt idx="14">
                  <c:v>0.22481605</c:v>
                </c:pt>
                <c:pt idx="15">
                  <c:v>0.2612363</c:v>
                </c:pt>
                <c:pt idx="16">
                  <c:v>0.2163418</c:v>
                </c:pt>
                <c:pt idx="17">
                  <c:v>0.23510385</c:v>
                </c:pt>
                <c:pt idx="18">
                  <c:v>0.30018715</c:v>
                </c:pt>
                <c:pt idx="19">
                  <c:v>0.30440245</c:v>
                </c:pt>
                <c:pt idx="20">
                  <c:v>0.29821435</c:v>
                </c:pt>
                <c:pt idx="21">
                  <c:v>0.19434265</c:v>
                </c:pt>
                <c:pt idx="22">
                  <c:v>0.25690075</c:v>
                </c:pt>
                <c:pt idx="23">
                  <c:v>0.2401183</c:v>
                </c:pt>
                <c:pt idx="24">
                  <c:v>0.277888</c:v>
                </c:pt>
                <c:pt idx="25">
                  <c:v>0.2807012</c:v>
                </c:pt>
                <c:pt idx="26">
                  <c:v>0.38238355</c:v>
                </c:pt>
                <c:pt idx="27">
                  <c:v>0.42189625</c:v>
                </c:pt>
                <c:pt idx="28">
                  <c:v>0.44163045</c:v>
                </c:pt>
                <c:pt idx="29">
                  <c:v>0.3218771</c:v>
                </c:pt>
                <c:pt idx="30">
                  <c:v>0.3716775</c:v>
                </c:pt>
                <c:pt idx="31">
                  <c:v>0.3192149</c:v>
                </c:pt>
                <c:pt idx="32">
                  <c:v>0.29889065</c:v>
                </c:pt>
                <c:pt idx="33">
                  <c:v>0.2042233</c:v>
                </c:pt>
                <c:pt idx="34">
                  <c:v>0.27182955</c:v>
                </c:pt>
                <c:pt idx="35">
                  <c:v>0.2210358</c:v>
                </c:pt>
                <c:pt idx="36">
                  <c:v>0.1970047</c:v>
                </c:pt>
                <c:pt idx="37">
                  <c:v>0.1490504</c:v>
                </c:pt>
                <c:pt idx="38">
                  <c:v>0.1811169</c:v>
                </c:pt>
                <c:pt idx="39">
                  <c:v>0.2461117</c:v>
                </c:pt>
                <c:pt idx="40">
                  <c:v>0.204712</c:v>
                </c:pt>
                <c:pt idx="41">
                  <c:v>0.223449</c:v>
                </c:pt>
                <c:pt idx="42">
                  <c:v>0.2260611</c:v>
                </c:pt>
                <c:pt idx="43">
                  <c:v>0.14171215</c:v>
                </c:pt>
                <c:pt idx="44">
                  <c:v>0.29702075</c:v>
                </c:pt>
                <c:pt idx="45">
                  <c:v>0.3353383</c:v>
                </c:pt>
                <c:pt idx="46">
                  <c:v>0.2729404</c:v>
                </c:pt>
                <c:pt idx="47">
                  <c:v>0.12017225</c:v>
                </c:pt>
                <c:pt idx="48">
                  <c:v>0.292217</c:v>
                </c:pt>
                <c:pt idx="49">
                  <c:v>0.107385245</c:v>
                </c:pt>
                <c:pt idx="50">
                  <c:v>0.27301535</c:v>
                </c:pt>
                <c:pt idx="51">
                  <c:v>0.20339545</c:v>
                </c:pt>
                <c:pt idx="52">
                  <c:v>0.4464742</c:v>
                </c:pt>
                <c:pt idx="53">
                  <c:v>0.3916</c:v>
                </c:pt>
                <c:pt idx="54">
                  <c:v>0.4079121</c:v>
                </c:pt>
                <c:pt idx="55">
                  <c:v>0.1582814</c:v>
                </c:pt>
                <c:pt idx="56">
                  <c:v>0.16392185</c:v>
                </c:pt>
                <c:pt idx="57">
                  <c:v>0.4076599</c:v>
                </c:pt>
                <c:pt idx="58">
                  <c:v>0.1824366</c:v>
                </c:pt>
                <c:pt idx="59">
                  <c:v>0.2864523</c:v>
                </c:pt>
                <c:pt idx="60">
                  <c:v>0.41066945</c:v>
                </c:pt>
                <c:pt idx="61">
                  <c:v>0.4222112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76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77:$E$138</c:f>
              <c:strCache>
                <c:ptCount val="62"/>
                <c:pt idx="0">
                  <c:v>cg10473158</c:v>
                </c:pt>
                <c:pt idx="1">
                  <c:v>cg05222671</c:v>
                </c:pt>
                <c:pt idx="2">
                  <c:v>cg10767216</c:v>
                </c:pt>
                <c:pt idx="3">
                  <c:v>cg12070022</c:v>
                </c:pt>
                <c:pt idx="4">
                  <c:v>cg15068552</c:v>
                </c:pt>
                <c:pt idx="5">
                  <c:v>cg17347253</c:v>
                </c:pt>
                <c:pt idx="6">
                  <c:v>cg02756856</c:v>
                </c:pt>
                <c:pt idx="7">
                  <c:v>cg26275543</c:v>
                </c:pt>
                <c:pt idx="8">
                  <c:v>cg20826277</c:v>
                </c:pt>
                <c:pt idx="9">
                  <c:v>cg14584935</c:v>
                </c:pt>
                <c:pt idx="10">
                  <c:v>cg24941047</c:v>
                </c:pt>
                <c:pt idx="11">
                  <c:v>cg07427065</c:v>
                </c:pt>
                <c:pt idx="12">
                  <c:v>cg02501418</c:v>
                </c:pt>
                <c:pt idx="13">
                  <c:v>cg08229366</c:v>
                </c:pt>
                <c:pt idx="14">
                  <c:v>cg07224147</c:v>
                </c:pt>
                <c:pt idx="15">
                  <c:v>cg27417677</c:v>
                </c:pt>
                <c:pt idx="16">
                  <c:v>cg09003373</c:v>
                </c:pt>
                <c:pt idx="17">
                  <c:v>cg14088957</c:v>
                </c:pt>
                <c:pt idx="18">
                  <c:v>cg06100421</c:v>
                </c:pt>
                <c:pt idx="19">
                  <c:v>cg20297423</c:v>
                </c:pt>
                <c:pt idx="20">
                  <c:v>cg05369791</c:v>
                </c:pt>
                <c:pt idx="21">
                  <c:v>cg08734637</c:v>
                </c:pt>
                <c:pt idx="22">
                  <c:v>cg13917504</c:v>
                </c:pt>
                <c:pt idx="23">
                  <c:v>cg25407198</c:v>
                </c:pt>
                <c:pt idx="24">
                  <c:v>cg21667116</c:v>
                </c:pt>
                <c:pt idx="25">
                  <c:v>cg23156962</c:v>
                </c:pt>
                <c:pt idx="26">
                  <c:v>cg04678950</c:v>
                </c:pt>
                <c:pt idx="27">
                  <c:v>cg17079325</c:v>
                </c:pt>
                <c:pt idx="28">
                  <c:v>cg04344875</c:v>
                </c:pt>
                <c:pt idx="29">
                  <c:v>cg18934293</c:v>
                </c:pt>
                <c:pt idx="30">
                  <c:v>cg00286878</c:v>
                </c:pt>
                <c:pt idx="31">
                  <c:v>cg12347392</c:v>
                </c:pt>
                <c:pt idx="32">
                  <c:v>cg04786207</c:v>
                </c:pt>
                <c:pt idx="33">
                  <c:v>cg19386484</c:v>
                </c:pt>
                <c:pt idx="34">
                  <c:v>cg26708559</c:v>
                </c:pt>
                <c:pt idx="35">
                  <c:v>cg22705386</c:v>
                </c:pt>
                <c:pt idx="36">
                  <c:v>cg06212135</c:v>
                </c:pt>
                <c:pt idx="37">
                  <c:v>cg10249538</c:v>
                </c:pt>
                <c:pt idx="38">
                  <c:v>cg16823958</c:v>
                </c:pt>
                <c:pt idx="39">
                  <c:v>cg27338480</c:v>
                </c:pt>
                <c:pt idx="40">
                  <c:v>cg09080913</c:v>
                </c:pt>
                <c:pt idx="41">
                  <c:v>cg13104298</c:v>
                </c:pt>
                <c:pt idx="42">
                  <c:v>cg07315018</c:v>
                </c:pt>
                <c:pt idx="43">
                  <c:v>cg21629528</c:v>
                </c:pt>
                <c:pt idx="44">
                  <c:v>cg20050761</c:v>
                </c:pt>
                <c:pt idx="45">
                  <c:v>cg07870293</c:v>
                </c:pt>
                <c:pt idx="46">
                  <c:v>cg05556276</c:v>
                </c:pt>
                <c:pt idx="47">
                  <c:v>cg17580798</c:v>
                </c:pt>
                <c:pt idx="48">
                  <c:v>cg05862114</c:v>
                </c:pt>
                <c:pt idx="49">
                  <c:v>cg01784351</c:v>
                </c:pt>
                <c:pt idx="50">
                  <c:v>cg27589003</c:v>
                </c:pt>
                <c:pt idx="51">
                  <c:v>cg19344806</c:v>
                </c:pt>
                <c:pt idx="52">
                  <c:v>cg23714917</c:v>
                </c:pt>
                <c:pt idx="53">
                  <c:v>cg21200654</c:v>
                </c:pt>
                <c:pt idx="54">
                  <c:v>cg25519926</c:v>
                </c:pt>
                <c:pt idx="55">
                  <c:v>cg09462536</c:v>
                </c:pt>
                <c:pt idx="56">
                  <c:v>cg22592140</c:v>
                </c:pt>
                <c:pt idx="57">
                  <c:v>cg03588221</c:v>
                </c:pt>
                <c:pt idx="58">
                  <c:v>cg13986840</c:v>
                </c:pt>
                <c:pt idx="59">
                  <c:v>cg23312013</c:v>
                </c:pt>
                <c:pt idx="60">
                  <c:v>cg14952237</c:v>
                </c:pt>
                <c:pt idx="61">
                  <c:v>cg05260959</c:v>
                </c:pt>
              </c:strCache>
            </c:strRef>
          </c:cat>
          <c:val>
            <c:numRef>
              <c:f>revise_data!$O$77:$O$138</c:f>
              <c:numCache>
                <c:formatCode>General</c:formatCode>
                <c:ptCount val="62"/>
                <c:pt idx="0">
                  <c:v>0.3215098</c:v>
                </c:pt>
                <c:pt idx="1">
                  <c:v>0.24196035</c:v>
                </c:pt>
                <c:pt idx="2">
                  <c:v>0.18339535</c:v>
                </c:pt>
                <c:pt idx="3">
                  <c:v>0.088857385</c:v>
                </c:pt>
                <c:pt idx="4">
                  <c:v>0.1374557</c:v>
                </c:pt>
                <c:pt idx="5">
                  <c:v>0.2131057</c:v>
                </c:pt>
                <c:pt idx="6">
                  <c:v>0.2849264</c:v>
                </c:pt>
                <c:pt idx="7">
                  <c:v>0.157729705</c:v>
                </c:pt>
                <c:pt idx="8">
                  <c:v>0.1503319</c:v>
                </c:pt>
                <c:pt idx="9">
                  <c:v>0.1512646</c:v>
                </c:pt>
                <c:pt idx="10">
                  <c:v>0.30807935</c:v>
                </c:pt>
                <c:pt idx="11">
                  <c:v>0.12484825</c:v>
                </c:pt>
                <c:pt idx="12">
                  <c:v>0.1601059</c:v>
                </c:pt>
                <c:pt idx="13">
                  <c:v>0.1612211</c:v>
                </c:pt>
                <c:pt idx="14">
                  <c:v>0.118636625</c:v>
                </c:pt>
                <c:pt idx="15">
                  <c:v>0.24678885</c:v>
                </c:pt>
                <c:pt idx="16">
                  <c:v>0.08838998</c:v>
                </c:pt>
                <c:pt idx="17">
                  <c:v>0.091180725</c:v>
                </c:pt>
                <c:pt idx="18">
                  <c:v>0.1650937</c:v>
                </c:pt>
                <c:pt idx="19">
                  <c:v>0.15878655</c:v>
                </c:pt>
                <c:pt idx="20">
                  <c:v>0.1184145</c:v>
                </c:pt>
                <c:pt idx="21">
                  <c:v>0.27648755</c:v>
                </c:pt>
                <c:pt idx="22">
                  <c:v>0.30549345</c:v>
                </c:pt>
                <c:pt idx="23">
                  <c:v>0.26625285</c:v>
                </c:pt>
                <c:pt idx="24">
                  <c:v>0.30444435</c:v>
                </c:pt>
                <c:pt idx="25">
                  <c:v>0.3013474</c:v>
                </c:pt>
                <c:pt idx="26">
                  <c:v>0.4305123</c:v>
                </c:pt>
                <c:pt idx="27">
                  <c:v>0.39338695</c:v>
                </c:pt>
                <c:pt idx="28">
                  <c:v>0.4249672</c:v>
                </c:pt>
                <c:pt idx="29">
                  <c:v>0.3295283</c:v>
                </c:pt>
                <c:pt idx="30">
                  <c:v>0.30235925</c:v>
                </c:pt>
                <c:pt idx="31">
                  <c:v>0.22479095</c:v>
                </c:pt>
                <c:pt idx="32">
                  <c:v>0.280166</c:v>
                </c:pt>
                <c:pt idx="33">
                  <c:v>0.25459405</c:v>
                </c:pt>
                <c:pt idx="34">
                  <c:v>0.23401745</c:v>
                </c:pt>
                <c:pt idx="35">
                  <c:v>0.14352075</c:v>
                </c:pt>
                <c:pt idx="36">
                  <c:v>0.1551216</c:v>
                </c:pt>
                <c:pt idx="37">
                  <c:v>0.08151788</c:v>
                </c:pt>
                <c:pt idx="38">
                  <c:v>0.1333101</c:v>
                </c:pt>
                <c:pt idx="39">
                  <c:v>0.18280465</c:v>
                </c:pt>
                <c:pt idx="40">
                  <c:v>0.1575764</c:v>
                </c:pt>
                <c:pt idx="41">
                  <c:v>0.1111973</c:v>
                </c:pt>
                <c:pt idx="42">
                  <c:v>0.14532945</c:v>
                </c:pt>
                <c:pt idx="43">
                  <c:v>0.08989045</c:v>
                </c:pt>
                <c:pt idx="44">
                  <c:v>0.25115895</c:v>
                </c:pt>
                <c:pt idx="45">
                  <c:v>0.267851</c:v>
                </c:pt>
                <c:pt idx="46">
                  <c:v>0.3302361</c:v>
                </c:pt>
                <c:pt idx="47">
                  <c:v>0.23149609</c:v>
                </c:pt>
                <c:pt idx="48">
                  <c:v>0.3343832</c:v>
                </c:pt>
                <c:pt idx="49">
                  <c:v>0.17539512</c:v>
                </c:pt>
                <c:pt idx="50">
                  <c:v>0.17300775</c:v>
                </c:pt>
                <c:pt idx="51">
                  <c:v>0.27807735</c:v>
                </c:pt>
                <c:pt idx="52">
                  <c:v>0.3898951</c:v>
                </c:pt>
                <c:pt idx="53">
                  <c:v>0.35022895</c:v>
                </c:pt>
                <c:pt idx="54">
                  <c:v>0.3185013</c:v>
                </c:pt>
                <c:pt idx="55">
                  <c:v>0.13910935</c:v>
                </c:pt>
                <c:pt idx="56">
                  <c:v>0.152507</c:v>
                </c:pt>
                <c:pt idx="57">
                  <c:v>0.47975965</c:v>
                </c:pt>
                <c:pt idx="58">
                  <c:v>0.15816035</c:v>
                </c:pt>
                <c:pt idx="59">
                  <c:v>0.2883055</c:v>
                </c:pt>
                <c:pt idx="60">
                  <c:v>0.4133228</c:v>
                </c:pt>
                <c:pt idx="61">
                  <c:v>0.4471415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3021208"/>
        <c:axId val="-2122838808"/>
      </c:lineChart>
      <c:catAx>
        <c:axId val="-2123021208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22838808"/>
        <c:crosses val="autoZero"/>
        <c:auto val="1"/>
        <c:lblAlgn val="ctr"/>
        <c:lblOffset val="100"/>
        <c:noMultiLvlLbl val="0"/>
      </c:catAx>
      <c:valAx>
        <c:axId val="-2122838808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254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23021208"/>
        <c:crosses val="autoZero"/>
        <c:crossBetween val="between"/>
        <c:majorUnit val="0.5"/>
        <c:minorUnit val="0.2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510225983247554"/>
          <c:y val="0.143526000120471"/>
          <c:w val="0.931750189775843"/>
          <c:h val="0.605060048819245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140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F$141:$F$190</c:f>
              <c:numCache>
                <c:formatCode>General</c:formatCode>
                <c:ptCount val="50"/>
                <c:pt idx="0">
                  <c:v>0.4441928</c:v>
                </c:pt>
                <c:pt idx="1">
                  <c:v>0.3524332</c:v>
                </c:pt>
                <c:pt idx="2">
                  <c:v>0.39280465</c:v>
                </c:pt>
                <c:pt idx="3">
                  <c:v>0.4487543</c:v>
                </c:pt>
                <c:pt idx="4">
                  <c:v>0.36320965</c:v>
                </c:pt>
                <c:pt idx="5">
                  <c:v>0.35008205</c:v>
                </c:pt>
                <c:pt idx="6">
                  <c:v>0.32996105</c:v>
                </c:pt>
                <c:pt idx="7">
                  <c:v>0.3674173</c:v>
                </c:pt>
                <c:pt idx="8">
                  <c:v>0.44064135</c:v>
                </c:pt>
                <c:pt idx="9">
                  <c:v>0.41755825</c:v>
                </c:pt>
                <c:pt idx="10">
                  <c:v>0.3368546</c:v>
                </c:pt>
                <c:pt idx="11">
                  <c:v>0.43722535</c:v>
                </c:pt>
                <c:pt idx="12">
                  <c:v>0.40060845</c:v>
                </c:pt>
                <c:pt idx="13">
                  <c:v>0.5355977</c:v>
                </c:pt>
                <c:pt idx="14">
                  <c:v>0.38856545</c:v>
                </c:pt>
                <c:pt idx="15">
                  <c:v>0.45974055</c:v>
                </c:pt>
                <c:pt idx="16">
                  <c:v>0.41884685</c:v>
                </c:pt>
                <c:pt idx="17">
                  <c:v>0.41532345</c:v>
                </c:pt>
                <c:pt idx="18">
                  <c:v>0.43537925</c:v>
                </c:pt>
                <c:pt idx="19">
                  <c:v>0.3922062</c:v>
                </c:pt>
                <c:pt idx="20">
                  <c:v>0.3217563</c:v>
                </c:pt>
                <c:pt idx="21">
                  <c:v>0.34817835</c:v>
                </c:pt>
                <c:pt idx="22">
                  <c:v>0.4015627</c:v>
                </c:pt>
                <c:pt idx="23">
                  <c:v>0.4033542</c:v>
                </c:pt>
                <c:pt idx="24">
                  <c:v>0.35190705</c:v>
                </c:pt>
                <c:pt idx="25">
                  <c:v>0.62386565</c:v>
                </c:pt>
                <c:pt idx="26">
                  <c:v>0.6397391</c:v>
                </c:pt>
                <c:pt idx="27">
                  <c:v>0.5732053</c:v>
                </c:pt>
                <c:pt idx="28">
                  <c:v>0.43915665</c:v>
                </c:pt>
                <c:pt idx="29">
                  <c:v>0.4238852</c:v>
                </c:pt>
                <c:pt idx="30">
                  <c:v>0.3980941</c:v>
                </c:pt>
                <c:pt idx="31">
                  <c:v>0.40521455</c:v>
                </c:pt>
                <c:pt idx="32">
                  <c:v>0.3393807</c:v>
                </c:pt>
                <c:pt idx="33">
                  <c:v>0.28972435</c:v>
                </c:pt>
                <c:pt idx="34">
                  <c:v>0.4403871</c:v>
                </c:pt>
                <c:pt idx="35">
                  <c:v>0.43247385</c:v>
                </c:pt>
                <c:pt idx="36">
                  <c:v>0.3589856</c:v>
                </c:pt>
                <c:pt idx="37">
                  <c:v>0.4874707</c:v>
                </c:pt>
                <c:pt idx="38">
                  <c:v>0.28018495</c:v>
                </c:pt>
                <c:pt idx="39">
                  <c:v>0.2016913</c:v>
                </c:pt>
                <c:pt idx="40">
                  <c:v>0.38851615</c:v>
                </c:pt>
                <c:pt idx="41">
                  <c:v>0.3488313</c:v>
                </c:pt>
                <c:pt idx="42">
                  <c:v>0.3905295</c:v>
                </c:pt>
                <c:pt idx="43">
                  <c:v>0.3812152</c:v>
                </c:pt>
                <c:pt idx="44">
                  <c:v>0.45380415</c:v>
                </c:pt>
                <c:pt idx="45">
                  <c:v>0.4156635</c:v>
                </c:pt>
                <c:pt idx="46">
                  <c:v>0.3897521</c:v>
                </c:pt>
                <c:pt idx="47">
                  <c:v>0.37294135</c:v>
                </c:pt>
                <c:pt idx="48">
                  <c:v>0.5674893</c:v>
                </c:pt>
                <c:pt idx="49">
                  <c:v>0.3427177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140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G$141:$G$190</c:f>
              <c:numCache>
                <c:formatCode>General</c:formatCode>
                <c:ptCount val="50"/>
                <c:pt idx="0">
                  <c:v>0.4708635</c:v>
                </c:pt>
                <c:pt idx="1">
                  <c:v>0.33418085</c:v>
                </c:pt>
                <c:pt idx="2">
                  <c:v>0.4947704</c:v>
                </c:pt>
                <c:pt idx="3">
                  <c:v>0.50762335</c:v>
                </c:pt>
                <c:pt idx="4">
                  <c:v>0.3583096</c:v>
                </c:pt>
                <c:pt idx="5">
                  <c:v>0.32850485</c:v>
                </c:pt>
                <c:pt idx="6">
                  <c:v>0.3607671</c:v>
                </c:pt>
                <c:pt idx="7">
                  <c:v>0.44057645</c:v>
                </c:pt>
                <c:pt idx="8">
                  <c:v>0.47811505</c:v>
                </c:pt>
                <c:pt idx="9">
                  <c:v>0.46164325</c:v>
                </c:pt>
                <c:pt idx="10">
                  <c:v>0.3644854</c:v>
                </c:pt>
                <c:pt idx="11">
                  <c:v>0.4636111</c:v>
                </c:pt>
                <c:pt idx="12">
                  <c:v>0.43392475</c:v>
                </c:pt>
                <c:pt idx="13">
                  <c:v>0.53599695</c:v>
                </c:pt>
                <c:pt idx="14">
                  <c:v>0.42272035</c:v>
                </c:pt>
                <c:pt idx="15">
                  <c:v>0.45429865</c:v>
                </c:pt>
                <c:pt idx="16">
                  <c:v>0.4665182</c:v>
                </c:pt>
                <c:pt idx="17">
                  <c:v>0.44758445</c:v>
                </c:pt>
                <c:pt idx="18">
                  <c:v>0.48301955</c:v>
                </c:pt>
                <c:pt idx="19">
                  <c:v>0.43556025</c:v>
                </c:pt>
                <c:pt idx="20">
                  <c:v>0.2960935</c:v>
                </c:pt>
                <c:pt idx="21">
                  <c:v>0.3525665</c:v>
                </c:pt>
                <c:pt idx="22">
                  <c:v>0.4953901</c:v>
                </c:pt>
                <c:pt idx="23">
                  <c:v>0.4560626</c:v>
                </c:pt>
                <c:pt idx="24">
                  <c:v>0.39332695</c:v>
                </c:pt>
                <c:pt idx="25">
                  <c:v>0.58339</c:v>
                </c:pt>
                <c:pt idx="26">
                  <c:v>0.5767245</c:v>
                </c:pt>
                <c:pt idx="27">
                  <c:v>0.54713595</c:v>
                </c:pt>
                <c:pt idx="28">
                  <c:v>0.4670027</c:v>
                </c:pt>
                <c:pt idx="29">
                  <c:v>0.35688195</c:v>
                </c:pt>
                <c:pt idx="30">
                  <c:v>0.30248345</c:v>
                </c:pt>
                <c:pt idx="31">
                  <c:v>0.408264</c:v>
                </c:pt>
                <c:pt idx="32">
                  <c:v>0.3580765</c:v>
                </c:pt>
                <c:pt idx="33">
                  <c:v>0.30804005</c:v>
                </c:pt>
                <c:pt idx="34">
                  <c:v>0.35359295</c:v>
                </c:pt>
                <c:pt idx="35">
                  <c:v>0.3969699</c:v>
                </c:pt>
                <c:pt idx="36">
                  <c:v>0.34475815</c:v>
                </c:pt>
                <c:pt idx="37">
                  <c:v>0.4710255</c:v>
                </c:pt>
                <c:pt idx="38">
                  <c:v>0.2863104</c:v>
                </c:pt>
                <c:pt idx="39">
                  <c:v>0.27151445</c:v>
                </c:pt>
                <c:pt idx="40">
                  <c:v>0.36093</c:v>
                </c:pt>
                <c:pt idx="41">
                  <c:v>0.3235278</c:v>
                </c:pt>
                <c:pt idx="42">
                  <c:v>0.40246</c:v>
                </c:pt>
                <c:pt idx="43">
                  <c:v>0.3651948</c:v>
                </c:pt>
                <c:pt idx="44">
                  <c:v>0.3950307</c:v>
                </c:pt>
                <c:pt idx="45">
                  <c:v>0.3617001</c:v>
                </c:pt>
                <c:pt idx="46">
                  <c:v>0.357377</c:v>
                </c:pt>
                <c:pt idx="47">
                  <c:v>0.3374245</c:v>
                </c:pt>
                <c:pt idx="48">
                  <c:v>0.58530775</c:v>
                </c:pt>
                <c:pt idx="49">
                  <c:v>0.343570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140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H$141:$H$190</c:f>
              <c:numCache>
                <c:formatCode>General</c:formatCode>
                <c:ptCount val="50"/>
                <c:pt idx="0">
                  <c:v>0.396041</c:v>
                </c:pt>
                <c:pt idx="1">
                  <c:v>0.29691615</c:v>
                </c:pt>
                <c:pt idx="2">
                  <c:v>0.4976166</c:v>
                </c:pt>
                <c:pt idx="3">
                  <c:v>0.4154026</c:v>
                </c:pt>
                <c:pt idx="4">
                  <c:v>0.27899705</c:v>
                </c:pt>
                <c:pt idx="5">
                  <c:v>0.3745987</c:v>
                </c:pt>
                <c:pt idx="6">
                  <c:v>0.3007958</c:v>
                </c:pt>
                <c:pt idx="7">
                  <c:v>0.3158752</c:v>
                </c:pt>
                <c:pt idx="8">
                  <c:v>0.4104697</c:v>
                </c:pt>
                <c:pt idx="9">
                  <c:v>0.4471022</c:v>
                </c:pt>
                <c:pt idx="10">
                  <c:v>0.33619565</c:v>
                </c:pt>
                <c:pt idx="11">
                  <c:v>0.4482004</c:v>
                </c:pt>
                <c:pt idx="12">
                  <c:v>0.41021275</c:v>
                </c:pt>
                <c:pt idx="13">
                  <c:v>0.5482415</c:v>
                </c:pt>
                <c:pt idx="14">
                  <c:v>0.42232935</c:v>
                </c:pt>
                <c:pt idx="15">
                  <c:v>0.47013385</c:v>
                </c:pt>
                <c:pt idx="16">
                  <c:v>0.4473333</c:v>
                </c:pt>
                <c:pt idx="17">
                  <c:v>0.45505235</c:v>
                </c:pt>
                <c:pt idx="18">
                  <c:v>0.46570595</c:v>
                </c:pt>
                <c:pt idx="19">
                  <c:v>0.38025555</c:v>
                </c:pt>
                <c:pt idx="20">
                  <c:v>0.34225545</c:v>
                </c:pt>
                <c:pt idx="21">
                  <c:v>0.36514855</c:v>
                </c:pt>
                <c:pt idx="22">
                  <c:v>0.42942215</c:v>
                </c:pt>
                <c:pt idx="23">
                  <c:v>0.41860985</c:v>
                </c:pt>
                <c:pt idx="24">
                  <c:v>0.3819335</c:v>
                </c:pt>
                <c:pt idx="25">
                  <c:v>0.60437505</c:v>
                </c:pt>
                <c:pt idx="26">
                  <c:v>0.61308575</c:v>
                </c:pt>
                <c:pt idx="27">
                  <c:v>0.60347985</c:v>
                </c:pt>
                <c:pt idx="28">
                  <c:v>0.43150425</c:v>
                </c:pt>
                <c:pt idx="29">
                  <c:v>0.385576</c:v>
                </c:pt>
                <c:pt idx="30">
                  <c:v>0.35848</c:v>
                </c:pt>
                <c:pt idx="31">
                  <c:v>0.4312719</c:v>
                </c:pt>
                <c:pt idx="32">
                  <c:v>0.36737435</c:v>
                </c:pt>
                <c:pt idx="33">
                  <c:v>0.29114165</c:v>
                </c:pt>
                <c:pt idx="34">
                  <c:v>0.37433275</c:v>
                </c:pt>
                <c:pt idx="35">
                  <c:v>0.42722715</c:v>
                </c:pt>
                <c:pt idx="36">
                  <c:v>0.33813105</c:v>
                </c:pt>
                <c:pt idx="37">
                  <c:v>0.45827065</c:v>
                </c:pt>
                <c:pt idx="38">
                  <c:v>0.29643</c:v>
                </c:pt>
                <c:pt idx="39">
                  <c:v>0.29031</c:v>
                </c:pt>
                <c:pt idx="40">
                  <c:v>0.37842465</c:v>
                </c:pt>
                <c:pt idx="41">
                  <c:v>0.3734487</c:v>
                </c:pt>
                <c:pt idx="42">
                  <c:v>0.36575505</c:v>
                </c:pt>
                <c:pt idx="43">
                  <c:v>0.30647365</c:v>
                </c:pt>
                <c:pt idx="44">
                  <c:v>0.18857965</c:v>
                </c:pt>
                <c:pt idx="45">
                  <c:v>0.38968725</c:v>
                </c:pt>
                <c:pt idx="46">
                  <c:v>0.348537</c:v>
                </c:pt>
                <c:pt idx="47">
                  <c:v>0.36567795</c:v>
                </c:pt>
                <c:pt idx="48">
                  <c:v>0.42020145</c:v>
                </c:pt>
                <c:pt idx="49">
                  <c:v>0.3884223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140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I$141:$I$190</c:f>
              <c:numCache>
                <c:formatCode>General</c:formatCode>
                <c:ptCount val="50"/>
                <c:pt idx="0">
                  <c:v>0.4347154</c:v>
                </c:pt>
                <c:pt idx="1">
                  <c:v>0.3534162</c:v>
                </c:pt>
                <c:pt idx="2">
                  <c:v>0.4854339</c:v>
                </c:pt>
                <c:pt idx="3">
                  <c:v>0.4194143</c:v>
                </c:pt>
                <c:pt idx="4">
                  <c:v>0.27678625</c:v>
                </c:pt>
                <c:pt idx="5">
                  <c:v>0.36548645</c:v>
                </c:pt>
                <c:pt idx="6">
                  <c:v>0.3245288</c:v>
                </c:pt>
                <c:pt idx="7">
                  <c:v>0.3306837</c:v>
                </c:pt>
                <c:pt idx="8">
                  <c:v>0.3787548</c:v>
                </c:pt>
                <c:pt idx="9">
                  <c:v>0.4037841</c:v>
                </c:pt>
                <c:pt idx="10">
                  <c:v>0.32791005</c:v>
                </c:pt>
                <c:pt idx="11">
                  <c:v>0.4274478</c:v>
                </c:pt>
                <c:pt idx="12">
                  <c:v>0.340134</c:v>
                </c:pt>
                <c:pt idx="13">
                  <c:v>0.5490877</c:v>
                </c:pt>
                <c:pt idx="14">
                  <c:v>0.39583375</c:v>
                </c:pt>
                <c:pt idx="15">
                  <c:v>0.4322808</c:v>
                </c:pt>
                <c:pt idx="16">
                  <c:v>0.41760715</c:v>
                </c:pt>
                <c:pt idx="17">
                  <c:v>0.42149985</c:v>
                </c:pt>
                <c:pt idx="18">
                  <c:v>0.4190053</c:v>
                </c:pt>
                <c:pt idx="19">
                  <c:v>0.3679699</c:v>
                </c:pt>
                <c:pt idx="20">
                  <c:v>0.32440995</c:v>
                </c:pt>
                <c:pt idx="21">
                  <c:v>0.37567245</c:v>
                </c:pt>
                <c:pt idx="22">
                  <c:v>0.41041345</c:v>
                </c:pt>
                <c:pt idx="23">
                  <c:v>0.3906962</c:v>
                </c:pt>
                <c:pt idx="24">
                  <c:v>0.3537062</c:v>
                </c:pt>
                <c:pt idx="25">
                  <c:v>0.5710392</c:v>
                </c:pt>
                <c:pt idx="26">
                  <c:v>0.6434316</c:v>
                </c:pt>
                <c:pt idx="27">
                  <c:v>0.56838735</c:v>
                </c:pt>
                <c:pt idx="28">
                  <c:v>0.50624125</c:v>
                </c:pt>
                <c:pt idx="29">
                  <c:v>0.3886879</c:v>
                </c:pt>
                <c:pt idx="30">
                  <c:v>0.2992828</c:v>
                </c:pt>
                <c:pt idx="31">
                  <c:v>0.37643155</c:v>
                </c:pt>
                <c:pt idx="32">
                  <c:v>0.37423085</c:v>
                </c:pt>
                <c:pt idx="33">
                  <c:v>0.3184738</c:v>
                </c:pt>
                <c:pt idx="34">
                  <c:v>0.37093675</c:v>
                </c:pt>
                <c:pt idx="35">
                  <c:v>0.41416865</c:v>
                </c:pt>
                <c:pt idx="36">
                  <c:v>0.33473785</c:v>
                </c:pt>
                <c:pt idx="37">
                  <c:v>0.4731262</c:v>
                </c:pt>
                <c:pt idx="38">
                  <c:v>0.27687335</c:v>
                </c:pt>
                <c:pt idx="39">
                  <c:v>0.2041075</c:v>
                </c:pt>
                <c:pt idx="40">
                  <c:v>0.4587893</c:v>
                </c:pt>
                <c:pt idx="41">
                  <c:v>0.3524188</c:v>
                </c:pt>
                <c:pt idx="42">
                  <c:v>0.4018979</c:v>
                </c:pt>
                <c:pt idx="43">
                  <c:v>0.3401487</c:v>
                </c:pt>
                <c:pt idx="44">
                  <c:v>0.20530415</c:v>
                </c:pt>
                <c:pt idx="45">
                  <c:v>0.38311775</c:v>
                </c:pt>
                <c:pt idx="46">
                  <c:v>0.3834829</c:v>
                </c:pt>
                <c:pt idx="47">
                  <c:v>0.3310361</c:v>
                </c:pt>
                <c:pt idx="48">
                  <c:v>0.4468751</c:v>
                </c:pt>
                <c:pt idx="49">
                  <c:v>0.4274351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140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J$141:$J$190</c:f>
              <c:numCache>
                <c:formatCode>General</c:formatCode>
                <c:ptCount val="50"/>
                <c:pt idx="0">
                  <c:v>0.41430715</c:v>
                </c:pt>
                <c:pt idx="1">
                  <c:v>0.3027592</c:v>
                </c:pt>
                <c:pt idx="2">
                  <c:v>0.43684805</c:v>
                </c:pt>
                <c:pt idx="3">
                  <c:v>0.45362895</c:v>
                </c:pt>
                <c:pt idx="4">
                  <c:v>0.28902905</c:v>
                </c:pt>
                <c:pt idx="5">
                  <c:v>0.3463685</c:v>
                </c:pt>
                <c:pt idx="6">
                  <c:v>0.3510812</c:v>
                </c:pt>
                <c:pt idx="7">
                  <c:v>0.385902</c:v>
                </c:pt>
                <c:pt idx="8">
                  <c:v>0.433116</c:v>
                </c:pt>
                <c:pt idx="9">
                  <c:v>0.45238795</c:v>
                </c:pt>
                <c:pt idx="10">
                  <c:v>0.3374905</c:v>
                </c:pt>
                <c:pt idx="11">
                  <c:v>0.4617564</c:v>
                </c:pt>
                <c:pt idx="12">
                  <c:v>0.41566955</c:v>
                </c:pt>
                <c:pt idx="13">
                  <c:v>0.54720425</c:v>
                </c:pt>
                <c:pt idx="14">
                  <c:v>0.44436595</c:v>
                </c:pt>
                <c:pt idx="15">
                  <c:v>0.4831091</c:v>
                </c:pt>
                <c:pt idx="16">
                  <c:v>0.4530176</c:v>
                </c:pt>
                <c:pt idx="17">
                  <c:v>0.4521753</c:v>
                </c:pt>
                <c:pt idx="18">
                  <c:v>0.4522545</c:v>
                </c:pt>
                <c:pt idx="19">
                  <c:v>0.37118725</c:v>
                </c:pt>
                <c:pt idx="20">
                  <c:v>0.30959645</c:v>
                </c:pt>
                <c:pt idx="21">
                  <c:v>0.35551185</c:v>
                </c:pt>
                <c:pt idx="22">
                  <c:v>0.4350628</c:v>
                </c:pt>
                <c:pt idx="23">
                  <c:v>0.40807465</c:v>
                </c:pt>
                <c:pt idx="24">
                  <c:v>0.37091715</c:v>
                </c:pt>
                <c:pt idx="25">
                  <c:v>0.61167595</c:v>
                </c:pt>
                <c:pt idx="26">
                  <c:v>0.66620635</c:v>
                </c:pt>
                <c:pt idx="27">
                  <c:v>0.66535275</c:v>
                </c:pt>
                <c:pt idx="28">
                  <c:v>0.47171875</c:v>
                </c:pt>
                <c:pt idx="29">
                  <c:v>0.41083605</c:v>
                </c:pt>
                <c:pt idx="30">
                  <c:v>0.36690185</c:v>
                </c:pt>
                <c:pt idx="31">
                  <c:v>0.39666435</c:v>
                </c:pt>
                <c:pt idx="32">
                  <c:v>0.3482295</c:v>
                </c:pt>
                <c:pt idx="33">
                  <c:v>0.2559933</c:v>
                </c:pt>
                <c:pt idx="34">
                  <c:v>0.4066876</c:v>
                </c:pt>
                <c:pt idx="35">
                  <c:v>0.40642925</c:v>
                </c:pt>
                <c:pt idx="36">
                  <c:v>0.3439081</c:v>
                </c:pt>
                <c:pt idx="37">
                  <c:v>0.48107255</c:v>
                </c:pt>
                <c:pt idx="38">
                  <c:v>0.2453281</c:v>
                </c:pt>
                <c:pt idx="39">
                  <c:v>0.23088305</c:v>
                </c:pt>
                <c:pt idx="40">
                  <c:v>0.4478109</c:v>
                </c:pt>
                <c:pt idx="41">
                  <c:v>0.34018695</c:v>
                </c:pt>
                <c:pt idx="42">
                  <c:v>0.4036334</c:v>
                </c:pt>
                <c:pt idx="43">
                  <c:v>0.4531743</c:v>
                </c:pt>
                <c:pt idx="44">
                  <c:v>0.39123815</c:v>
                </c:pt>
                <c:pt idx="45">
                  <c:v>0.3876242</c:v>
                </c:pt>
                <c:pt idx="46">
                  <c:v>0.3669786</c:v>
                </c:pt>
                <c:pt idx="47">
                  <c:v>0.3658327</c:v>
                </c:pt>
                <c:pt idx="48">
                  <c:v>0.55904805</c:v>
                </c:pt>
                <c:pt idx="49">
                  <c:v>0.3890858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140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K$141:$K$190</c:f>
              <c:numCache>
                <c:formatCode>General</c:formatCode>
                <c:ptCount val="50"/>
                <c:pt idx="0">
                  <c:v>0.41076605</c:v>
                </c:pt>
                <c:pt idx="1">
                  <c:v>0.3817179</c:v>
                </c:pt>
                <c:pt idx="2">
                  <c:v>0.436895</c:v>
                </c:pt>
                <c:pt idx="3">
                  <c:v>0.49977085</c:v>
                </c:pt>
                <c:pt idx="4">
                  <c:v>0.30120485</c:v>
                </c:pt>
                <c:pt idx="5">
                  <c:v>0.3555716</c:v>
                </c:pt>
                <c:pt idx="6">
                  <c:v>0.3363349</c:v>
                </c:pt>
                <c:pt idx="7">
                  <c:v>0.3616853</c:v>
                </c:pt>
                <c:pt idx="8">
                  <c:v>0.41576385</c:v>
                </c:pt>
                <c:pt idx="9">
                  <c:v>0.43628245</c:v>
                </c:pt>
                <c:pt idx="10">
                  <c:v>0.3365356</c:v>
                </c:pt>
                <c:pt idx="11">
                  <c:v>0.45725525</c:v>
                </c:pt>
                <c:pt idx="12">
                  <c:v>0.40649635</c:v>
                </c:pt>
                <c:pt idx="13">
                  <c:v>0.54692885</c:v>
                </c:pt>
                <c:pt idx="14">
                  <c:v>0.4209316</c:v>
                </c:pt>
                <c:pt idx="15">
                  <c:v>0.4505598</c:v>
                </c:pt>
                <c:pt idx="16">
                  <c:v>0.44270855</c:v>
                </c:pt>
                <c:pt idx="17">
                  <c:v>0.4313096</c:v>
                </c:pt>
                <c:pt idx="18">
                  <c:v>0.44624075</c:v>
                </c:pt>
                <c:pt idx="19">
                  <c:v>0.3834876</c:v>
                </c:pt>
                <c:pt idx="20">
                  <c:v>0.3182669</c:v>
                </c:pt>
                <c:pt idx="21">
                  <c:v>0.37850305</c:v>
                </c:pt>
                <c:pt idx="22">
                  <c:v>0.38963805</c:v>
                </c:pt>
                <c:pt idx="23">
                  <c:v>0.3986583</c:v>
                </c:pt>
                <c:pt idx="24">
                  <c:v>0.3418394</c:v>
                </c:pt>
                <c:pt idx="25">
                  <c:v>0.6303099</c:v>
                </c:pt>
                <c:pt idx="26">
                  <c:v>0.70872325</c:v>
                </c:pt>
                <c:pt idx="27">
                  <c:v>0.7108187</c:v>
                </c:pt>
                <c:pt idx="28">
                  <c:v>0.45953165</c:v>
                </c:pt>
                <c:pt idx="29">
                  <c:v>0.3718692</c:v>
                </c:pt>
                <c:pt idx="30">
                  <c:v>0.31644</c:v>
                </c:pt>
                <c:pt idx="31">
                  <c:v>0.37132145</c:v>
                </c:pt>
                <c:pt idx="32">
                  <c:v>0.3466959</c:v>
                </c:pt>
                <c:pt idx="33">
                  <c:v>0.2950187</c:v>
                </c:pt>
                <c:pt idx="34">
                  <c:v>0.3759944</c:v>
                </c:pt>
                <c:pt idx="35">
                  <c:v>0.3989471</c:v>
                </c:pt>
                <c:pt idx="36">
                  <c:v>0.34584815</c:v>
                </c:pt>
                <c:pt idx="37">
                  <c:v>0.46395545</c:v>
                </c:pt>
                <c:pt idx="38">
                  <c:v>0.2391529</c:v>
                </c:pt>
                <c:pt idx="39">
                  <c:v>0.2055571</c:v>
                </c:pt>
                <c:pt idx="40">
                  <c:v>0.4237766</c:v>
                </c:pt>
                <c:pt idx="41">
                  <c:v>0.34605225</c:v>
                </c:pt>
                <c:pt idx="42">
                  <c:v>0.3485516</c:v>
                </c:pt>
                <c:pt idx="43">
                  <c:v>0.41339775</c:v>
                </c:pt>
                <c:pt idx="44">
                  <c:v>0.37583495</c:v>
                </c:pt>
                <c:pt idx="45">
                  <c:v>0.3527015</c:v>
                </c:pt>
                <c:pt idx="46">
                  <c:v>0.3749677</c:v>
                </c:pt>
                <c:pt idx="47">
                  <c:v>0.3170835</c:v>
                </c:pt>
                <c:pt idx="48">
                  <c:v>0.5918394</c:v>
                </c:pt>
                <c:pt idx="49">
                  <c:v>0.3682294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140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L$141:$L$190</c:f>
              <c:numCache>
                <c:formatCode>General</c:formatCode>
                <c:ptCount val="50"/>
                <c:pt idx="0">
                  <c:v>0.4277646</c:v>
                </c:pt>
                <c:pt idx="1">
                  <c:v>0.3439418</c:v>
                </c:pt>
                <c:pt idx="2">
                  <c:v>0.43571675</c:v>
                </c:pt>
                <c:pt idx="3">
                  <c:v>0.44313935</c:v>
                </c:pt>
                <c:pt idx="4">
                  <c:v>0.34933005</c:v>
                </c:pt>
                <c:pt idx="5">
                  <c:v>0.37990195</c:v>
                </c:pt>
                <c:pt idx="6">
                  <c:v>0.3226767</c:v>
                </c:pt>
                <c:pt idx="7">
                  <c:v>0.3032341</c:v>
                </c:pt>
                <c:pt idx="8">
                  <c:v>0.3656726</c:v>
                </c:pt>
                <c:pt idx="9">
                  <c:v>0.4631872</c:v>
                </c:pt>
                <c:pt idx="10">
                  <c:v>0.36156135</c:v>
                </c:pt>
                <c:pt idx="11">
                  <c:v>0.4651273</c:v>
                </c:pt>
                <c:pt idx="12">
                  <c:v>0.39328525</c:v>
                </c:pt>
                <c:pt idx="13">
                  <c:v>0.5299511</c:v>
                </c:pt>
                <c:pt idx="14">
                  <c:v>0.42114915</c:v>
                </c:pt>
                <c:pt idx="15">
                  <c:v>0.4906663</c:v>
                </c:pt>
                <c:pt idx="16">
                  <c:v>0.44558115</c:v>
                </c:pt>
                <c:pt idx="17">
                  <c:v>0.42889245</c:v>
                </c:pt>
                <c:pt idx="18">
                  <c:v>0.46797115</c:v>
                </c:pt>
                <c:pt idx="19">
                  <c:v>0.3974936</c:v>
                </c:pt>
                <c:pt idx="20">
                  <c:v>0.3533659</c:v>
                </c:pt>
                <c:pt idx="21">
                  <c:v>0.4109922</c:v>
                </c:pt>
                <c:pt idx="22">
                  <c:v>0.4229872</c:v>
                </c:pt>
                <c:pt idx="23">
                  <c:v>0.4326462</c:v>
                </c:pt>
                <c:pt idx="24">
                  <c:v>0.37751595</c:v>
                </c:pt>
                <c:pt idx="25">
                  <c:v>0.61976725</c:v>
                </c:pt>
                <c:pt idx="26">
                  <c:v>0.64953995</c:v>
                </c:pt>
                <c:pt idx="27">
                  <c:v>0.59568185</c:v>
                </c:pt>
                <c:pt idx="28">
                  <c:v>0.4842421</c:v>
                </c:pt>
                <c:pt idx="29">
                  <c:v>0.42159645</c:v>
                </c:pt>
                <c:pt idx="30">
                  <c:v>0.35177655</c:v>
                </c:pt>
                <c:pt idx="31">
                  <c:v>0.4107108</c:v>
                </c:pt>
                <c:pt idx="32">
                  <c:v>0.40652655</c:v>
                </c:pt>
                <c:pt idx="33">
                  <c:v>0.33566645</c:v>
                </c:pt>
                <c:pt idx="34">
                  <c:v>0.4135137</c:v>
                </c:pt>
                <c:pt idx="35">
                  <c:v>0.444685</c:v>
                </c:pt>
                <c:pt idx="36">
                  <c:v>0.37045435</c:v>
                </c:pt>
                <c:pt idx="37">
                  <c:v>0.4772836</c:v>
                </c:pt>
                <c:pt idx="38">
                  <c:v>0.33133315</c:v>
                </c:pt>
                <c:pt idx="39">
                  <c:v>0.27557475</c:v>
                </c:pt>
                <c:pt idx="40">
                  <c:v>0.3756862</c:v>
                </c:pt>
                <c:pt idx="41">
                  <c:v>0.3246201</c:v>
                </c:pt>
                <c:pt idx="42">
                  <c:v>0.40322895</c:v>
                </c:pt>
                <c:pt idx="43">
                  <c:v>0.4015541</c:v>
                </c:pt>
                <c:pt idx="44">
                  <c:v>0.1828894</c:v>
                </c:pt>
                <c:pt idx="45">
                  <c:v>0.40047075</c:v>
                </c:pt>
                <c:pt idx="46">
                  <c:v>0.39334915</c:v>
                </c:pt>
                <c:pt idx="47">
                  <c:v>0.30016035</c:v>
                </c:pt>
                <c:pt idx="48">
                  <c:v>0.43506405</c:v>
                </c:pt>
                <c:pt idx="49">
                  <c:v>0.3880031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140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M$141:$M$190</c:f>
              <c:numCache>
                <c:formatCode>General</c:formatCode>
                <c:ptCount val="50"/>
                <c:pt idx="0">
                  <c:v>0.4911435</c:v>
                </c:pt>
                <c:pt idx="1">
                  <c:v>0.3253827</c:v>
                </c:pt>
                <c:pt idx="2">
                  <c:v>0.41939135</c:v>
                </c:pt>
                <c:pt idx="3">
                  <c:v>0.38239445</c:v>
                </c:pt>
                <c:pt idx="4">
                  <c:v>0.2855401</c:v>
                </c:pt>
                <c:pt idx="5">
                  <c:v>0.35538925</c:v>
                </c:pt>
                <c:pt idx="6">
                  <c:v>0.3152795</c:v>
                </c:pt>
                <c:pt idx="7">
                  <c:v>0.2899686</c:v>
                </c:pt>
                <c:pt idx="8">
                  <c:v>0.38410265</c:v>
                </c:pt>
                <c:pt idx="9">
                  <c:v>0.45521695</c:v>
                </c:pt>
                <c:pt idx="10">
                  <c:v>0.3365683</c:v>
                </c:pt>
                <c:pt idx="11">
                  <c:v>0.44178095</c:v>
                </c:pt>
                <c:pt idx="12">
                  <c:v>0.38167925</c:v>
                </c:pt>
                <c:pt idx="13">
                  <c:v>0.5335694</c:v>
                </c:pt>
                <c:pt idx="14">
                  <c:v>0.41184075</c:v>
                </c:pt>
                <c:pt idx="15">
                  <c:v>0.48004885</c:v>
                </c:pt>
                <c:pt idx="16">
                  <c:v>0.42417</c:v>
                </c:pt>
                <c:pt idx="17">
                  <c:v>0.41995775</c:v>
                </c:pt>
                <c:pt idx="18">
                  <c:v>0.47737955</c:v>
                </c:pt>
                <c:pt idx="19">
                  <c:v>0.402839</c:v>
                </c:pt>
                <c:pt idx="20">
                  <c:v>0.3204484</c:v>
                </c:pt>
                <c:pt idx="21">
                  <c:v>0.38378755</c:v>
                </c:pt>
                <c:pt idx="22">
                  <c:v>0.4834732</c:v>
                </c:pt>
                <c:pt idx="23">
                  <c:v>0.4747959</c:v>
                </c:pt>
                <c:pt idx="24">
                  <c:v>0.39939565</c:v>
                </c:pt>
                <c:pt idx="25">
                  <c:v>0.64971175</c:v>
                </c:pt>
                <c:pt idx="26">
                  <c:v>0.6133118</c:v>
                </c:pt>
                <c:pt idx="27">
                  <c:v>0.6444343</c:v>
                </c:pt>
                <c:pt idx="28">
                  <c:v>0.5128483</c:v>
                </c:pt>
                <c:pt idx="29">
                  <c:v>0.44433025</c:v>
                </c:pt>
                <c:pt idx="30">
                  <c:v>0.38143035</c:v>
                </c:pt>
                <c:pt idx="31">
                  <c:v>0.42943195</c:v>
                </c:pt>
                <c:pt idx="32">
                  <c:v>0.3866089</c:v>
                </c:pt>
                <c:pt idx="33">
                  <c:v>0.33901275</c:v>
                </c:pt>
                <c:pt idx="34">
                  <c:v>0.4227269</c:v>
                </c:pt>
                <c:pt idx="35">
                  <c:v>0.45468125</c:v>
                </c:pt>
                <c:pt idx="36">
                  <c:v>0.35867135</c:v>
                </c:pt>
                <c:pt idx="37">
                  <c:v>0.49289765</c:v>
                </c:pt>
                <c:pt idx="38">
                  <c:v>0.30305945</c:v>
                </c:pt>
                <c:pt idx="39">
                  <c:v>0.2916668</c:v>
                </c:pt>
                <c:pt idx="40">
                  <c:v>0.39040885</c:v>
                </c:pt>
                <c:pt idx="41">
                  <c:v>0.3179808</c:v>
                </c:pt>
                <c:pt idx="42">
                  <c:v>0.43005315</c:v>
                </c:pt>
                <c:pt idx="43">
                  <c:v>0.37922645</c:v>
                </c:pt>
                <c:pt idx="44">
                  <c:v>0.1939669</c:v>
                </c:pt>
                <c:pt idx="45">
                  <c:v>0.39877095</c:v>
                </c:pt>
                <c:pt idx="46">
                  <c:v>0.3721922</c:v>
                </c:pt>
                <c:pt idx="47">
                  <c:v>0.34834615</c:v>
                </c:pt>
                <c:pt idx="48">
                  <c:v>0.47014</c:v>
                </c:pt>
                <c:pt idx="49">
                  <c:v>0.3986793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140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N$141:$N$190</c:f>
              <c:numCache>
                <c:formatCode>General</c:formatCode>
                <c:ptCount val="50"/>
                <c:pt idx="0">
                  <c:v>0.4056785</c:v>
                </c:pt>
                <c:pt idx="1">
                  <c:v>0.28926475</c:v>
                </c:pt>
                <c:pt idx="2">
                  <c:v>0.44528945</c:v>
                </c:pt>
                <c:pt idx="3">
                  <c:v>0.34509595</c:v>
                </c:pt>
                <c:pt idx="4">
                  <c:v>0.28905615</c:v>
                </c:pt>
                <c:pt idx="5">
                  <c:v>0.342828</c:v>
                </c:pt>
                <c:pt idx="6">
                  <c:v>0.30168415</c:v>
                </c:pt>
                <c:pt idx="7">
                  <c:v>0.31478475</c:v>
                </c:pt>
                <c:pt idx="8">
                  <c:v>0.3821927</c:v>
                </c:pt>
                <c:pt idx="9">
                  <c:v>0.41997405</c:v>
                </c:pt>
                <c:pt idx="10">
                  <c:v>0.31915055</c:v>
                </c:pt>
                <c:pt idx="11">
                  <c:v>0.44058515</c:v>
                </c:pt>
                <c:pt idx="12">
                  <c:v>0.3982552</c:v>
                </c:pt>
                <c:pt idx="13">
                  <c:v>0.5169391</c:v>
                </c:pt>
                <c:pt idx="14">
                  <c:v>0.3951084</c:v>
                </c:pt>
                <c:pt idx="15">
                  <c:v>0.45705345</c:v>
                </c:pt>
                <c:pt idx="16">
                  <c:v>0.3970089</c:v>
                </c:pt>
                <c:pt idx="17">
                  <c:v>0.40380765</c:v>
                </c:pt>
                <c:pt idx="18">
                  <c:v>0.390953</c:v>
                </c:pt>
                <c:pt idx="19">
                  <c:v>0.34074115</c:v>
                </c:pt>
                <c:pt idx="20">
                  <c:v>0.3046684</c:v>
                </c:pt>
                <c:pt idx="21">
                  <c:v>0.33324465</c:v>
                </c:pt>
                <c:pt idx="22">
                  <c:v>0.29221975</c:v>
                </c:pt>
                <c:pt idx="23">
                  <c:v>0.40235465</c:v>
                </c:pt>
                <c:pt idx="24">
                  <c:v>0.3108597</c:v>
                </c:pt>
                <c:pt idx="25">
                  <c:v>0.4393875</c:v>
                </c:pt>
                <c:pt idx="26">
                  <c:v>0.53268085</c:v>
                </c:pt>
                <c:pt idx="27">
                  <c:v>0.42761635</c:v>
                </c:pt>
                <c:pt idx="28">
                  <c:v>0.33105905</c:v>
                </c:pt>
                <c:pt idx="29">
                  <c:v>0.3335921</c:v>
                </c:pt>
                <c:pt idx="30">
                  <c:v>0.28926925</c:v>
                </c:pt>
                <c:pt idx="31">
                  <c:v>0.2729868</c:v>
                </c:pt>
                <c:pt idx="32">
                  <c:v>0.26172845</c:v>
                </c:pt>
                <c:pt idx="33">
                  <c:v>0.23268185</c:v>
                </c:pt>
                <c:pt idx="34">
                  <c:v>0.3423161</c:v>
                </c:pt>
                <c:pt idx="35">
                  <c:v>0.4206628</c:v>
                </c:pt>
                <c:pt idx="36">
                  <c:v>0.31726315</c:v>
                </c:pt>
                <c:pt idx="37">
                  <c:v>0.46186815</c:v>
                </c:pt>
                <c:pt idx="38">
                  <c:v>0.1394326</c:v>
                </c:pt>
                <c:pt idx="39">
                  <c:v>0.102914645</c:v>
                </c:pt>
                <c:pt idx="40">
                  <c:v>0.34718775</c:v>
                </c:pt>
                <c:pt idx="41">
                  <c:v>0.33676885</c:v>
                </c:pt>
                <c:pt idx="42">
                  <c:v>0.3668475</c:v>
                </c:pt>
                <c:pt idx="43">
                  <c:v>0.25112145</c:v>
                </c:pt>
                <c:pt idx="44">
                  <c:v>0.20805045</c:v>
                </c:pt>
                <c:pt idx="45">
                  <c:v>0.3996211</c:v>
                </c:pt>
                <c:pt idx="46">
                  <c:v>0.34443305</c:v>
                </c:pt>
                <c:pt idx="47">
                  <c:v>0.3427538</c:v>
                </c:pt>
                <c:pt idx="48">
                  <c:v>0.4296206</c:v>
                </c:pt>
                <c:pt idx="49">
                  <c:v>0.3514264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140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141:$E$190</c:f>
              <c:strCache>
                <c:ptCount val="50"/>
                <c:pt idx="0">
                  <c:v>cg11753499</c:v>
                </c:pt>
                <c:pt idx="1">
                  <c:v>cg13210239</c:v>
                </c:pt>
                <c:pt idx="2">
                  <c:v>cg17985533</c:v>
                </c:pt>
                <c:pt idx="3">
                  <c:v>cg15922305</c:v>
                </c:pt>
                <c:pt idx="4">
                  <c:v>cg25289899</c:v>
                </c:pt>
                <c:pt idx="5">
                  <c:v>cg25437674</c:v>
                </c:pt>
                <c:pt idx="6">
                  <c:v>cg17769238</c:v>
                </c:pt>
                <c:pt idx="7">
                  <c:v>cg04975775</c:v>
                </c:pt>
                <c:pt idx="8">
                  <c:v>cg15886040</c:v>
                </c:pt>
                <c:pt idx="9">
                  <c:v>cg10154633</c:v>
                </c:pt>
                <c:pt idx="10">
                  <c:v>cg26469586</c:v>
                </c:pt>
                <c:pt idx="11">
                  <c:v>cg24409677</c:v>
                </c:pt>
                <c:pt idx="12">
                  <c:v>cg16303279</c:v>
                </c:pt>
                <c:pt idx="13">
                  <c:v>cg02694715</c:v>
                </c:pt>
                <c:pt idx="14">
                  <c:v>cg11735853</c:v>
                </c:pt>
                <c:pt idx="15">
                  <c:v>cg01977486</c:v>
                </c:pt>
                <c:pt idx="16">
                  <c:v>cg25838645</c:v>
                </c:pt>
                <c:pt idx="17">
                  <c:v>cg13581483</c:v>
                </c:pt>
                <c:pt idx="18">
                  <c:v>cg04088212</c:v>
                </c:pt>
                <c:pt idx="19">
                  <c:v>cg01539474</c:v>
                </c:pt>
                <c:pt idx="20">
                  <c:v>cg18362496</c:v>
                </c:pt>
                <c:pt idx="21">
                  <c:v>cg24605090</c:v>
                </c:pt>
                <c:pt idx="22">
                  <c:v>cg04817190</c:v>
                </c:pt>
                <c:pt idx="23">
                  <c:v>cg06749854</c:v>
                </c:pt>
                <c:pt idx="24">
                  <c:v>cg24510613</c:v>
                </c:pt>
                <c:pt idx="25">
                  <c:v>cg16675558</c:v>
                </c:pt>
                <c:pt idx="26">
                  <c:v>cg03996735</c:v>
                </c:pt>
                <c:pt idx="27">
                  <c:v>cg18104242</c:v>
                </c:pt>
                <c:pt idx="28">
                  <c:v>cg27300742</c:v>
                </c:pt>
                <c:pt idx="29">
                  <c:v>cg25281616</c:v>
                </c:pt>
                <c:pt idx="30">
                  <c:v>cg01895612</c:v>
                </c:pt>
                <c:pt idx="31">
                  <c:v>cg23476401</c:v>
                </c:pt>
                <c:pt idx="32">
                  <c:v>cg00237904</c:v>
                </c:pt>
                <c:pt idx="33">
                  <c:v>cg06765785</c:v>
                </c:pt>
                <c:pt idx="34">
                  <c:v>cg25821896</c:v>
                </c:pt>
                <c:pt idx="35">
                  <c:v>cg25574978</c:v>
                </c:pt>
                <c:pt idx="36">
                  <c:v>cg18454954</c:v>
                </c:pt>
                <c:pt idx="37">
                  <c:v>cg25579157</c:v>
                </c:pt>
                <c:pt idx="38">
                  <c:v>cg02886509</c:v>
                </c:pt>
                <c:pt idx="39">
                  <c:v>cg02657360</c:v>
                </c:pt>
                <c:pt idx="40">
                  <c:v>cg27372170</c:v>
                </c:pt>
                <c:pt idx="41">
                  <c:v>cg22259242</c:v>
                </c:pt>
                <c:pt idx="42">
                  <c:v>cg19177307</c:v>
                </c:pt>
                <c:pt idx="43">
                  <c:v>cg01585333</c:v>
                </c:pt>
                <c:pt idx="44">
                  <c:v>cg06982169</c:v>
                </c:pt>
                <c:pt idx="45">
                  <c:v>cg16574793</c:v>
                </c:pt>
                <c:pt idx="46">
                  <c:v>cg09452478</c:v>
                </c:pt>
                <c:pt idx="47">
                  <c:v>cg02864690</c:v>
                </c:pt>
                <c:pt idx="48">
                  <c:v>cg20891060</c:v>
                </c:pt>
                <c:pt idx="49">
                  <c:v>cg19024989</c:v>
                </c:pt>
              </c:strCache>
            </c:strRef>
          </c:cat>
          <c:val>
            <c:numRef>
              <c:f>revise_data!$O$141:$O$190</c:f>
              <c:numCache>
                <c:formatCode>General</c:formatCode>
                <c:ptCount val="50"/>
                <c:pt idx="0">
                  <c:v>0.40625435</c:v>
                </c:pt>
                <c:pt idx="1">
                  <c:v>0.1817816</c:v>
                </c:pt>
                <c:pt idx="2">
                  <c:v>0.29338865</c:v>
                </c:pt>
                <c:pt idx="3">
                  <c:v>0.3359197</c:v>
                </c:pt>
                <c:pt idx="4">
                  <c:v>0.30664095</c:v>
                </c:pt>
                <c:pt idx="5">
                  <c:v>0.29979135</c:v>
                </c:pt>
                <c:pt idx="6">
                  <c:v>0.2728031</c:v>
                </c:pt>
                <c:pt idx="7">
                  <c:v>0.21683445</c:v>
                </c:pt>
                <c:pt idx="8">
                  <c:v>0.28564225</c:v>
                </c:pt>
                <c:pt idx="9">
                  <c:v>0.36414815</c:v>
                </c:pt>
                <c:pt idx="10">
                  <c:v>0.2897278</c:v>
                </c:pt>
                <c:pt idx="11">
                  <c:v>0.38467065</c:v>
                </c:pt>
                <c:pt idx="12">
                  <c:v>0.2778397</c:v>
                </c:pt>
                <c:pt idx="13">
                  <c:v>0.5147695</c:v>
                </c:pt>
                <c:pt idx="14">
                  <c:v>0.38772665</c:v>
                </c:pt>
                <c:pt idx="15">
                  <c:v>0.46272605</c:v>
                </c:pt>
                <c:pt idx="16">
                  <c:v>0.35966785</c:v>
                </c:pt>
                <c:pt idx="17">
                  <c:v>0.4143177</c:v>
                </c:pt>
                <c:pt idx="18">
                  <c:v>0.39280395</c:v>
                </c:pt>
                <c:pt idx="19">
                  <c:v>0.3852483</c:v>
                </c:pt>
                <c:pt idx="20">
                  <c:v>0.27811865</c:v>
                </c:pt>
                <c:pt idx="21">
                  <c:v>0.27898015</c:v>
                </c:pt>
                <c:pt idx="22">
                  <c:v>0.35191945</c:v>
                </c:pt>
                <c:pt idx="23">
                  <c:v>0.38554255</c:v>
                </c:pt>
                <c:pt idx="24">
                  <c:v>0.3391455</c:v>
                </c:pt>
                <c:pt idx="25">
                  <c:v>0.36823415</c:v>
                </c:pt>
                <c:pt idx="26">
                  <c:v>0.43030565</c:v>
                </c:pt>
                <c:pt idx="27">
                  <c:v>0.4250327</c:v>
                </c:pt>
                <c:pt idx="28">
                  <c:v>0.30320425</c:v>
                </c:pt>
                <c:pt idx="29">
                  <c:v>0.3096536</c:v>
                </c:pt>
                <c:pt idx="30">
                  <c:v>0.25725585</c:v>
                </c:pt>
                <c:pt idx="31">
                  <c:v>0.2246509</c:v>
                </c:pt>
                <c:pt idx="32">
                  <c:v>0.1968191</c:v>
                </c:pt>
                <c:pt idx="33">
                  <c:v>0.22759255</c:v>
                </c:pt>
                <c:pt idx="34">
                  <c:v>0.31420105</c:v>
                </c:pt>
                <c:pt idx="35">
                  <c:v>0.37446055</c:v>
                </c:pt>
                <c:pt idx="36">
                  <c:v>0.2926896</c:v>
                </c:pt>
                <c:pt idx="37">
                  <c:v>0.3988243</c:v>
                </c:pt>
                <c:pt idx="38">
                  <c:v>0.2026668</c:v>
                </c:pt>
                <c:pt idx="39">
                  <c:v>0.1874401</c:v>
                </c:pt>
                <c:pt idx="40">
                  <c:v>0.39841905</c:v>
                </c:pt>
                <c:pt idx="41">
                  <c:v>0.25659035</c:v>
                </c:pt>
                <c:pt idx="42">
                  <c:v>0.3844271</c:v>
                </c:pt>
                <c:pt idx="43">
                  <c:v>0.2936694</c:v>
                </c:pt>
                <c:pt idx="44">
                  <c:v>0.1547254</c:v>
                </c:pt>
                <c:pt idx="45">
                  <c:v>0.40479275</c:v>
                </c:pt>
                <c:pt idx="46">
                  <c:v>0.3621867</c:v>
                </c:pt>
                <c:pt idx="47">
                  <c:v>0.3451884</c:v>
                </c:pt>
                <c:pt idx="48">
                  <c:v>0.5179628</c:v>
                </c:pt>
                <c:pt idx="49">
                  <c:v>0.3164961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1234120"/>
        <c:axId val="2041215416"/>
      </c:lineChart>
      <c:catAx>
        <c:axId val="2041234120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41215416"/>
        <c:crosses val="autoZero"/>
        <c:auto val="1"/>
        <c:lblAlgn val="ctr"/>
        <c:lblOffset val="100"/>
        <c:noMultiLvlLbl val="0"/>
      </c:catAx>
      <c:valAx>
        <c:axId val="2041215416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041234120"/>
        <c:crosses val="autoZero"/>
        <c:crossBetween val="between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735556189682231"/>
          <c:y val="0.130706881239643"/>
          <c:w val="0.901609145744623"/>
          <c:h val="0.603085704688555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192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F$193:$F$224</c:f>
              <c:numCache>
                <c:formatCode>General</c:formatCode>
                <c:ptCount val="32"/>
                <c:pt idx="0">
                  <c:v>0.34734895</c:v>
                </c:pt>
                <c:pt idx="1">
                  <c:v>0.3948888</c:v>
                </c:pt>
                <c:pt idx="2">
                  <c:v>0.16386365</c:v>
                </c:pt>
                <c:pt idx="3">
                  <c:v>0.4005732</c:v>
                </c:pt>
                <c:pt idx="4">
                  <c:v>0.40244285</c:v>
                </c:pt>
                <c:pt idx="5">
                  <c:v>0.1780629</c:v>
                </c:pt>
                <c:pt idx="6">
                  <c:v>0.3857066</c:v>
                </c:pt>
                <c:pt idx="7">
                  <c:v>0.1776036</c:v>
                </c:pt>
                <c:pt idx="8">
                  <c:v>0.18828075</c:v>
                </c:pt>
                <c:pt idx="9">
                  <c:v>0.18479795</c:v>
                </c:pt>
                <c:pt idx="10">
                  <c:v>0.23619745</c:v>
                </c:pt>
                <c:pt idx="11">
                  <c:v>0.2872001</c:v>
                </c:pt>
                <c:pt idx="12">
                  <c:v>0.20590375</c:v>
                </c:pt>
                <c:pt idx="13">
                  <c:v>0.4159012</c:v>
                </c:pt>
                <c:pt idx="14">
                  <c:v>0.324227</c:v>
                </c:pt>
                <c:pt idx="15">
                  <c:v>0.41594745</c:v>
                </c:pt>
                <c:pt idx="16">
                  <c:v>0.4740722</c:v>
                </c:pt>
                <c:pt idx="17">
                  <c:v>0.3486013</c:v>
                </c:pt>
                <c:pt idx="18">
                  <c:v>0.37371555</c:v>
                </c:pt>
                <c:pt idx="19">
                  <c:v>0.30310895</c:v>
                </c:pt>
                <c:pt idx="20">
                  <c:v>0.3221395</c:v>
                </c:pt>
                <c:pt idx="21">
                  <c:v>0.26522115</c:v>
                </c:pt>
                <c:pt idx="22">
                  <c:v>0.4122852</c:v>
                </c:pt>
                <c:pt idx="23">
                  <c:v>0.18954865</c:v>
                </c:pt>
                <c:pt idx="24">
                  <c:v>0.22165535</c:v>
                </c:pt>
                <c:pt idx="25">
                  <c:v>0.18689075</c:v>
                </c:pt>
                <c:pt idx="26">
                  <c:v>0.3005546</c:v>
                </c:pt>
                <c:pt idx="27">
                  <c:v>0.24893195</c:v>
                </c:pt>
                <c:pt idx="28">
                  <c:v>0.2455783</c:v>
                </c:pt>
                <c:pt idx="29">
                  <c:v>0.2506021</c:v>
                </c:pt>
                <c:pt idx="30">
                  <c:v>0.37404095</c:v>
                </c:pt>
                <c:pt idx="31">
                  <c:v>0.448097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192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>
                  <a:alpha val="88000"/>
                </a:schemeClr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G$193:$G$224</c:f>
              <c:numCache>
                <c:formatCode>General</c:formatCode>
                <c:ptCount val="32"/>
                <c:pt idx="0">
                  <c:v>0.4054262</c:v>
                </c:pt>
                <c:pt idx="1">
                  <c:v>0.3674031</c:v>
                </c:pt>
                <c:pt idx="2">
                  <c:v>0.1528625</c:v>
                </c:pt>
                <c:pt idx="3">
                  <c:v>0.3705303</c:v>
                </c:pt>
                <c:pt idx="4">
                  <c:v>0.36601545</c:v>
                </c:pt>
                <c:pt idx="5">
                  <c:v>0.17296925</c:v>
                </c:pt>
                <c:pt idx="6">
                  <c:v>0.34798</c:v>
                </c:pt>
                <c:pt idx="7">
                  <c:v>0.16311715</c:v>
                </c:pt>
                <c:pt idx="8">
                  <c:v>0.16951475</c:v>
                </c:pt>
                <c:pt idx="9">
                  <c:v>0.1706057</c:v>
                </c:pt>
                <c:pt idx="10">
                  <c:v>0.1963079</c:v>
                </c:pt>
                <c:pt idx="11">
                  <c:v>0.2504021</c:v>
                </c:pt>
                <c:pt idx="12">
                  <c:v>0.1399563</c:v>
                </c:pt>
                <c:pt idx="13">
                  <c:v>0.4161333</c:v>
                </c:pt>
                <c:pt idx="14">
                  <c:v>0.30828495</c:v>
                </c:pt>
                <c:pt idx="15">
                  <c:v>0.4013619</c:v>
                </c:pt>
                <c:pt idx="16">
                  <c:v>0.4555368</c:v>
                </c:pt>
                <c:pt idx="17">
                  <c:v>0.3126601</c:v>
                </c:pt>
                <c:pt idx="18">
                  <c:v>0.3178545</c:v>
                </c:pt>
                <c:pt idx="19">
                  <c:v>0.2844971</c:v>
                </c:pt>
                <c:pt idx="20">
                  <c:v>0.3028211</c:v>
                </c:pt>
                <c:pt idx="21">
                  <c:v>0.2635784</c:v>
                </c:pt>
                <c:pt idx="22">
                  <c:v>0.30830345</c:v>
                </c:pt>
                <c:pt idx="23">
                  <c:v>0.12673685</c:v>
                </c:pt>
                <c:pt idx="24">
                  <c:v>0.1500429</c:v>
                </c:pt>
                <c:pt idx="25">
                  <c:v>0.108907925</c:v>
                </c:pt>
                <c:pt idx="26">
                  <c:v>0.22204355</c:v>
                </c:pt>
                <c:pt idx="27">
                  <c:v>0.18240105</c:v>
                </c:pt>
                <c:pt idx="28">
                  <c:v>0.18922495</c:v>
                </c:pt>
                <c:pt idx="29">
                  <c:v>0.19160315</c:v>
                </c:pt>
                <c:pt idx="30">
                  <c:v>0.38369945</c:v>
                </c:pt>
                <c:pt idx="31">
                  <c:v>0.522464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192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H$193:$H$224</c:f>
              <c:numCache>
                <c:formatCode>General</c:formatCode>
                <c:ptCount val="32"/>
                <c:pt idx="0">
                  <c:v>0.3377129</c:v>
                </c:pt>
                <c:pt idx="1">
                  <c:v>0.39382095</c:v>
                </c:pt>
                <c:pt idx="2">
                  <c:v>0.12219675</c:v>
                </c:pt>
                <c:pt idx="3">
                  <c:v>0.37229915</c:v>
                </c:pt>
                <c:pt idx="4">
                  <c:v>0.34779395</c:v>
                </c:pt>
                <c:pt idx="5">
                  <c:v>0.19364345</c:v>
                </c:pt>
                <c:pt idx="6">
                  <c:v>0.36526645</c:v>
                </c:pt>
                <c:pt idx="7">
                  <c:v>0.1601704</c:v>
                </c:pt>
                <c:pt idx="8">
                  <c:v>0.19214215</c:v>
                </c:pt>
                <c:pt idx="9">
                  <c:v>0.19327915</c:v>
                </c:pt>
                <c:pt idx="10">
                  <c:v>0.24098655</c:v>
                </c:pt>
                <c:pt idx="11">
                  <c:v>0.3018261</c:v>
                </c:pt>
                <c:pt idx="12">
                  <c:v>0.1869408</c:v>
                </c:pt>
                <c:pt idx="13">
                  <c:v>0.43327545</c:v>
                </c:pt>
                <c:pt idx="14">
                  <c:v>0.3152241</c:v>
                </c:pt>
                <c:pt idx="15">
                  <c:v>0.4239006</c:v>
                </c:pt>
                <c:pt idx="16">
                  <c:v>0.4853197</c:v>
                </c:pt>
                <c:pt idx="17">
                  <c:v>0.3296107</c:v>
                </c:pt>
                <c:pt idx="18">
                  <c:v>0.3343027</c:v>
                </c:pt>
                <c:pt idx="19">
                  <c:v>0.28878795</c:v>
                </c:pt>
                <c:pt idx="20">
                  <c:v>0.30505465</c:v>
                </c:pt>
                <c:pt idx="21">
                  <c:v>0.27728125</c:v>
                </c:pt>
                <c:pt idx="22">
                  <c:v>0.35566625</c:v>
                </c:pt>
                <c:pt idx="23">
                  <c:v>0.14769005</c:v>
                </c:pt>
                <c:pt idx="24">
                  <c:v>0.2234174</c:v>
                </c:pt>
                <c:pt idx="25">
                  <c:v>0.1398322</c:v>
                </c:pt>
                <c:pt idx="26">
                  <c:v>0.2731436</c:v>
                </c:pt>
                <c:pt idx="27">
                  <c:v>0.25693625</c:v>
                </c:pt>
                <c:pt idx="28">
                  <c:v>0.2675284</c:v>
                </c:pt>
                <c:pt idx="29">
                  <c:v>0.27254135</c:v>
                </c:pt>
                <c:pt idx="30">
                  <c:v>0.388667</c:v>
                </c:pt>
                <c:pt idx="31">
                  <c:v>0.4817981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192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I$193:$I$224</c:f>
              <c:numCache>
                <c:formatCode>General</c:formatCode>
                <c:ptCount val="32"/>
                <c:pt idx="0">
                  <c:v>0.40594875</c:v>
                </c:pt>
                <c:pt idx="1">
                  <c:v>0.3407413</c:v>
                </c:pt>
                <c:pt idx="2">
                  <c:v>0.12192805</c:v>
                </c:pt>
                <c:pt idx="3">
                  <c:v>0.36367655</c:v>
                </c:pt>
                <c:pt idx="4">
                  <c:v>0.35864245</c:v>
                </c:pt>
                <c:pt idx="5">
                  <c:v>0.1751126</c:v>
                </c:pt>
                <c:pt idx="6">
                  <c:v>0.3695401</c:v>
                </c:pt>
                <c:pt idx="7">
                  <c:v>0.16165175</c:v>
                </c:pt>
                <c:pt idx="8">
                  <c:v>0.18549555</c:v>
                </c:pt>
                <c:pt idx="9">
                  <c:v>0.1566699</c:v>
                </c:pt>
                <c:pt idx="10">
                  <c:v>0.2316144</c:v>
                </c:pt>
                <c:pt idx="11">
                  <c:v>0.30100445</c:v>
                </c:pt>
                <c:pt idx="12">
                  <c:v>0.17866805</c:v>
                </c:pt>
                <c:pt idx="13">
                  <c:v>0.4625302</c:v>
                </c:pt>
                <c:pt idx="14">
                  <c:v>0.30909765</c:v>
                </c:pt>
                <c:pt idx="15">
                  <c:v>0.4305834</c:v>
                </c:pt>
                <c:pt idx="16">
                  <c:v>0.5042948</c:v>
                </c:pt>
                <c:pt idx="17">
                  <c:v>0.32205895</c:v>
                </c:pt>
                <c:pt idx="18">
                  <c:v>0.30705895</c:v>
                </c:pt>
                <c:pt idx="19">
                  <c:v>0.25626525</c:v>
                </c:pt>
                <c:pt idx="20">
                  <c:v>0.2879936</c:v>
                </c:pt>
                <c:pt idx="21">
                  <c:v>0.2541832</c:v>
                </c:pt>
                <c:pt idx="22">
                  <c:v>0.3555588</c:v>
                </c:pt>
                <c:pt idx="23">
                  <c:v>0.115712465</c:v>
                </c:pt>
                <c:pt idx="24">
                  <c:v>0.158359</c:v>
                </c:pt>
                <c:pt idx="25">
                  <c:v>0.11758997</c:v>
                </c:pt>
                <c:pt idx="26">
                  <c:v>0.2532081</c:v>
                </c:pt>
                <c:pt idx="27">
                  <c:v>0.21578175</c:v>
                </c:pt>
                <c:pt idx="28">
                  <c:v>0.19906555</c:v>
                </c:pt>
                <c:pt idx="29">
                  <c:v>0.2268697</c:v>
                </c:pt>
                <c:pt idx="30">
                  <c:v>0.4125083</c:v>
                </c:pt>
                <c:pt idx="31">
                  <c:v>0.4924601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192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J$193:$J$224</c:f>
              <c:numCache>
                <c:formatCode>General</c:formatCode>
                <c:ptCount val="32"/>
                <c:pt idx="0">
                  <c:v>0.33913145</c:v>
                </c:pt>
                <c:pt idx="1">
                  <c:v>0.36461635</c:v>
                </c:pt>
                <c:pt idx="2">
                  <c:v>0.166315</c:v>
                </c:pt>
                <c:pt idx="3">
                  <c:v>0.39364315</c:v>
                </c:pt>
                <c:pt idx="4">
                  <c:v>0.38170755</c:v>
                </c:pt>
                <c:pt idx="5">
                  <c:v>0.2326421</c:v>
                </c:pt>
                <c:pt idx="6">
                  <c:v>0.37570755</c:v>
                </c:pt>
                <c:pt idx="7">
                  <c:v>0.23109045</c:v>
                </c:pt>
                <c:pt idx="8">
                  <c:v>0.20578265</c:v>
                </c:pt>
                <c:pt idx="9">
                  <c:v>0.1840336</c:v>
                </c:pt>
                <c:pt idx="10">
                  <c:v>0.28966815</c:v>
                </c:pt>
                <c:pt idx="11">
                  <c:v>0.3504455</c:v>
                </c:pt>
                <c:pt idx="12">
                  <c:v>0.21135005</c:v>
                </c:pt>
                <c:pt idx="13">
                  <c:v>0.4445783</c:v>
                </c:pt>
                <c:pt idx="14">
                  <c:v>0.33183915</c:v>
                </c:pt>
                <c:pt idx="15">
                  <c:v>0.45374645</c:v>
                </c:pt>
                <c:pt idx="16">
                  <c:v>0.50119975</c:v>
                </c:pt>
                <c:pt idx="17">
                  <c:v>0.32599145</c:v>
                </c:pt>
                <c:pt idx="18">
                  <c:v>0.3178159</c:v>
                </c:pt>
                <c:pt idx="19">
                  <c:v>0.31584475</c:v>
                </c:pt>
                <c:pt idx="20">
                  <c:v>0.34264335</c:v>
                </c:pt>
                <c:pt idx="21">
                  <c:v>0.2866787</c:v>
                </c:pt>
                <c:pt idx="22">
                  <c:v>0.4021822</c:v>
                </c:pt>
                <c:pt idx="23">
                  <c:v>0.1171952</c:v>
                </c:pt>
                <c:pt idx="24">
                  <c:v>0.19076305</c:v>
                </c:pt>
                <c:pt idx="25">
                  <c:v>0.14327245</c:v>
                </c:pt>
                <c:pt idx="26">
                  <c:v>0.27403875</c:v>
                </c:pt>
                <c:pt idx="27">
                  <c:v>0.26758615</c:v>
                </c:pt>
                <c:pt idx="28">
                  <c:v>0.2363868</c:v>
                </c:pt>
                <c:pt idx="29">
                  <c:v>0.25327225</c:v>
                </c:pt>
                <c:pt idx="30">
                  <c:v>0.4444812</c:v>
                </c:pt>
                <c:pt idx="31">
                  <c:v>0.5103602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192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K$193:$K$224</c:f>
              <c:numCache>
                <c:formatCode>General</c:formatCode>
                <c:ptCount val="32"/>
                <c:pt idx="0">
                  <c:v>0.375704</c:v>
                </c:pt>
                <c:pt idx="1">
                  <c:v>0.3266352</c:v>
                </c:pt>
                <c:pt idx="2">
                  <c:v>0.1693665</c:v>
                </c:pt>
                <c:pt idx="3">
                  <c:v>0.4140765</c:v>
                </c:pt>
                <c:pt idx="4">
                  <c:v>0.39202395</c:v>
                </c:pt>
                <c:pt idx="5">
                  <c:v>0.1824725</c:v>
                </c:pt>
                <c:pt idx="6">
                  <c:v>0.3356211</c:v>
                </c:pt>
                <c:pt idx="7">
                  <c:v>0.1612752</c:v>
                </c:pt>
                <c:pt idx="8">
                  <c:v>0.1451626</c:v>
                </c:pt>
                <c:pt idx="9">
                  <c:v>0.14700775</c:v>
                </c:pt>
                <c:pt idx="10">
                  <c:v>0.25499095</c:v>
                </c:pt>
                <c:pt idx="11">
                  <c:v>0.3199033</c:v>
                </c:pt>
                <c:pt idx="12">
                  <c:v>0.20081855</c:v>
                </c:pt>
                <c:pt idx="13">
                  <c:v>0.4616931</c:v>
                </c:pt>
                <c:pt idx="14">
                  <c:v>0.31256535</c:v>
                </c:pt>
                <c:pt idx="15">
                  <c:v>0.4437313</c:v>
                </c:pt>
                <c:pt idx="16">
                  <c:v>0.46375785</c:v>
                </c:pt>
                <c:pt idx="17">
                  <c:v>0.339867</c:v>
                </c:pt>
                <c:pt idx="18">
                  <c:v>0.3163918</c:v>
                </c:pt>
                <c:pt idx="19">
                  <c:v>0.2734276</c:v>
                </c:pt>
                <c:pt idx="20">
                  <c:v>0.3056124</c:v>
                </c:pt>
                <c:pt idx="21">
                  <c:v>0.26682445</c:v>
                </c:pt>
                <c:pt idx="22">
                  <c:v>0.3476063</c:v>
                </c:pt>
                <c:pt idx="23">
                  <c:v>0.070226435</c:v>
                </c:pt>
                <c:pt idx="24">
                  <c:v>0.1434142</c:v>
                </c:pt>
                <c:pt idx="25">
                  <c:v>0.08518956</c:v>
                </c:pt>
                <c:pt idx="26">
                  <c:v>0.21883115</c:v>
                </c:pt>
                <c:pt idx="27">
                  <c:v>0.21873805</c:v>
                </c:pt>
                <c:pt idx="28">
                  <c:v>0.1885622</c:v>
                </c:pt>
                <c:pt idx="29">
                  <c:v>0.2385046</c:v>
                </c:pt>
                <c:pt idx="30">
                  <c:v>0.3684675</c:v>
                </c:pt>
                <c:pt idx="31">
                  <c:v>0.5119345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192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L$193:$L$224</c:f>
              <c:numCache>
                <c:formatCode>General</c:formatCode>
                <c:ptCount val="32"/>
                <c:pt idx="0">
                  <c:v>0.3224293</c:v>
                </c:pt>
                <c:pt idx="1">
                  <c:v>0.3842771</c:v>
                </c:pt>
                <c:pt idx="2">
                  <c:v>0.1416804</c:v>
                </c:pt>
                <c:pt idx="3">
                  <c:v>0.36199155</c:v>
                </c:pt>
                <c:pt idx="4">
                  <c:v>0.3678191</c:v>
                </c:pt>
                <c:pt idx="5">
                  <c:v>0.23892725</c:v>
                </c:pt>
                <c:pt idx="6">
                  <c:v>0.3592799</c:v>
                </c:pt>
                <c:pt idx="7">
                  <c:v>0.21073995</c:v>
                </c:pt>
                <c:pt idx="8">
                  <c:v>0.2420534</c:v>
                </c:pt>
                <c:pt idx="9">
                  <c:v>0.22588</c:v>
                </c:pt>
                <c:pt idx="10">
                  <c:v>0.2771962</c:v>
                </c:pt>
                <c:pt idx="11">
                  <c:v>0.3324987</c:v>
                </c:pt>
                <c:pt idx="12">
                  <c:v>0.1968794</c:v>
                </c:pt>
                <c:pt idx="13">
                  <c:v>0.47201565</c:v>
                </c:pt>
                <c:pt idx="14">
                  <c:v>0.3352103</c:v>
                </c:pt>
                <c:pt idx="15">
                  <c:v>0.4118825</c:v>
                </c:pt>
                <c:pt idx="16">
                  <c:v>0.469138</c:v>
                </c:pt>
                <c:pt idx="17">
                  <c:v>0.3677022</c:v>
                </c:pt>
                <c:pt idx="18">
                  <c:v>0.36132615</c:v>
                </c:pt>
                <c:pt idx="19">
                  <c:v>0.2974969</c:v>
                </c:pt>
                <c:pt idx="20">
                  <c:v>0.3382111</c:v>
                </c:pt>
                <c:pt idx="21">
                  <c:v>0.29051935</c:v>
                </c:pt>
                <c:pt idx="22">
                  <c:v>0.38601075</c:v>
                </c:pt>
                <c:pt idx="23">
                  <c:v>0.14419205</c:v>
                </c:pt>
                <c:pt idx="24">
                  <c:v>0.18982115</c:v>
                </c:pt>
                <c:pt idx="25">
                  <c:v>0.15234305</c:v>
                </c:pt>
                <c:pt idx="26">
                  <c:v>0.2835662</c:v>
                </c:pt>
                <c:pt idx="27">
                  <c:v>0.2436499</c:v>
                </c:pt>
                <c:pt idx="28">
                  <c:v>0.2245927</c:v>
                </c:pt>
                <c:pt idx="29">
                  <c:v>0.06522071</c:v>
                </c:pt>
                <c:pt idx="30">
                  <c:v>0.42969235</c:v>
                </c:pt>
                <c:pt idx="31">
                  <c:v>0.5177929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192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M$193:$M$224</c:f>
              <c:numCache>
                <c:formatCode>General</c:formatCode>
                <c:ptCount val="32"/>
                <c:pt idx="0">
                  <c:v>0.430659</c:v>
                </c:pt>
                <c:pt idx="1">
                  <c:v>0.40937365</c:v>
                </c:pt>
                <c:pt idx="2">
                  <c:v>0.1751413</c:v>
                </c:pt>
                <c:pt idx="3">
                  <c:v>0.41144885</c:v>
                </c:pt>
                <c:pt idx="4">
                  <c:v>0.42118275</c:v>
                </c:pt>
                <c:pt idx="5">
                  <c:v>0.2407385</c:v>
                </c:pt>
                <c:pt idx="6">
                  <c:v>0.3661829</c:v>
                </c:pt>
                <c:pt idx="7">
                  <c:v>0.18961785</c:v>
                </c:pt>
                <c:pt idx="8">
                  <c:v>0.2107383</c:v>
                </c:pt>
                <c:pt idx="9">
                  <c:v>0.21001735</c:v>
                </c:pt>
                <c:pt idx="10">
                  <c:v>0.2622315</c:v>
                </c:pt>
                <c:pt idx="11">
                  <c:v>0.31629185</c:v>
                </c:pt>
                <c:pt idx="12">
                  <c:v>0.19691675</c:v>
                </c:pt>
                <c:pt idx="13">
                  <c:v>0.481992</c:v>
                </c:pt>
                <c:pt idx="14">
                  <c:v>0.3425086</c:v>
                </c:pt>
                <c:pt idx="15">
                  <c:v>0.40754635</c:v>
                </c:pt>
                <c:pt idx="16">
                  <c:v>0.4982188</c:v>
                </c:pt>
                <c:pt idx="17">
                  <c:v>0.3594514</c:v>
                </c:pt>
                <c:pt idx="18">
                  <c:v>0.35794365</c:v>
                </c:pt>
                <c:pt idx="19">
                  <c:v>0.3193317</c:v>
                </c:pt>
                <c:pt idx="20">
                  <c:v>0.3586882</c:v>
                </c:pt>
                <c:pt idx="21">
                  <c:v>0.28813185</c:v>
                </c:pt>
                <c:pt idx="22">
                  <c:v>0.43139555</c:v>
                </c:pt>
                <c:pt idx="23">
                  <c:v>0.23096315</c:v>
                </c:pt>
                <c:pt idx="24">
                  <c:v>0.2168112</c:v>
                </c:pt>
                <c:pt idx="25">
                  <c:v>0.1633156</c:v>
                </c:pt>
                <c:pt idx="26">
                  <c:v>0.34348875</c:v>
                </c:pt>
                <c:pt idx="27">
                  <c:v>0.2859903</c:v>
                </c:pt>
                <c:pt idx="28">
                  <c:v>0.30544395</c:v>
                </c:pt>
                <c:pt idx="29">
                  <c:v>0.09487606</c:v>
                </c:pt>
                <c:pt idx="30">
                  <c:v>0.42829435</c:v>
                </c:pt>
                <c:pt idx="31">
                  <c:v>0.5547064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192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N$193:$N$224</c:f>
              <c:numCache>
                <c:formatCode>General</c:formatCode>
                <c:ptCount val="32"/>
                <c:pt idx="0">
                  <c:v>0.37750155</c:v>
                </c:pt>
                <c:pt idx="1">
                  <c:v>0.3014089</c:v>
                </c:pt>
                <c:pt idx="2">
                  <c:v>0.1686479</c:v>
                </c:pt>
                <c:pt idx="3">
                  <c:v>0.29592795</c:v>
                </c:pt>
                <c:pt idx="4">
                  <c:v>0.2927017</c:v>
                </c:pt>
                <c:pt idx="5">
                  <c:v>0.20051265</c:v>
                </c:pt>
                <c:pt idx="6">
                  <c:v>0.30883445</c:v>
                </c:pt>
                <c:pt idx="7">
                  <c:v>0.17474135</c:v>
                </c:pt>
                <c:pt idx="8">
                  <c:v>0.1548532</c:v>
                </c:pt>
                <c:pt idx="9">
                  <c:v>0.1315177</c:v>
                </c:pt>
                <c:pt idx="10">
                  <c:v>0.1972588</c:v>
                </c:pt>
                <c:pt idx="11">
                  <c:v>0.2763707</c:v>
                </c:pt>
                <c:pt idx="12">
                  <c:v>0.16118145</c:v>
                </c:pt>
                <c:pt idx="13">
                  <c:v>0.3928374</c:v>
                </c:pt>
                <c:pt idx="14">
                  <c:v>0.2940237</c:v>
                </c:pt>
                <c:pt idx="15">
                  <c:v>0.4254479</c:v>
                </c:pt>
                <c:pt idx="16">
                  <c:v>0.50001315</c:v>
                </c:pt>
                <c:pt idx="17">
                  <c:v>0.2937254</c:v>
                </c:pt>
                <c:pt idx="18">
                  <c:v>0.26074545</c:v>
                </c:pt>
                <c:pt idx="19">
                  <c:v>0.28320995</c:v>
                </c:pt>
                <c:pt idx="20">
                  <c:v>0.31266725</c:v>
                </c:pt>
                <c:pt idx="21">
                  <c:v>0.2656836</c:v>
                </c:pt>
                <c:pt idx="22">
                  <c:v>0.2656472</c:v>
                </c:pt>
                <c:pt idx="23">
                  <c:v>0.094783155</c:v>
                </c:pt>
                <c:pt idx="24">
                  <c:v>0.13178195</c:v>
                </c:pt>
                <c:pt idx="25">
                  <c:v>0.112049685</c:v>
                </c:pt>
                <c:pt idx="26">
                  <c:v>0.3098282</c:v>
                </c:pt>
                <c:pt idx="27">
                  <c:v>0.2247831</c:v>
                </c:pt>
                <c:pt idx="28">
                  <c:v>0.24826155</c:v>
                </c:pt>
                <c:pt idx="29">
                  <c:v>0.2403461</c:v>
                </c:pt>
                <c:pt idx="30">
                  <c:v>0.4238628</c:v>
                </c:pt>
                <c:pt idx="31">
                  <c:v>0.6811738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192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193:$E$224</c:f>
              <c:strCache>
                <c:ptCount val="32"/>
                <c:pt idx="0">
                  <c:v>cg00000924</c:v>
                </c:pt>
                <c:pt idx="1">
                  <c:v>cg11297256</c:v>
                </c:pt>
                <c:pt idx="2">
                  <c:v>cg14392746</c:v>
                </c:pt>
                <c:pt idx="3">
                  <c:v>cg12077660</c:v>
                </c:pt>
                <c:pt idx="4">
                  <c:v>cg03401726</c:v>
                </c:pt>
                <c:pt idx="5">
                  <c:v>cg16739686</c:v>
                </c:pt>
                <c:pt idx="6">
                  <c:v>cg08359167</c:v>
                </c:pt>
                <c:pt idx="7">
                  <c:v>cg08446215</c:v>
                </c:pt>
                <c:pt idx="8">
                  <c:v>cg26104781</c:v>
                </c:pt>
                <c:pt idx="9">
                  <c:v>cg02219360</c:v>
                </c:pt>
                <c:pt idx="10">
                  <c:v>cg20699737</c:v>
                </c:pt>
                <c:pt idx="11">
                  <c:v>cg26547719</c:v>
                </c:pt>
                <c:pt idx="12">
                  <c:v>cg07595203</c:v>
                </c:pt>
                <c:pt idx="13">
                  <c:v>cg09518720</c:v>
                </c:pt>
                <c:pt idx="14">
                  <c:v>cg14958441</c:v>
                </c:pt>
                <c:pt idx="15">
                  <c:v>cg27323091</c:v>
                </c:pt>
                <c:pt idx="16">
                  <c:v>cg01873334</c:v>
                </c:pt>
                <c:pt idx="17">
                  <c:v>cg05816130</c:v>
                </c:pt>
                <c:pt idx="18">
                  <c:v>cg14243741</c:v>
                </c:pt>
                <c:pt idx="19">
                  <c:v>cg21137515</c:v>
                </c:pt>
                <c:pt idx="20">
                  <c:v>cg05740879</c:v>
                </c:pt>
                <c:pt idx="21">
                  <c:v>cg01893176</c:v>
                </c:pt>
                <c:pt idx="22">
                  <c:v>cg11993252</c:v>
                </c:pt>
                <c:pt idx="23">
                  <c:v>cg11666921</c:v>
                </c:pt>
                <c:pt idx="24">
                  <c:v>cg26094482</c:v>
                </c:pt>
                <c:pt idx="25">
                  <c:v>cg26908876</c:v>
                </c:pt>
                <c:pt idx="26">
                  <c:v>cg03422070</c:v>
                </c:pt>
                <c:pt idx="27">
                  <c:v>cg15651941</c:v>
                </c:pt>
                <c:pt idx="28">
                  <c:v>cg25306939</c:v>
                </c:pt>
                <c:pt idx="29">
                  <c:v>cg06288089</c:v>
                </c:pt>
                <c:pt idx="30">
                  <c:v>cg02798157</c:v>
                </c:pt>
                <c:pt idx="31">
                  <c:v>cg27604721</c:v>
                </c:pt>
              </c:strCache>
            </c:strRef>
          </c:cat>
          <c:val>
            <c:numRef>
              <c:f>revise_data!$O$193:$O$224</c:f>
              <c:numCache>
                <c:formatCode>General</c:formatCode>
                <c:ptCount val="32"/>
                <c:pt idx="0">
                  <c:v>0.3634466</c:v>
                </c:pt>
                <c:pt idx="1">
                  <c:v>0.30861915</c:v>
                </c:pt>
                <c:pt idx="2">
                  <c:v>0.189864675</c:v>
                </c:pt>
                <c:pt idx="3">
                  <c:v>0.32181485</c:v>
                </c:pt>
                <c:pt idx="4">
                  <c:v>0.299277</c:v>
                </c:pt>
                <c:pt idx="5">
                  <c:v>0.21684855</c:v>
                </c:pt>
                <c:pt idx="6">
                  <c:v>0.2999698</c:v>
                </c:pt>
                <c:pt idx="7">
                  <c:v>0.1221244</c:v>
                </c:pt>
                <c:pt idx="8">
                  <c:v>0.1556911</c:v>
                </c:pt>
                <c:pt idx="9">
                  <c:v>0.16896585</c:v>
                </c:pt>
                <c:pt idx="10">
                  <c:v>0.2542445</c:v>
                </c:pt>
                <c:pt idx="11">
                  <c:v>0.27175905</c:v>
                </c:pt>
                <c:pt idx="12">
                  <c:v>0.14448445</c:v>
                </c:pt>
                <c:pt idx="13">
                  <c:v>0.3551864</c:v>
                </c:pt>
                <c:pt idx="14">
                  <c:v>0.28164225</c:v>
                </c:pt>
                <c:pt idx="15">
                  <c:v>0.39224095</c:v>
                </c:pt>
                <c:pt idx="16">
                  <c:v>0.4413222</c:v>
                </c:pt>
                <c:pt idx="17">
                  <c:v>0.2954849</c:v>
                </c:pt>
                <c:pt idx="18">
                  <c:v>0.27052225</c:v>
                </c:pt>
                <c:pt idx="19">
                  <c:v>0.21962865</c:v>
                </c:pt>
                <c:pt idx="20">
                  <c:v>0.27043675</c:v>
                </c:pt>
                <c:pt idx="21">
                  <c:v>0.2328598</c:v>
                </c:pt>
                <c:pt idx="22">
                  <c:v>0.2549587</c:v>
                </c:pt>
                <c:pt idx="23">
                  <c:v>0.036098105</c:v>
                </c:pt>
                <c:pt idx="24">
                  <c:v>0.06972682</c:v>
                </c:pt>
                <c:pt idx="25">
                  <c:v>0.02751387</c:v>
                </c:pt>
                <c:pt idx="26">
                  <c:v>0.1523894</c:v>
                </c:pt>
                <c:pt idx="27">
                  <c:v>0.11769205</c:v>
                </c:pt>
                <c:pt idx="28">
                  <c:v>0.125050845</c:v>
                </c:pt>
                <c:pt idx="29">
                  <c:v>0.2027876</c:v>
                </c:pt>
                <c:pt idx="30">
                  <c:v>0.34983415</c:v>
                </c:pt>
                <c:pt idx="31">
                  <c:v>0.50464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3083864"/>
        <c:axId val="-2123060680"/>
      </c:lineChart>
      <c:catAx>
        <c:axId val="-2123083864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23060680"/>
        <c:crosses val="autoZero"/>
        <c:auto val="1"/>
        <c:lblAlgn val="ctr"/>
        <c:lblOffset val="100"/>
        <c:noMultiLvlLbl val="0"/>
      </c:catAx>
      <c:valAx>
        <c:axId val="-212306068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23083864"/>
        <c:crosses val="autoZero"/>
        <c:crossBetween val="between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04258319621679"/>
          <c:y val="0.151589383938394"/>
          <c:w val="0.726776134328676"/>
          <c:h val="0.589306655665566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226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F$227:$F$235</c:f>
              <c:numCache>
                <c:formatCode>General</c:formatCode>
                <c:ptCount val="9"/>
                <c:pt idx="0">
                  <c:v>0.7474632</c:v>
                </c:pt>
                <c:pt idx="1">
                  <c:v>0.63778965</c:v>
                </c:pt>
                <c:pt idx="2">
                  <c:v>0.2762966</c:v>
                </c:pt>
                <c:pt idx="3">
                  <c:v>0.50453415</c:v>
                </c:pt>
                <c:pt idx="4">
                  <c:v>0.3545769</c:v>
                </c:pt>
                <c:pt idx="5">
                  <c:v>0.31857375</c:v>
                </c:pt>
                <c:pt idx="6">
                  <c:v>0.29899775</c:v>
                </c:pt>
                <c:pt idx="7">
                  <c:v>0.38863325</c:v>
                </c:pt>
                <c:pt idx="8">
                  <c:v>0.354834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226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G$227:$G$235</c:f>
              <c:numCache>
                <c:formatCode>General</c:formatCode>
                <c:ptCount val="9"/>
                <c:pt idx="0">
                  <c:v>0.66323965</c:v>
                </c:pt>
                <c:pt idx="1">
                  <c:v>0.57241855</c:v>
                </c:pt>
                <c:pt idx="2">
                  <c:v>0.20782175</c:v>
                </c:pt>
                <c:pt idx="3">
                  <c:v>0.448889</c:v>
                </c:pt>
                <c:pt idx="4">
                  <c:v>0.35448515</c:v>
                </c:pt>
                <c:pt idx="5">
                  <c:v>0.2926809</c:v>
                </c:pt>
                <c:pt idx="6">
                  <c:v>0.2493137</c:v>
                </c:pt>
                <c:pt idx="7">
                  <c:v>0.3723494</c:v>
                </c:pt>
                <c:pt idx="8">
                  <c:v>0.298976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226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H$227:$H$235</c:f>
              <c:numCache>
                <c:formatCode>General</c:formatCode>
                <c:ptCount val="9"/>
                <c:pt idx="0">
                  <c:v>0.70062665</c:v>
                </c:pt>
                <c:pt idx="1">
                  <c:v>0.6788875</c:v>
                </c:pt>
                <c:pt idx="2">
                  <c:v>0.23673855</c:v>
                </c:pt>
                <c:pt idx="3">
                  <c:v>0.464646</c:v>
                </c:pt>
                <c:pt idx="4">
                  <c:v>0.4115236</c:v>
                </c:pt>
                <c:pt idx="5">
                  <c:v>0.25542935</c:v>
                </c:pt>
                <c:pt idx="6">
                  <c:v>0.29127075</c:v>
                </c:pt>
                <c:pt idx="7">
                  <c:v>0.3577338</c:v>
                </c:pt>
                <c:pt idx="8">
                  <c:v>0.4144441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226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I$227:$I$235</c:f>
              <c:numCache>
                <c:formatCode>General</c:formatCode>
                <c:ptCount val="9"/>
                <c:pt idx="0">
                  <c:v>0.7367497</c:v>
                </c:pt>
                <c:pt idx="1">
                  <c:v>0.6801507</c:v>
                </c:pt>
                <c:pt idx="2">
                  <c:v>0.29317365</c:v>
                </c:pt>
                <c:pt idx="3">
                  <c:v>0.42946705</c:v>
                </c:pt>
                <c:pt idx="4">
                  <c:v>0.3680798</c:v>
                </c:pt>
                <c:pt idx="5">
                  <c:v>0.280412</c:v>
                </c:pt>
                <c:pt idx="6">
                  <c:v>0.3200068</c:v>
                </c:pt>
                <c:pt idx="7">
                  <c:v>0.3790427</c:v>
                </c:pt>
                <c:pt idx="8">
                  <c:v>0.336108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226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J$227:$J$235</c:f>
              <c:numCache>
                <c:formatCode>General</c:formatCode>
                <c:ptCount val="9"/>
                <c:pt idx="0">
                  <c:v>0.6642653</c:v>
                </c:pt>
                <c:pt idx="1">
                  <c:v>0.7449858</c:v>
                </c:pt>
                <c:pt idx="2">
                  <c:v>0.30738005</c:v>
                </c:pt>
                <c:pt idx="3">
                  <c:v>0.46978575</c:v>
                </c:pt>
                <c:pt idx="4">
                  <c:v>0.3340467</c:v>
                </c:pt>
                <c:pt idx="5">
                  <c:v>0.2369118</c:v>
                </c:pt>
                <c:pt idx="6">
                  <c:v>0.28265405</c:v>
                </c:pt>
                <c:pt idx="7">
                  <c:v>0.3835892</c:v>
                </c:pt>
                <c:pt idx="8">
                  <c:v>0.2720697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226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K$227:$K$235</c:f>
              <c:numCache>
                <c:formatCode>General</c:formatCode>
                <c:ptCount val="9"/>
                <c:pt idx="0">
                  <c:v>0.5743617</c:v>
                </c:pt>
                <c:pt idx="1">
                  <c:v>0.6452054</c:v>
                </c:pt>
                <c:pt idx="2">
                  <c:v>0.26866275</c:v>
                </c:pt>
                <c:pt idx="3">
                  <c:v>0.35983125</c:v>
                </c:pt>
                <c:pt idx="4">
                  <c:v>0.4364625</c:v>
                </c:pt>
                <c:pt idx="5">
                  <c:v>0.136509255</c:v>
                </c:pt>
                <c:pt idx="6">
                  <c:v>0.3219367</c:v>
                </c:pt>
                <c:pt idx="7">
                  <c:v>0.3685593</c:v>
                </c:pt>
                <c:pt idx="8">
                  <c:v>0.2693476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226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L$227:$L$235</c:f>
              <c:numCache>
                <c:formatCode>General</c:formatCode>
                <c:ptCount val="9"/>
                <c:pt idx="0">
                  <c:v>0.757061</c:v>
                </c:pt>
                <c:pt idx="1">
                  <c:v>0.72939635</c:v>
                </c:pt>
                <c:pt idx="2">
                  <c:v>0.2636538</c:v>
                </c:pt>
                <c:pt idx="3">
                  <c:v>0.47676</c:v>
                </c:pt>
                <c:pt idx="4">
                  <c:v>0.42482995</c:v>
                </c:pt>
                <c:pt idx="5">
                  <c:v>0.18606905</c:v>
                </c:pt>
                <c:pt idx="6">
                  <c:v>0.3042037</c:v>
                </c:pt>
                <c:pt idx="7">
                  <c:v>0.3873659</c:v>
                </c:pt>
                <c:pt idx="8">
                  <c:v>0.3530656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226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M$227:$M$235</c:f>
              <c:numCache>
                <c:formatCode>General</c:formatCode>
                <c:ptCount val="9"/>
                <c:pt idx="0">
                  <c:v>0.7243867</c:v>
                </c:pt>
                <c:pt idx="1">
                  <c:v>0.73974085</c:v>
                </c:pt>
                <c:pt idx="2">
                  <c:v>0.31278465</c:v>
                </c:pt>
                <c:pt idx="3">
                  <c:v>0.50895235</c:v>
                </c:pt>
                <c:pt idx="4">
                  <c:v>0.4167138</c:v>
                </c:pt>
                <c:pt idx="5">
                  <c:v>0.21397765</c:v>
                </c:pt>
                <c:pt idx="6">
                  <c:v>0.3198344</c:v>
                </c:pt>
                <c:pt idx="7">
                  <c:v>0.359282</c:v>
                </c:pt>
                <c:pt idx="8">
                  <c:v>0.3694237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226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N$227:$N$235</c:f>
              <c:numCache>
                <c:formatCode>General</c:formatCode>
                <c:ptCount val="9"/>
                <c:pt idx="0">
                  <c:v>0.58011075</c:v>
                </c:pt>
                <c:pt idx="1">
                  <c:v>0.62762585</c:v>
                </c:pt>
                <c:pt idx="2">
                  <c:v>0.1884102</c:v>
                </c:pt>
                <c:pt idx="3">
                  <c:v>0.4303011</c:v>
                </c:pt>
                <c:pt idx="4">
                  <c:v>0.30940795</c:v>
                </c:pt>
                <c:pt idx="5">
                  <c:v>0.27610175</c:v>
                </c:pt>
                <c:pt idx="6">
                  <c:v>0.23951045</c:v>
                </c:pt>
                <c:pt idx="7">
                  <c:v>0.3822223</c:v>
                </c:pt>
                <c:pt idx="8">
                  <c:v>0.273696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226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27:$E$235</c:f>
              <c:strCache>
                <c:ptCount val="9"/>
                <c:pt idx="0">
                  <c:v>cg02152271</c:v>
                </c:pt>
                <c:pt idx="1">
                  <c:v>cg12298755</c:v>
                </c:pt>
                <c:pt idx="2">
                  <c:v>cg18506672</c:v>
                </c:pt>
                <c:pt idx="3">
                  <c:v>cg02125271</c:v>
                </c:pt>
                <c:pt idx="4">
                  <c:v>cg26875073</c:v>
                </c:pt>
                <c:pt idx="5">
                  <c:v>cg22159025</c:v>
                </c:pt>
                <c:pt idx="6">
                  <c:v>cg22555495</c:v>
                </c:pt>
                <c:pt idx="7">
                  <c:v>cg01614564</c:v>
                </c:pt>
                <c:pt idx="8">
                  <c:v>cg13073261</c:v>
                </c:pt>
              </c:strCache>
            </c:strRef>
          </c:cat>
          <c:val>
            <c:numRef>
              <c:f>revise_data!$O$227:$O$235</c:f>
              <c:numCache>
                <c:formatCode>General</c:formatCode>
                <c:ptCount val="9"/>
                <c:pt idx="0">
                  <c:v>0.49415705</c:v>
                </c:pt>
                <c:pt idx="1">
                  <c:v>0.42349865</c:v>
                </c:pt>
                <c:pt idx="2">
                  <c:v>0.29584225</c:v>
                </c:pt>
                <c:pt idx="3">
                  <c:v>0.46157535</c:v>
                </c:pt>
                <c:pt idx="4">
                  <c:v>0.38508365</c:v>
                </c:pt>
                <c:pt idx="5">
                  <c:v>0.22705415</c:v>
                </c:pt>
                <c:pt idx="6">
                  <c:v>0.2633036</c:v>
                </c:pt>
                <c:pt idx="7">
                  <c:v>0.38525445</c:v>
                </c:pt>
                <c:pt idx="8">
                  <c:v>0.3333435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85226216"/>
        <c:axId val="-2085220648"/>
      </c:lineChart>
      <c:catAx>
        <c:axId val="-2085226216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085220648"/>
        <c:crosses val="autoZero"/>
        <c:auto val="1"/>
        <c:lblAlgn val="ctr"/>
        <c:lblOffset val="100"/>
        <c:noMultiLvlLbl val="0"/>
      </c:catAx>
      <c:valAx>
        <c:axId val="-2085220648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cross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085226216"/>
        <c:crosses val="autoZero"/>
        <c:crossBetween val="between"/>
        <c:majorUnit val="0.5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618015188757367"/>
          <c:y val="0.145430555555556"/>
          <c:w val="0.917331886785013"/>
          <c:h val="0.605477891156462"/>
        </c:manualLayout>
      </c:layout>
      <c:lineChart>
        <c:grouping val="standard"/>
        <c:varyColors val="0"/>
        <c:ser>
          <c:idx val="0"/>
          <c:order val="0"/>
          <c:tx>
            <c:strRef>
              <c:f>revise_data!$F$237</c:f>
              <c:strCache>
                <c:ptCount val="1"/>
                <c:pt idx="0">
                  <c:v>BS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round/>
            </a:ln>
            <a:effectLst/>
          </c:spPr>
          <c:marker>
            <c:symbol val="triangle"/>
            <c:size val="6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F$238:$F$279</c:f>
              <c:numCache>
                <c:formatCode>General</c:formatCode>
                <c:ptCount val="42"/>
                <c:pt idx="0">
                  <c:v>0.66935765</c:v>
                </c:pt>
                <c:pt idx="1">
                  <c:v>0.5965856</c:v>
                </c:pt>
                <c:pt idx="2">
                  <c:v>0.59361225</c:v>
                </c:pt>
                <c:pt idx="3">
                  <c:v>0.56254035</c:v>
                </c:pt>
                <c:pt idx="4">
                  <c:v>0.52705675</c:v>
                </c:pt>
                <c:pt idx="5">
                  <c:v>0.56460725</c:v>
                </c:pt>
                <c:pt idx="6">
                  <c:v>0.3387063</c:v>
                </c:pt>
                <c:pt idx="7">
                  <c:v>0.31084365</c:v>
                </c:pt>
                <c:pt idx="8">
                  <c:v>0.29208725</c:v>
                </c:pt>
                <c:pt idx="9">
                  <c:v>0.1834801</c:v>
                </c:pt>
                <c:pt idx="10">
                  <c:v>0.22884485</c:v>
                </c:pt>
                <c:pt idx="11">
                  <c:v>0.2791563</c:v>
                </c:pt>
                <c:pt idx="12">
                  <c:v>0.2809678</c:v>
                </c:pt>
                <c:pt idx="13">
                  <c:v>0.1270871</c:v>
                </c:pt>
                <c:pt idx="14">
                  <c:v>0.2162917</c:v>
                </c:pt>
                <c:pt idx="15">
                  <c:v>0.2150665</c:v>
                </c:pt>
                <c:pt idx="16">
                  <c:v>0.18380785</c:v>
                </c:pt>
                <c:pt idx="17">
                  <c:v>0.24536015</c:v>
                </c:pt>
                <c:pt idx="18">
                  <c:v>0.425619</c:v>
                </c:pt>
                <c:pt idx="19">
                  <c:v>0.14294255</c:v>
                </c:pt>
                <c:pt idx="20">
                  <c:v>0.4480058</c:v>
                </c:pt>
                <c:pt idx="21">
                  <c:v>0.24939595</c:v>
                </c:pt>
                <c:pt idx="22">
                  <c:v>0.3032197</c:v>
                </c:pt>
                <c:pt idx="23">
                  <c:v>0.32690455</c:v>
                </c:pt>
                <c:pt idx="24">
                  <c:v>0.4018737</c:v>
                </c:pt>
                <c:pt idx="25">
                  <c:v>0.3766476</c:v>
                </c:pt>
                <c:pt idx="26">
                  <c:v>0.25400735</c:v>
                </c:pt>
                <c:pt idx="27">
                  <c:v>0.13892815</c:v>
                </c:pt>
                <c:pt idx="28">
                  <c:v>0.1314355</c:v>
                </c:pt>
                <c:pt idx="29">
                  <c:v>0.081798815</c:v>
                </c:pt>
                <c:pt idx="30">
                  <c:v>0.1838831</c:v>
                </c:pt>
                <c:pt idx="31">
                  <c:v>0.11276905</c:v>
                </c:pt>
                <c:pt idx="32">
                  <c:v>0.33335975</c:v>
                </c:pt>
                <c:pt idx="33">
                  <c:v>0.30498405</c:v>
                </c:pt>
                <c:pt idx="34">
                  <c:v>0.3648321</c:v>
                </c:pt>
                <c:pt idx="35">
                  <c:v>0.39264975</c:v>
                </c:pt>
                <c:pt idx="36">
                  <c:v>0.45245045</c:v>
                </c:pt>
                <c:pt idx="37">
                  <c:v>0.17693005</c:v>
                </c:pt>
                <c:pt idx="38">
                  <c:v>0.27765945</c:v>
                </c:pt>
                <c:pt idx="39">
                  <c:v>0.1772241</c:v>
                </c:pt>
                <c:pt idx="40">
                  <c:v>0.1874663</c:v>
                </c:pt>
                <c:pt idx="41">
                  <c:v>0.270278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revise_data!$G$237</c:f>
              <c:strCache>
                <c:ptCount val="1"/>
                <c:pt idx="0">
                  <c:v>OX_pool</c:v>
                </c:pt>
              </c:strCache>
            </c:strRef>
          </c:tx>
          <c:spPr>
            <a:ln w="28575" cap="rnd">
              <a:solidFill>
                <a:srgbClr val="92D050"/>
              </a:solidFill>
              <a:prstDash val="sysDot"/>
              <a:round/>
            </a:ln>
            <a:effectLst/>
          </c:spPr>
          <c:marker>
            <c:symbol val="triangle"/>
            <c:size val="6"/>
            <c:spPr>
              <a:solidFill>
                <a:schemeClr val="bg1"/>
              </a:solidFill>
              <a:ln w="9525">
                <a:solidFill>
                  <a:srgbClr val="92D050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G$238:$G$279</c:f>
              <c:numCache>
                <c:formatCode>General</c:formatCode>
                <c:ptCount val="42"/>
                <c:pt idx="0">
                  <c:v>0.62886475</c:v>
                </c:pt>
                <c:pt idx="1">
                  <c:v>0.562727</c:v>
                </c:pt>
                <c:pt idx="2">
                  <c:v>0.59465265</c:v>
                </c:pt>
                <c:pt idx="3">
                  <c:v>0.6027856</c:v>
                </c:pt>
                <c:pt idx="4">
                  <c:v>0.55807645</c:v>
                </c:pt>
                <c:pt idx="5">
                  <c:v>0.59128445</c:v>
                </c:pt>
                <c:pt idx="6">
                  <c:v>0.3668603</c:v>
                </c:pt>
                <c:pt idx="7">
                  <c:v>0.33158915</c:v>
                </c:pt>
                <c:pt idx="8">
                  <c:v>0.2808056</c:v>
                </c:pt>
                <c:pt idx="9">
                  <c:v>0.176751</c:v>
                </c:pt>
                <c:pt idx="10">
                  <c:v>0.2174359</c:v>
                </c:pt>
                <c:pt idx="11">
                  <c:v>0.2484908</c:v>
                </c:pt>
                <c:pt idx="12">
                  <c:v>0.24503895</c:v>
                </c:pt>
                <c:pt idx="13">
                  <c:v>0.065346735</c:v>
                </c:pt>
                <c:pt idx="14">
                  <c:v>0.14995595</c:v>
                </c:pt>
                <c:pt idx="15">
                  <c:v>0.15745625</c:v>
                </c:pt>
                <c:pt idx="16">
                  <c:v>0.14131735</c:v>
                </c:pt>
                <c:pt idx="17">
                  <c:v>0.19120015</c:v>
                </c:pt>
                <c:pt idx="18">
                  <c:v>0.36942075</c:v>
                </c:pt>
                <c:pt idx="19">
                  <c:v>0.089100845</c:v>
                </c:pt>
                <c:pt idx="20">
                  <c:v>0.3742144</c:v>
                </c:pt>
                <c:pt idx="21">
                  <c:v>0.19174355</c:v>
                </c:pt>
                <c:pt idx="22">
                  <c:v>0.23514095</c:v>
                </c:pt>
                <c:pt idx="23">
                  <c:v>0.2292998</c:v>
                </c:pt>
                <c:pt idx="24">
                  <c:v>0.28589165</c:v>
                </c:pt>
                <c:pt idx="25">
                  <c:v>0.26068875</c:v>
                </c:pt>
                <c:pt idx="26">
                  <c:v>0.1572841</c:v>
                </c:pt>
                <c:pt idx="27">
                  <c:v>0.098368955</c:v>
                </c:pt>
                <c:pt idx="28">
                  <c:v>0.105327605</c:v>
                </c:pt>
                <c:pt idx="29">
                  <c:v>0.06722009</c:v>
                </c:pt>
                <c:pt idx="30">
                  <c:v>0.1348898</c:v>
                </c:pt>
                <c:pt idx="31">
                  <c:v>0.080096305</c:v>
                </c:pt>
                <c:pt idx="32">
                  <c:v>0.30057485</c:v>
                </c:pt>
                <c:pt idx="33">
                  <c:v>0.3033924</c:v>
                </c:pt>
                <c:pt idx="34">
                  <c:v>0.3816886</c:v>
                </c:pt>
                <c:pt idx="35">
                  <c:v>0.3364512</c:v>
                </c:pt>
                <c:pt idx="36">
                  <c:v>0.33250785</c:v>
                </c:pt>
                <c:pt idx="37">
                  <c:v>0.1280736</c:v>
                </c:pt>
                <c:pt idx="38">
                  <c:v>0.2087127</c:v>
                </c:pt>
                <c:pt idx="39">
                  <c:v>0.1327976</c:v>
                </c:pt>
                <c:pt idx="40">
                  <c:v>0.14946125</c:v>
                </c:pt>
                <c:pt idx="41">
                  <c:v>0.2843060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revise_data!$H$237</c:f>
              <c:strCache>
                <c:ptCount val="1"/>
                <c:pt idx="0">
                  <c:v>BS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accent1">
                  <a:lumMod val="50000"/>
                </a:schemeClr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H$238:$H$279</c:f>
              <c:numCache>
                <c:formatCode>General</c:formatCode>
                <c:ptCount val="42"/>
                <c:pt idx="0">
                  <c:v>0.6956882</c:v>
                </c:pt>
                <c:pt idx="1">
                  <c:v>0.6704036</c:v>
                </c:pt>
                <c:pt idx="2">
                  <c:v>0.65201215</c:v>
                </c:pt>
                <c:pt idx="3">
                  <c:v>0.6212972</c:v>
                </c:pt>
                <c:pt idx="4">
                  <c:v>0.5568667</c:v>
                </c:pt>
                <c:pt idx="5">
                  <c:v>0.61732135</c:v>
                </c:pt>
                <c:pt idx="6">
                  <c:v>0.36517395</c:v>
                </c:pt>
                <c:pt idx="7">
                  <c:v>0.34084185</c:v>
                </c:pt>
                <c:pt idx="8">
                  <c:v>0.26244555</c:v>
                </c:pt>
                <c:pt idx="9">
                  <c:v>0.1880064</c:v>
                </c:pt>
                <c:pt idx="10">
                  <c:v>0.2064906</c:v>
                </c:pt>
                <c:pt idx="11">
                  <c:v>0.2640236</c:v>
                </c:pt>
                <c:pt idx="12">
                  <c:v>0.26261945</c:v>
                </c:pt>
                <c:pt idx="13">
                  <c:v>0.14994005</c:v>
                </c:pt>
                <c:pt idx="14">
                  <c:v>0.2063202</c:v>
                </c:pt>
                <c:pt idx="15">
                  <c:v>0.23658625</c:v>
                </c:pt>
                <c:pt idx="16">
                  <c:v>0.20531565</c:v>
                </c:pt>
                <c:pt idx="17">
                  <c:v>0.25826125</c:v>
                </c:pt>
                <c:pt idx="18">
                  <c:v>0.3839909</c:v>
                </c:pt>
                <c:pt idx="19">
                  <c:v>0.118199385</c:v>
                </c:pt>
                <c:pt idx="20">
                  <c:v>0.3971373</c:v>
                </c:pt>
                <c:pt idx="21">
                  <c:v>0.22292455</c:v>
                </c:pt>
                <c:pt idx="22">
                  <c:v>0.27431465</c:v>
                </c:pt>
                <c:pt idx="23">
                  <c:v>0.28846055</c:v>
                </c:pt>
                <c:pt idx="24">
                  <c:v>0.35811535</c:v>
                </c:pt>
                <c:pt idx="25">
                  <c:v>0.3211288</c:v>
                </c:pt>
                <c:pt idx="26">
                  <c:v>0.21179925</c:v>
                </c:pt>
                <c:pt idx="27">
                  <c:v>0.12029095</c:v>
                </c:pt>
                <c:pt idx="28">
                  <c:v>0.1344501</c:v>
                </c:pt>
                <c:pt idx="29">
                  <c:v>0.01949848</c:v>
                </c:pt>
                <c:pt idx="30">
                  <c:v>0.1749306</c:v>
                </c:pt>
                <c:pt idx="31">
                  <c:v>0.13183905</c:v>
                </c:pt>
                <c:pt idx="32">
                  <c:v>0.3279281</c:v>
                </c:pt>
                <c:pt idx="33">
                  <c:v>0.24755205</c:v>
                </c:pt>
                <c:pt idx="34">
                  <c:v>0.3239994</c:v>
                </c:pt>
                <c:pt idx="35">
                  <c:v>0.35227395</c:v>
                </c:pt>
                <c:pt idx="36">
                  <c:v>0.3921015</c:v>
                </c:pt>
                <c:pt idx="37">
                  <c:v>0.1553901</c:v>
                </c:pt>
                <c:pt idx="38">
                  <c:v>0.26022095</c:v>
                </c:pt>
                <c:pt idx="39">
                  <c:v>0.16900945</c:v>
                </c:pt>
                <c:pt idx="40">
                  <c:v>0.19941325</c:v>
                </c:pt>
                <c:pt idx="41">
                  <c:v>0.2679753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revise_data!$I$237</c:f>
              <c:strCache>
                <c:ptCount val="1"/>
                <c:pt idx="0">
                  <c:v>OX_869</c:v>
                </c:pt>
              </c:strCache>
            </c:strRef>
          </c:tx>
          <c:spPr>
            <a:ln w="28575" cap="rnd">
              <a:solidFill>
                <a:schemeClr val="accent1">
                  <a:lumMod val="50000"/>
                </a:schemeClr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chemeClr val="accent1">
                    <a:lumMod val="50000"/>
                  </a:schemeClr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I$238:$I$279</c:f>
              <c:numCache>
                <c:formatCode>General</c:formatCode>
                <c:ptCount val="42"/>
                <c:pt idx="0">
                  <c:v>0.6315896</c:v>
                </c:pt>
                <c:pt idx="1">
                  <c:v>0.63050985</c:v>
                </c:pt>
                <c:pt idx="2">
                  <c:v>0.65917095</c:v>
                </c:pt>
                <c:pt idx="3">
                  <c:v>0.5796841</c:v>
                </c:pt>
                <c:pt idx="4">
                  <c:v>0.623247</c:v>
                </c:pt>
                <c:pt idx="5">
                  <c:v>0.5975834</c:v>
                </c:pt>
                <c:pt idx="6">
                  <c:v>0.31369805</c:v>
                </c:pt>
                <c:pt idx="7">
                  <c:v>0.3523018</c:v>
                </c:pt>
                <c:pt idx="8">
                  <c:v>0.2319633</c:v>
                </c:pt>
                <c:pt idx="9">
                  <c:v>0.2110519</c:v>
                </c:pt>
                <c:pt idx="10">
                  <c:v>0.24588965</c:v>
                </c:pt>
                <c:pt idx="11">
                  <c:v>0.2597082</c:v>
                </c:pt>
                <c:pt idx="12">
                  <c:v>0.26654165</c:v>
                </c:pt>
                <c:pt idx="13">
                  <c:v>0.1393314</c:v>
                </c:pt>
                <c:pt idx="14">
                  <c:v>0.2349214</c:v>
                </c:pt>
                <c:pt idx="15">
                  <c:v>0.22414405</c:v>
                </c:pt>
                <c:pt idx="16">
                  <c:v>0.2042448</c:v>
                </c:pt>
                <c:pt idx="17">
                  <c:v>0.18871575</c:v>
                </c:pt>
                <c:pt idx="18">
                  <c:v>0.38877795</c:v>
                </c:pt>
                <c:pt idx="19">
                  <c:v>0.0983248</c:v>
                </c:pt>
                <c:pt idx="20">
                  <c:v>0.3929151</c:v>
                </c:pt>
                <c:pt idx="21">
                  <c:v>0.19532675</c:v>
                </c:pt>
                <c:pt idx="22">
                  <c:v>0.2693483</c:v>
                </c:pt>
                <c:pt idx="23">
                  <c:v>0.31186885</c:v>
                </c:pt>
                <c:pt idx="24">
                  <c:v>0.37689375</c:v>
                </c:pt>
                <c:pt idx="25">
                  <c:v>0.36420205</c:v>
                </c:pt>
                <c:pt idx="26">
                  <c:v>0.2085708</c:v>
                </c:pt>
                <c:pt idx="27">
                  <c:v>0.112077175</c:v>
                </c:pt>
                <c:pt idx="28">
                  <c:v>0.09934571</c:v>
                </c:pt>
                <c:pt idx="29">
                  <c:v>0.033788545</c:v>
                </c:pt>
                <c:pt idx="30">
                  <c:v>0.14143295</c:v>
                </c:pt>
                <c:pt idx="31">
                  <c:v>0.06992821</c:v>
                </c:pt>
                <c:pt idx="32">
                  <c:v>0.3423615</c:v>
                </c:pt>
                <c:pt idx="33">
                  <c:v>0.2357965</c:v>
                </c:pt>
                <c:pt idx="34">
                  <c:v>0.3765101</c:v>
                </c:pt>
                <c:pt idx="35">
                  <c:v>0.3674257</c:v>
                </c:pt>
                <c:pt idx="36">
                  <c:v>0.42764905</c:v>
                </c:pt>
                <c:pt idx="37">
                  <c:v>0.1232785</c:v>
                </c:pt>
                <c:pt idx="38">
                  <c:v>0.2251105</c:v>
                </c:pt>
                <c:pt idx="39">
                  <c:v>0.13927325</c:v>
                </c:pt>
                <c:pt idx="40">
                  <c:v>0.165499</c:v>
                </c:pt>
                <c:pt idx="41">
                  <c:v>0.3073101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revise_data!$J$237</c:f>
              <c:strCache>
                <c:ptCount val="1"/>
                <c:pt idx="0">
                  <c:v>BS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olid"/>
              <a:round/>
            </a:ln>
            <a:effectLst/>
          </c:spPr>
          <c:marker>
            <c:symbol val="circle"/>
            <c:size val="6"/>
            <c:spPr>
              <a:solidFill>
                <a:srgbClr val="0066CC"/>
              </a:solidFill>
              <a:ln w="9525">
                <a:solidFill>
                  <a:srgbClr val="0066CC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J$238:$J$279</c:f>
              <c:numCache>
                <c:formatCode>General</c:formatCode>
                <c:ptCount val="42"/>
                <c:pt idx="0">
                  <c:v>0.68250995</c:v>
                </c:pt>
                <c:pt idx="1">
                  <c:v>0.58816805</c:v>
                </c:pt>
                <c:pt idx="2">
                  <c:v>0.65657445</c:v>
                </c:pt>
                <c:pt idx="3">
                  <c:v>0.5423674</c:v>
                </c:pt>
                <c:pt idx="4">
                  <c:v>0.5800849</c:v>
                </c:pt>
                <c:pt idx="5">
                  <c:v>0.5896358</c:v>
                </c:pt>
                <c:pt idx="6">
                  <c:v>0.40945665</c:v>
                </c:pt>
                <c:pt idx="7">
                  <c:v>0.3781298</c:v>
                </c:pt>
                <c:pt idx="8">
                  <c:v>0.33578385</c:v>
                </c:pt>
                <c:pt idx="9">
                  <c:v>0.19527875</c:v>
                </c:pt>
                <c:pt idx="10">
                  <c:v>0.2665863</c:v>
                </c:pt>
                <c:pt idx="11">
                  <c:v>0.29070265</c:v>
                </c:pt>
                <c:pt idx="12">
                  <c:v>0.27753955</c:v>
                </c:pt>
                <c:pt idx="13">
                  <c:v>0.09440804</c:v>
                </c:pt>
                <c:pt idx="14">
                  <c:v>0.1830992</c:v>
                </c:pt>
                <c:pt idx="15">
                  <c:v>0.159450445</c:v>
                </c:pt>
                <c:pt idx="16">
                  <c:v>0.19570645</c:v>
                </c:pt>
                <c:pt idx="17">
                  <c:v>0.2027842</c:v>
                </c:pt>
                <c:pt idx="18">
                  <c:v>0.4160066</c:v>
                </c:pt>
                <c:pt idx="19">
                  <c:v>0.1261907</c:v>
                </c:pt>
                <c:pt idx="20">
                  <c:v>0.42526905</c:v>
                </c:pt>
                <c:pt idx="21">
                  <c:v>0.226045</c:v>
                </c:pt>
                <c:pt idx="22">
                  <c:v>0.284167</c:v>
                </c:pt>
                <c:pt idx="23">
                  <c:v>0.30814055</c:v>
                </c:pt>
                <c:pt idx="24">
                  <c:v>0.37618895</c:v>
                </c:pt>
                <c:pt idx="25">
                  <c:v>0.3369006</c:v>
                </c:pt>
                <c:pt idx="26">
                  <c:v>0.19100975</c:v>
                </c:pt>
                <c:pt idx="27">
                  <c:v>0.12845995</c:v>
                </c:pt>
                <c:pt idx="28">
                  <c:v>0.13642775</c:v>
                </c:pt>
                <c:pt idx="29">
                  <c:v>0.12971104</c:v>
                </c:pt>
                <c:pt idx="30">
                  <c:v>0.19200675</c:v>
                </c:pt>
                <c:pt idx="31">
                  <c:v>0.10610499</c:v>
                </c:pt>
                <c:pt idx="32">
                  <c:v>0.3287527</c:v>
                </c:pt>
                <c:pt idx="33">
                  <c:v>0.29850395</c:v>
                </c:pt>
                <c:pt idx="34">
                  <c:v>0.3828097</c:v>
                </c:pt>
                <c:pt idx="35">
                  <c:v>0.3749225</c:v>
                </c:pt>
                <c:pt idx="36">
                  <c:v>0.42564185</c:v>
                </c:pt>
                <c:pt idx="37">
                  <c:v>0.15010225</c:v>
                </c:pt>
                <c:pt idx="38">
                  <c:v>0.25311455</c:v>
                </c:pt>
                <c:pt idx="39">
                  <c:v>0.1489635</c:v>
                </c:pt>
                <c:pt idx="40">
                  <c:v>0.17715485</c:v>
                </c:pt>
                <c:pt idx="41">
                  <c:v>0.2724475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revise_data!$K$237</c:f>
              <c:strCache>
                <c:ptCount val="1"/>
                <c:pt idx="0">
                  <c:v>OX_3410</c:v>
                </c:pt>
              </c:strCache>
            </c:strRef>
          </c:tx>
          <c:spPr>
            <a:ln w="28575" cap="rnd">
              <a:solidFill>
                <a:srgbClr val="0066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0066CC">
                    <a:alpha val="95000"/>
                  </a:srgbClr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K$238:$K$279</c:f>
              <c:numCache>
                <c:formatCode>General</c:formatCode>
                <c:ptCount val="42"/>
                <c:pt idx="0">
                  <c:v>0.68100895</c:v>
                </c:pt>
                <c:pt idx="1">
                  <c:v>0.65981405</c:v>
                </c:pt>
                <c:pt idx="2">
                  <c:v>0.6525322</c:v>
                </c:pt>
                <c:pt idx="3">
                  <c:v>0.56703835</c:v>
                </c:pt>
                <c:pt idx="4">
                  <c:v>0.58156775</c:v>
                </c:pt>
                <c:pt idx="5">
                  <c:v>0.61646255</c:v>
                </c:pt>
                <c:pt idx="6">
                  <c:v>0.383386</c:v>
                </c:pt>
                <c:pt idx="7">
                  <c:v>0.31915675</c:v>
                </c:pt>
                <c:pt idx="8">
                  <c:v>0.30280865</c:v>
                </c:pt>
                <c:pt idx="9">
                  <c:v>0.21548935</c:v>
                </c:pt>
                <c:pt idx="10">
                  <c:v>0.23055495</c:v>
                </c:pt>
                <c:pt idx="11">
                  <c:v>0.25851435</c:v>
                </c:pt>
                <c:pt idx="12">
                  <c:v>0.25341445</c:v>
                </c:pt>
                <c:pt idx="13">
                  <c:v>0.044463595</c:v>
                </c:pt>
                <c:pt idx="14">
                  <c:v>0.1537156</c:v>
                </c:pt>
                <c:pt idx="15">
                  <c:v>0.1539711</c:v>
                </c:pt>
                <c:pt idx="16">
                  <c:v>0.16397805</c:v>
                </c:pt>
                <c:pt idx="17">
                  <c:v>0.17005145</c:v>
                </c:pt>
                <c:pt idx="18">
                  <c:v>0.4001869</c:v>
                </c:pt>
                <c:pt idx="19">
                  <c:v>0.09802944</c:v>
                </c:pt>
                <c:pt idx="20">
                  <c:v>0.38737875</c:v>
                </c:pt>
                <c:pt idx="21">
                  <c:v>0.1560863</c:v>
                </c:pt>
                <c:pt idx="22">
                  <c:v>0.2083168</c:v>
                </c:pt>
                <c:pt idx="23">
                  <c:v>0.29937855</c:v>
                </c:pt>
                <c:pt idx="24">
                  <c:v>0.34484835</c:v>
                </c:pt>
                <c:pt idx="25">
                  <c:v>0.3066026</c:v>
                </c:pt>
                <c:pt idx="26">
                  <c:v>0.18388705</c:v>
                </c:pt>
                <c:pt idx="27">
                  <c:v>0.107353135</c:v>
                </c:pt>
                <c:pt idx="28">
                  <c:v>0.08968672</c:v>
                </c:pt>
                <c:pt idx="29">
                  <c:v>0.12783014</c:v>
                </c:pt>
                <c:pt idx="30">
                  <c:v>0.14466645</c:v>
                </c:pt>
                <c:pt idx="31">
                  <c:v>0.080530665</c:v>
                </c:pt>
                <c:pt idx="32">
                  <c:v>0.24783825</c:v>
                </c:pt>
                <c:pt idx="33">
                  <c:v>0.23615965</c:v>
                </c:pt>
                <c:pt idx="34">
                  <c:v>0.38522845</c:v>
                </c:pt>
                <c:pt idx="35">
                  <c:v>0.32998445</c:v>
                </c:pt>
                <c:pt idx="36">
                  <c:v>0.3461874</c:v>
                </c:pt>
                <c:pt idx="37">
                  <c:v>0.094204785</c:v>
                </c:pt>
                <c:pt idx="38">
                  <c:v>0.16810105</c:v>
                </c:pt>
                <c:pt idx="39">
                  <c:v>0.10055602</c:v>
                </c:pt>
                <c:pt idx="40">
                  <c:v>0.14058025</c:v>
                </c:pt>
                <c:pt idx="41">
                  <c:v>0.22799725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revise_data!$L$237</c:f>
              <c:strCache>
                <c:ptCount val="1"/>
                <c:pt idx="0">
                  <c:v>BS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olid"/>
              <a:round/>
            </a:ln>
            <a:effectLst/>
          </c:spPr>
          <c:marker>
            <c:symbol val="circle"/>
            <c:size val="6"/>
            <c:spPr>
              <a:solidFill>
                <a:srgbClr val="33CCCC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L$238:$L$279</c:f>
              <c:numCache>
                <c:formatCode>General</c:formatCode>
                <c:ptCount val="42"/>
                <c:pt idx="0">
                  <c:v>0.6816542</c:v>
                </c:pt>
                <c:pt idx="1">
                  <c:v>0.66129905</c:v>
                </c:pt>
                <c:pt idx="2">
                  <c:v>0.7238729</c:v>
                </c:pt>
                <c:pt idx="3">
                  <c:v>0.61658095</c:v>
                </c:pt>
                <c:pt idx="4">
                  <c:v>0.60804985</c:v>
                </c:pt>
                <c:pt idx="5">
                  <c:v>0.62383845</c:v>
                </c:pt>
                <c:pt idx="6">
                  <c:v>0.3440766</c:v>
                </c:pt>
                <c:pt idx="7">
                  <c:v>0.39108915</c:v>
                </c:pt>
                <c:pt idx="8">
                  <c:v>0.3221281</c:v>
                </c:pt>
                <c:pt idx="9">
                  <c:v>0.2442257</c:v>
                </c:pt>
                <c:pt idx="10">
                  <c:v>0.2782246</c:v>
                </c:pt>
                <c:pt idx="11">
                  <c:v>0.24864205</c:v>
                </c:pt>
                <c:pt idx="12">
                  <c:v>0.25442105</c:v>
                </c:pt>
                <c:pt idx="13">
                  <c:v>0.1374202</c:v>
                </c:pt>
                <c:pt idx="14">
                  <c:v>0.19978845</c:v>
                </c:pt>
                <c:pt idx="15">
                  <c:v>0.22610215</c:v>
                </c:pt>
                <c:pt idx="16">
                  <c:v>0.20628785</c:v>
                </c:pt>
                <c:pt idx="17">
                  <c:v>0.2133349</c:v>
                </c:pt>
                <c:pt idx="18">
                  <c:v>0.38654475</c:v>
                </c:pt>
                <c:pt idx="19">
                  <c:v>0.111079555</c:v>
                </c:pt>
                <c:pt idx="20">
                  <c:v>0.4025998</c:v>
                </c:pt>
                <c:pt idx="21">
                  <c:v>0.2358505</c:v>
                </c:pt>
                <c:pt idx="22">
                  <c:v>0.30011555</c:v>
                </c:pt>
                <c:pt idx="23">
                  <c:v>0.2988905</c:v>
                </c:pt>
                <c:pt idx="24">
                  <c:v>0.4043946</c:v>
                </c:pt>
                <c:pt idx="25">
                  <c:v>0.39048065</c:v>
                </c:pt>
                <c:pt idx="26">
                  <c:v>0.24164905</c:v>
                </c:pt>
                <c:pt idx="27">
                  <c:v>0.13433393</c:v>
                </c:pt>
                <c:pt idx="28">
                  <c:v>0.132646245</c:v>
                </c:pt>
                <c:pt idx="29">
                  <c:v>0.08185904</c:v>
                </c:pt>
                <c:pt idx="30">
                  <c:v>0.18688875</c:v>
                </c:pt>
                <c:pt idx="31">
                  <c:v>0.099754905</c:v>
                </c:pt>
                <c:pt idx="32">
                  <c:v>0.3397789</c:v>
                </c:pt>
                <c:pt idx="33">
                  <c:v>0.27602575</c:v>
                </c:pt>
                <c:pt idx="34">
                  <c:v>0.32091005</c:v>
                </c:pt>
                <c:pt idx="35">
                  <c:v>0.40982055</c:v>
                </c:pt>
                <c:pt idx="36">
                  <c:v>0.453951</c:v>
                </c:pt>
                <c:pt idx="37">
                  <c:v>0.1508205</c:v>
                </c:pt>
                <c:pt idx="38">
                  <c:v>0.26763805</c:v>
                </c:pt>
                <c:pt idx="39">
                  <c:v>0.1836927</c:v>
                </c:pt>
                <c:pt idx="40">
                  <c:v>0.2032041</c:v>
                </c:pt>
                <c:pt idx="41">
                  <c:v>0.2766414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revise_data!$M$237</c:f>
              <c:strCache>
                <c:ptCount val="1"/>
                <c:pt idx="0">
                  <c:v>OX_5152</c:v>
                </c:pt>
              </c:strCache>
            </c:strRef>
          </c:tx>
          <c:spPr>
            <a:ln w="28575" cap="rnd">
              <a:solidFill>
                <a:srgbClr val="33CCCC"/>
              </a:solidFill>
              <a:prstDash val="sysDot"/>
              <a:round/>
            </a:ln>
            <a:effectLst/>
          </c:spPr>
          <c:marker>
            <c:symbol val="circle"/>
            <c:size val="6"/>
            <c:spPr>
              <a:solidFill>
                <a:schemeClr val="bg1"/>
              </a:solidFill>
              <a:ln w="9525">
                <a:solidFill>
                  <a:srgbClr val="33CCCC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M$238:$M$279</c:f>
              <c:numCache>
                <c:formatCode>General</c:formatCode>
                <c:ptCount val="42"/>
                <c:pt idx="0">
                  <c:v>0.69528685</c:v>
                </c:pt>
                <c:pt idx="1">
                  <c:v>0.66619095</c:v>
                </c:pt>
                <c:pt idx="2">
                  <c:v>0.664359</c:v>
                </c:pt>
                <c:pt idx="3">
                  <c:v>0.5905547</c:v>
                </c:pt>
                <c:pt idx="4">
                  <c:v>0.6077006</c:v>
                </c:pt>
                <c:pt idx="5">
                  <c:v>0.62736135</c:v>
                </c:pt>
                <c:pt idx="6">
                  <c:v>0.3937213</c:v>
                </c:pt>
                <c:pt idx="7">
                  <c:v>0.39065265</c:v>
                </c:pt>
                <c:pt idx="8">
                  <c:v>0.37537365</c:v>
                </c:pt>
                <c:pt idx="9">
                  <c:v>0.24511915</c:v>
                </c:pt>
                <c:pt idx="10">
                  <c:v>0.3307141</c:v>
                </c:pt>
                <c:pt idx="11">
                  <c:v>0.28550775</c:v>
                </c:pt>
                <c:pt idx="12">
                  <c:v>0.2919761</c:v>
                </c:pt>
                <c:pt idx="13">
                  <c:v>0.11560772</c:v>
                </c:pt>
                <c:pt idx="14">
                  <c:v>0.18398995</c:v>
                </c:pt>
                <c:pt idx="15">
                  <c:v>0.2536639</c:v>
                </c:pt>
                <c:pt idx="16">
                  <c:v>0.2224621</c:v>
                </c:pt>
                <c:pt idx="17">
                  <c:v>0.24695525</c:v>
                </c:pt>
                <c:pt idx="18">
                  <c:v>0.3979916</c:v>
                </c:pt>
                <c:pt idx="19">
                  <c:v>0.124223875</c:v>
                </c:pt>
                <c:pt idx="20">
                  <c:v>0.4203196</c:v>
                </c:pt>
                <c:pt idx="21">
                  <c:v>0.2229412</c:v>
                </c:pt>
                <c:pt idx="22">
                  <c:v>0.2972343</c:v>
                </c:pt>
                <c:pt idx="23">
                  <c:v>0.2853973</c:v>
                </c:pt>
                <c:pt idx="24">
                  <c:v>0.3606524</c:v>
                </c:pt>
                <c:pt idx="25">
                  <c:v>0.32233315</c:v>
                </c:pt>
                <c:pt idx="26">
                  <c:v>0.23107675</c:v>
                </c:pt>
                <c:pt idx="27">
                  <c:v>0.135812</c:v>
                </c:pt>
                <c:pt idx="28">
                  <c:v>0.13922225</c:v>
                </c:pt>
                <c:pt idx="29">
                  <c:v>0.081721495</c:v>
                </c:pt>
                <c:pt idx="30">
                  <c:v>0.16847005</c:v>
                </c:pt>
                <c:pt idx="31">
                  <c:v>0.106856555</c:v>
                </c:pt>
                <c:pt idx="32">
                  <c:v>0.34065375</c:v>
                </c:pt>
                <c:pt idx="33">
                  <c:v>0.25284605</c:v>
                </c:pt>
                <c:pt idx="34">
                  <c:v>0.3803125</c:v>
                </c:pt>
                <c:pt idx="35">
                  <c:v>0.34217375</c:v>
                </c:pt>
                <c:pt idx="36">
                  <c:v>0.3813427</c:v>
                </c:pt>
                <c:pt idx="37">
                  <c:v>0.1325026</c:v>
                </c:pt>
                <c:pt idx="38">
                  <c:v>0.25989255</c:v>
                </c:pt>
                <c:pt idx="39">
                  <c:v>0.1730088</c:v>
                </c:pt>
                <c:pt idx="40">
                  <c:v>0.20163065</c:v>
                </c:pt>
                <c:pt idx="41">
                  <c:v>0.24685855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revise_data!$N$237</c:f>
              <c:strCache>
                <c:ptCount val="1"/>
                <c:pt idx="0">
                  <c:v>BS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olid"/>
              <a:round/>
            </a:ln>
            <a:effectLst/>
          </c:spPr>
          <c:marker>
            <c:symbol val="square"/>
            <c:size val="6"/>
            <c:spPr>
              <a:solidFill>
                <a:srgbClr val="FF9999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N$238:$N$279</c:f>
              <c:numCache>
                <c:formatCode>General</c:formatCode>
                <c:ptCount val="42"/>
                <c:pt idx="0">
                  <c:v>0.72358475</c:v>
                </c:pt>
                <c:pt idx="1">
                  <c:v>0.67217215</c:v>
                </c:pt>
                <c:pt idx="2">
                  <c:v>0.6054223</c:v>
                </c:pt>
                <c:pt idx="3">
                  <c:v>0.6242592</c:v>
                </c:pt>
                <c:pt idx="4">
                  <c:v>0.65738635</c:v>
                </c:pt>
                <c:pt idx="5">
                  <c:v>0.62234975</c:v>
                </c:pt>
                <c:pt idx="6">
                  <c:v>0.3838903</c:v>
                </c:pt>
                <c:pt idx="7">
                  <c:v>0.4557482</c:v>
                </c:pt>
                <c:pt idx="8">
                  <c:v>0.3422619</c:v>
                </c:pt>
                <c:pt idx="9">
                  <c:v>0.35214415</c:v>
                </c:pt>
                <c:pt idx="10">
                  <c:v>0.4188016</c:v>
                </c:pt>
                <c:pt idx="11">
                  <c:v>0.25518295</c:v>
                </c:pt>
                <c:pt idx="12">
                  <c:v>0.2659216</c:v>
                </c:pt>
                <c:pt idx="13">
                  <c:v>0.16792318</c:v>
                </c:pt>
                <c:pt idx="14">
                  <c:v>0.2455619</c:v>
                </c:pt>
                <c:pt idx="15">
                  <c:v>0.3045279</c:v>
                </c:pt>
                <c:pt idx="16">
                  <c:v>0.2720377</c:v>
                </c:pt>
                <c:pt idx="17">
                  <c:v>0.2280059</c:v>
                </c:pt>
                <c:pt idx="18">
                  <c:v>0.3579089</c:v>
                </c:pt>
                <c:pt idx="19">
                  <c:v>0.07929321</c:v>
                </c:pt>
                <c:pt idx="20">
                  <c:v>0.331316</c:v>
                </c:pt>
                <c:pt idx="21">
                  <c:v>0.1401104</c:v>
                </c:pt>
                <c:pt idx="22">
                  <c:v>0.2100195</c:v>
                </c:pt>
                <c:pt idx="23">
                  <c:v>0.2200218</c:v>
                </c:pt>
                <c:pt idx="24">
                  <c:v>0.26544775</c:v>
                </c:pt>
                <c:pt idx="25">
                  <c:v>0.24091025</c:v>
                </c:pt>
                <c:pt idx="26">
                  <c:v>0.1376626</c:v>
                </c:pt>
                <c:pt idx="27">
                  <c:v>0.09187119</c:v>
                </c:pt>
                <c:pt idx="28">
                  <c:v>0.06483409</c:v>
                </c:pt>
                <c:pt idx="29">
                  <c:v>0.046807275</c:v>
                </c:pt>
                <c:pt idx="30">
                  <c:v>0.1269522</c:v>
                </c:pt>
                <c:pt idx="31">
                  <c:v>0.045719225</c:v>
                </c:pt>
                <c:pt idx="32">
                  <c:v>0.1585782</c:v>
                </c:pt>
                <c:pt idx="33">
                  <c:v>0.30068005</c:v>
                </c:pt>
                <c:pt idx="34">
                  <c:v>0.3671968</c:v>
                </c:pt>
                <c:pt idx="35">
                  <c:v>0.34133635</c:v>
                </c:pt>
                <c:pt idx="36">
                  <c:v>0.33317035</c:v>
                </c:pt>
                <c:pt idx="37">
                  <c:v>0.07571932</c:v>
                </c:pt>
                <c:pt idx="38">
                  <c:v>0.138367</c:v>
                </c:pt>
                <c:pt idx="39">
                  <c:v>0.09965518</c:v>
                </c:pt>
                <c:pt idx="40">
                  <c:v>0.1172664</c:v>
                </c:pt>
                <c:pt idx="41">
                  <c:v>0.18747445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revise_data!$O$237</c:f>
              <c:strCache>
                <c:ptCount val="1"/>
                <c:pt idx="0">
                  <c:v>OX_Brain</c:v>
                </c:pt>
              </c:strCache>
            </c:strRef>
          </c:tx>
          <c:spPr>
            <a:ln w="28575" cap="rnd">
              <a:solidFill>
                <a:srgbClr val="FF9999"/>
              </a:solidFill>
              <a:prstDash val="sysDot"/>
              <a:round/>
            </a:ln>
            <a:effectLst/>
          </c:spPr>
          <c:marker>
            <c:symbol val="square"/>
            <c:size val="6"/>
            <c:spPr>
              <a:solidFill>
                <a:schemeClr val="bg1"/>
              </a:solidFill>
              <a:ln w="9525">
                <a:solidFill>
                  <a:srgbClr val="FF9999"/>
                </a:solidFill>
              </a:ln>
              <a:effectLst/>
            </c:spPr>
          </c:marker>
          <c:cat>
            <c:strRef>
              <c:f>revise_data!$E$238:$E$279</c:f>
              <c:strCache>
                <c:ptCount val="42"/>
                <c:pt idx="0">
                  <c:v>cg22741626</c:v>
                </c:pt>
                <c:pt idx="1">
                  <c:v>cg18997188</c:v>
                </c:pt>
                <c:pt idx="2">
                  <c:v>cg20213508</c:v>
                </c:pt>
                <c:pt idx="3">
                  <c:v>cg26791489</c:v>
                </c:pt>
                <c:pt idx="4">
                  <c:v>cg04779428</c:v>
                </c:pt>
                <c:pt idx="5">
                  <c:v>cg04019914</c:v>
                </c:pt>
                <c:pt idx="6">
                  <c:v>cg11357538</c:v>
                </c:pt>
                <c:pt idx="7">
                  <c:v>cg20008140</c:v>
                </c:pt>
                <c:pt idx="8">
                  <c:v>cg11480267</c:v>
                </c:pt>
                <c:pt idx="9">
                  <c:v>cg10011623</c:v>
                </c:pt>
                <c:pt idx="10">
                  <c:v>cg01748573</c:v>
                </c:pt>
                <c:pt idx="11">
                  <c:v>cg17334845</c:v>
                </c:pt>
                <c:pt idx="12">
                  <c:v>cg26767990</c:v>
                </c:pt>
                <c:pt idx="13">
                  <c:v>cg17652507</c:v>
                </c:pt>
                <c:pt idx="14">
                  <c:v>cg22407822</c:v>
                </c:pt>
                <c:pt idx="15">
                  <c:v>cg07341934</c:v>
                </c:pt>
                <c:pt idx="16">
                  <c:v>cg02107718</c:v>
                </c:pt>
                <c:pt idx="17">
                  <c:v>cg23496597</c:v>
                </c:pt>
                <c:pt idx="18">
                  <c:v>cg25308079</c:v>
                </c:pt>
                <c:pt idx="19">
                  <c:v>cg03014008</c:v>
                </c:pt>
                <c:pt idx="20">
                  <c:v>cg09772382</c:v>
                </c:pt>
                <c:pt idx="21">
                  <c:v>cg15222215</c:v>
                </c:pt>
                <c:pt idx="22">
                  <c:v>cg14263118</c:v>
                </c:pt>
                <c:pt idx="23">
                  <c:v>cg11244758</c:v>
                </c:pt>
                <c:pt idx="24">
                  <c:v>cg18160880</c:v>
                </c:pt>
                <c:pt idx="25">
                  <c:v>cg05926269</c:v>
                </c:pt>
                <c:pt idx="26">
                  <c:v>cg03821543</c:v>
                </c:pt>
                <c:pt idx="27">
                  <c:v>cg01538522</c:v>
                </c:pt>
                <c:pt idx="28">
                  <c:v>cg00267746</c:v>
                </c:pt>
                <c:pt idx="29">
                  <c:v>cg09885502</c:v>
                </c:pt>
                <c:pt idx="30">
                  <c:v>cg03837903</c:v>
                </c:pt>
                <c:pt idx="31">
                  <c:v>cg23159236</c:v>
                </c:pt>
                <c:pt idx="32">
                  <c:v>cg22798925</c:v>
                </c:pt>
                <c:pt idx="33">
                  <c:v>cg20126878</c:v>
                </c:pt>
                <c:pt idx="34">
                  <c:v>cg27027803</c:v>
                </c:pt>
                <c:pt idx="35">
                  <c:v>cg08997444</c:v>
                </c:pt>
                <c:pt idx="36">
                  <c:v>cg22639787</c:v>
                </c:pt>
                <c:pt idx="37">
                  <c:v>cg05960039</c:v>
                </c:pt>
                <c:pt idx="38">
                  <c:v>cg09604333</c:v>
                </c:pt>
                <c:pt idx="39">
                  <c:v>cg06047881</c:v>
                </c:pt>
                <c:pt idx="40">
                  <c:v>cg20018057</c:v>
                </c:pt>
                <c:pt idx="41">
                  <c:v>cg10748817</c:v>
                </c:pt>
              </c:strCache>
            </c:strRef>
          </c:cat>
          <c:val>
            <c:numRef>
              <c:f>revise_data!$O$238:$O$279</c:f>
              <c:numCache>
                <c:formatCode>General</c:formatCode>
                <c:ptCount val="42"/>
                <c:pt idx="0">
                  <c:v>0.6008402</c:v>
                </c:pt>
                <c:pt idx="1">
                  <c:v>0.61507335</c:v>
                </c:pt>
                <c:pt idx="2">
                  <c:v>0.534837</c:v>
                </c:pt>
                <c:pt idx="3">
                  <c:v>0.61042155</c:v>
                </c:pt>
                <c:pt idx="4">
                  <c:v>0.56589545</c:v>
                </c:pt>
                <c:pt idx="5">
                  <c:v>0.50004055</c:v>
                </c:pt>
                <c:pt idx="6">
                  <c:v>0.26815305</c:v>
                </c:pt>
                <c:pt idx="7">
                  <c:v>0.24421575</c:v>
                </c:pt>
                <c:pt idx="8">
                  <c:v>0.2274686</c:v>
                </c:pt>
                <c:pt idx="9">
                  <c:v>0.13675185</c:v>
                </c:pt>
                <c:pt idx="10">
                  <c:v>0.19118415</c:v>
                </c:pt>
                <c:pt idx="11">
                  <c:v>0.17736635</c:v>
                </c:pt>
                <c:pt idx="12">
                  <c:v>0.18696585</c:v>
                </c:pt>
                <c:pt idx="13">
                  <c:v>0.062157925</c:v>
                </c:pt>
                <c:pt idx="14">
                  <c:v>0.123034425</c:v>
                </c:pt>
                <c:pt idx="15">
                  <c:v>0.1765891</c:v>
                </c:pt>
                <c:pt idx="16">
                  <c:v>0.1995589</c:v>
                </c:pt>
                <c:pt idx="17">
                  <c:v>0.1518685</c:v>
                </c:pt>
                <c:pt idx="18">
                  <c:v>0.3008599</c:v>
                </c:pt>
                <c:pt idx="19">
                  <c:v>0.073249775</c:v>
                </c:pt>
                <c:pt idx="20">
                  <c:v>0.2558189</c:v>
                </c:pt>
                <c:pt idx="21">
                  <c:v>0.153324</c:v>
                </c:pt>
                <c:pt idx="22">
                  <c:v>0.2050542</c:v>
                </c:pt>
                <c:pt idx="23">
                  <c:v>0.17462725</c:v>
                </c:pt>
                <c:pt idx="24">
                  <c:v>0.2020459</c:v>
                </c:pt>
                <c:pt idx="25">
                  <c:v>0.1678482</c:v>
                </c:pt>
                <c:pt idx="26">
                  <c:v>0.13413835</c:v>
                </c:pt>
                <c:pt idx="27">
                  <c:v>0.08003209</c:v>
                </c:pt>
                <c:pt idx="28">
                  <c:v>0.076456975</c:v>
                </c:pt>
                <c:pt idx="29">
                  <c:v>0.08233027</c:v>
                </c:pt>
                <c:pt idx="30">
                  <c:v>0.11502463</c:v>
                </c:pt>
                <c:pt idx="31">
                  <c:v>0.039054375</c:v>
                </c:pt>
                <c:pt idx="32">
                  <c:v>0.15987135</c:v>
                </c:pt>
                <c:pt idx="33">
                  <c:v>0.14537615</c:v>
                </c:pt>
                <c:pt idx="34">
                  <c:v>0.08692119</c:v>
                </c:pt>
                <c:pt idx="35">
                  <c:v>0.16766035</c:v>
                </c:pt>
                <c:pt idx="36">
                  <c:v>0.1217586</c:v>
                </c:pt>
                <c:pt idx="37">
                  <c:v>0.025110385</c:v>
                </c:pt>
                <c:pt idx="38">
                  <c:v>0.060521735</c:v>
                </c:pt>
                <c:pt idx="39">
                  <c:v>0.062022415</c:v>
                </c:pt>
                <c:pt idx="40">
                  <c:v>0.04840305</c:v>
                </c:pt>
                <c:pt idx="41">
                  <c:v>0.186058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23771608"/>
        <c:axId val="-2123585960"/>
      </c:lineChart>
      <c:catAx>
        <c:axId val="-2123771608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23585960"/>
        <c:crosses val="autoZero"/>
        <c:auto val="1"/>
        <c:lblAlgn val="ctr"/>
        <c:lblOffset val="100"/>
        <c:noMultiLvlLbl val="0"/>
      </c:catAx>
      <c:valAx>
        <c:axId val="-2123585960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bg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cross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2123771608"/>
        <c:crosses val="autoZero"/>
        <c:crossBetween val="between"/>
        <c:majorUnit val="0.5"/>
        <c:minorUnit val="0.5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4C555A-39F1-E24E-A459-771CB92356FE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BADD9A-6E41-3947-B5BF-9B2A38DCE6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39348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DE2FDF-F3EC-914C-8ABF-FA6BA5B7B20A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8D06E3-FD99-7A44-BFD2-E5961084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7943938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8D06E3-FD99-7A44-BFD2-E5961084978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45795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C38DA6-B982-194D-B7FC-F7C2022CCC8E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212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94D3C-B788-6C4D-917E-4E55D25B8599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897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81385-ECA6-6646-9BB7-5C776D370BAF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0548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F8C70-6002-9A43-AD92-05A9C018D66E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298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B7EE8-899F-CF41-875B-4BB57B8EE17E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95825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8F1FD5-2B91-6440-A837-ACA32FFE5057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3224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9FA4C-F57B-BC4F-8818-F26366CBF6E7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5018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30597-BADF-9842-B6D8-BDE2C7786143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3431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213751-00DE-2643-ACF8-9FA216583C87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9790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93F86C-512D-634F-A54E-B1F26F3FC616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745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86B5C-EF91-0F49-8490-723F27D0A72A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628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773DD-DF56-E04B-A16D-359D9A2FA7E6}" type="datetime1">
              <a:rPr kumimoji="1" lang="ja-JP" altLang="en-US" smtClean="0"/>
              <a:t>15/07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3A828-0F9A-4AF5-B5F6-6F21210DFD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5014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8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4460131"/>
              </p:ext>
            </p:extLst>
          </p:nvPr>
        </p:nvGraphicFramePr>
        <p:xfrm>
          <a:off x="1638024" y="1643178"/>
          <a:ext cx="6587972" cy="41317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1656937" y="1628819"/>
            <a:ext cx="370884" cy="260422"/>
          </a:xfrm>
          <a:prstGeom prst="rect">
            <a:avLst/>
          </a:prstGeom>
          <a:solidFill>
            <a:schemeClr val="bg1"/>
          </a:solidFill>
        </p:spPr>
        <p:txBody>
          <a:bodyPr wrap="none" lIns="91423" tIns="45712" rIns="91423" bIns="45712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656937" y="2700750"/>
            <a:ext cx="370884" cy="260422"/>
          </a:xfrm>
          <a:prstGeom prst="rect">
            <a:avLst/>
          </a:prstGeom>
          <a:solidFill>
            <a:schemeClr val="bg1"/>
          </a:solidFill>
        </p:spPr>
        <p:txBody>
          <a:bodyPr wrap="none" lIns="91423" tIns="45712" rIns="91423" bIns="45712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647993" y="3760506"/>
            <a:ext cx="394747" cy="260422"/>
          </a:xfrm>
          <a:prstGeom prst="rect">
            <a:avLst/>
          </a:prstGeom>
          <a:solidFill>
            <a:schemeClr val="bg1"/>
          </a:solidFill>
        </p:spPr>
        <p:txBody>
          <a:bodyPr wrap="square" lIns="91423" tIns="45712" rIns="91423" bIns="45712" rtlCol="0">
            <a:spAutoFit/>
          </a:bodyPr>
          <a:lstStyle/>
          <a:p>
            <a:pPr algn="r"/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765035" y="2586913"/>
            <a:ext cx="1618211" cy="292372"/>
          </a:xfrm>
          <a:prstGeom prst="rect">
            <a:avLst/>
          </a:prstGeom>
          <a:noFill/>
        </p:spPr>
        <p:txBody>
          <a:bodyPr wrap="none" lIns="91423" tIns="45712" rIns="91423" bIns="45712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Average </a:t>
            </a:r>
            <a:r>
              <a:rPr lang="en-US" altLang="ja-JP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beta </a:t>
            </a:r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endParaRPr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グループ化 9"/>
          <p:cNvGrpSpPr/>
          <p:nvPr/>
        </p:nvGrpSpPr>
        <p:grpSpPr>
          <a:xfrm>
            <a:off x="3283479" y="4959841"/>
            <a:ext cx="3366061" cy="818982"/>
            <a:chOff x="3241114" y="4459374"/>
            <a:chExt cx="3366061" cy="818982"/>
          </a:xfrm>
        </p:grpSpPr>
        <p:grpSp>
          <p:nvGrpSpPr>
            <p:cNvPr id="11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3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8" name="直線コネクタ 47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" name="円/楕円 48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6" name="直線コネクタ 4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円/楕円 4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4" name="直線コネクタ 4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円/楕円 4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2" name="直線コネクタ 41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二等辺三角形 42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7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40" name="直線コネクタ 39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正方形/長方形 40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8" name="テキスト ボックス 17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8" name="直線コネクタ 37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円/楕円 38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0" name="テキスト ボックス 19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6" name="直線コネクタ 3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円/楕円 3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2" name="テキスト ボックス 21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4" name="直線コネクタ 33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二等辺三角形 34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4" name="テキスト ボックス 23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5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2" name="直線コネクタ 31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正方形/長方形 32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6" name="テキスト ボックス 25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7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0" name="直線コネクタ 29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円/楕円 30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8" name="テキスト ボックス 27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正方形/長方形 28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2" name="テキスト ボックス 11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テキスト ボックス 49"/>
          <p:cNvSpPr txBox="1"/>
          <p:nvPr/>
        </p:nvSpPr>
        <p:spPr>
          <a:xfrm>
            <a:off x="217612" y="364842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4162484" y="377542"/>
            <a:ext cx="15810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G3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23850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/>
          <p:cNvGrpSpPr/>
          <p:nvPr/>
        </p:nvGrpSpPr>
        <p:grpSpPr>
          <a:xfrm>
            <a:off x="2745382" y="1344681"/>
            <a:ext cx="4047811" cy="3579155"/>
            <a:chOff x="2916832" y="1611381"/>
            <a:chExt cx="4047811" cy="3579155"/>
          </a:xfrm>
        </p:grpSpPr>
        <p:graphicFrame>
          <p:nvGraphicFramePr>
            <p:cNvPr id="2" name="グラフ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6164185"/>
                </p:ext>
              </p:extLst>
            </p:nvPr>
          </p:nvGraphicFramePr>
          <p:xfrm>
            <a:off x="3103844" y="1611381"/>
            <a:ext cx="3860799" cy="35791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テキスト ボックス 2"/>
            <p:cNvSpPr txBox="1"/>
            <p:nvPr/>
          </p:nvSpPr>
          <p:spPr>
            <a:xfrm>
              <a:off x="3145814" y="1928231"/>
              <a:ext cx="370884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3145814" y="3000162"/>
              <a:ext cx="370884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3136870" y="4076200"/>
              <a:ext cx="394747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91423" tIns="45712" rIns="91423" bIns="45712" rtlCol="0">
              <a:spAutoFit/>
            </a:bodyPr>
            <a:lstStyle/>
            <a:p>
              <a:pPr algn="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 rot="16200000">
              <a:off x="2253912" y="2886325"/>
              <a:ext cx="1618211" cy="292372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Average </a:t>
              </a:r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/>
          <p:cNvGrpSpPr/>
          <p:nvPr/>
        </p:nvGrpSpPr>
        <p:grpSpPr>
          <a:xfrm>
            <a:off x="3345248" y="5022122"/>
            <a:ext cx="3366061" cy="818982"/>
            <a:chOff x="3241114" y="4459374"/>
            <a:chExt cx="3366061" cy="818982"/>
          </a:xfrm>
        </p:grpSpPr>
        <p:grpSp>
          <p:nvGrpSpPr>
            <p:cNvPr id="9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1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6" name="直線コネクタ 4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円/楕円 4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2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4" name="直線コネクタ 4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円/楕円 4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2" name="直線コネクタ 41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円/楕円 42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0" name="直線コネクタ 39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二等辺三角形 40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8" name="直線コネクタ 37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正方形/長方形 38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6" name="テキスト ボックス 15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6" name="直線コネクタ 3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円/楕円 3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8" name="テキスト ボックス 17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4" name="直線コネクタ 3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円/楕円 3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0" name="テキスト ボックス 19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2" name="直線コネクタ 31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二等辺三角形 32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2" name="テキスト ボックス 21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0" name="直線コネクタ 29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正方形/長方形 30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4" name="テキスト ボックス 23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5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8" name="直線コネクタ 27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円/楕円 28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6" name="テキスト ボックス 25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正方形/長方形 26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" name="テキスト ボックス 9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テキスト ボックス 47"/>
          <p:cNvSpPr txBox="1"/>
          <p:nvPr/>
        </p:nvSpPr>
        <p:spPr>
          <a:xfrm>
            <a:off x="217612" y="377542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162484" y="390242"/>
            <a:ext cx="18795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LAGL1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4734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47"/>
          <p:cNvGrpSpPr/>
          <p:nvPr/>
        </p:nvGrpSpPr>
        <p:grpSpPr>
          <a:xfrm>
            <a:off x="79681" y="1465704"/>
            <a:ext cx="9687767" cy="3443976"/>
            <a:chOff x="78938" y="1609630"/>
            <a:chExt cx="9687767" cy="3443976"/>
          </a:xfrm>
        </p:grpSpPr>
        <p:graphicFrame>
          <p:nvGraphicFramePr>
            <p:cNvPr id="2" name="グラフ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9704712"/>
                </p:ext>
              </p:extLst>
            </p:nvPr>
          </p:nvGraphicFramePr>
          <p:xfrm>
            <a:off x="275756" y="1609630"/>
            <a:ext cx="9490949" cy="34439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3" name="グループ化 2"/>
            <p:cNvGrpSpPr/>
            <p:nvPr/>
          </p:nvGrpSpPr>
          <p:grpSpPr>
            <a:xfrm>
              <a:off x="78938" y="1925015"/>
              <a:ext cx="551447" cy="2392109"/>
              <a:chOff x="-1132490" y="2382862"/>
              <a:chExt cx="621302" cy="2392109"/>
            </a:xfrm>
            <a:scene3d>
              <a:camera prst="orthographicFront">
                <a:rot lat="0" lon="0" rev="0"/>
              </a:camera>
              <a:lightRig rig="threePt" dir="t"/>
            </a:scene3d>
          </p:grpSpPr>
          <p:sp>
            <p:nvSpPr>
              <p:cNvPr id="4" name="テキスト ボックス 3"/>
              <p:cNvSpPr txBox="1"/>
              <p:nvPr/>
            </p:nvSpPr>
            <p:spPr>
              <a:xfrm>
                <a:off x="-901080" y="2382862"/>
                <a:ext cx="374815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テキスト ボックス 4"/>
              <p:cNvSpPr txBox="1"/>
              <p:nvPr/>
            </p:nvSpPr>
            <p:spPr>
              <a:xfrm>
                <a:off x="-901080" y="3446652"/>
                <a:ext cx="374815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-910119" y="4514549"/>
                <a:ext cx="398931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91423" tIns="45712" rIns="91423" bIns="45712" rtlCol="0">
                <a:spAutoFit/>
              </a:bodyPr>
              <a:lstStyle/>
              <a:p>
                <a:pPr algn="r"/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 rot="16200000">
                <a:off x="-1793860" y="3355689"/>
                <a:ext cx="1618211" cy="295471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Average </a:t>
                </a:r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ta 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value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" name="グループ化 7"/>
          <p:cNvGrpSpPr/>
          <p:nvPr/>
        </p:nvGrpSpPr>
        <p:grpSpPr>
          <a:xfrm>
            <a:off x="3345248" y="5022122"/>
            <a:ext cx="3366061" cy="818982"/>
            <a:chOff x="3241114" y="4459374"/>
            <a:chExt cx="3366061" cy="818982"/>
          </a:xfrm>
        </p:grpSpPr>
        <p:grpSp>
          <p:nvGrpSpPr>
            <p:cNvPr id="9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1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6" name="直線コネクタ 4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円/楕円 4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2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4" name="直線コネクタ 4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円/楕円 4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2" name="直線コネクタ 41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円/楕円 42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0" name="直線コネクタ 39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二等辺三角形 40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8" name="直線コネクタ 37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正方形/長方形 38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6" name="テキスト ボックス 15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6" name="直線コネクタ 3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円/楕円 3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8" name="テキスト ボックス 17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4" name="直線コネクタ 3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円/楕円 3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0" name="テキスト ボックス 19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2" name="直線コネクタ 31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二等辺三角形 32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2" name="テキスト ボックス 21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0" name="直線コネクタ 29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正方形/長方形 30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4" name="テキスト ボックス 23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5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8" name="直線コネクタ 27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円/楕円 28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6" name="テキスト ボックス 25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正方形/長方形 26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" name="テキスト ボックス 9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/>
          <p:cNvSpPr txBox="1"/>
          <p:nvPr/>
        </p:nvSpPr>
        <p:spPr>
          <a:xfrm>
            <a:off x="217612" y="377542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162484" y="390242"/>
            <a:ext cx="16946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EG10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79771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0" y="1464501"/>
            <a:ext cx="9853912" cy="3420000"/>
            <a:chOff x="-2776707" y="1553163"/>
            <a:chExt cx="9853912" cy="3420000"/>
          </a:xfrm>
        </p:grpSpPr>
        <p:graphicFrame>
          <p:nvGraphicFramePr>
            <p:cNvPr id="3" name="グラフ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96087158"/>
                </p:ext>
              </p:extLst>
            </p:nvPr>
          </p:nvGraphicFramePr>
          <p:xfrm>
            <a:off x="-2578598" y="1553163"/>
            <a:ext cx="9655803" cy="34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4" name="グループ化 3"/>
            <p:cNvGrpSpPr/>
            <p:nvPr/>
          </p:nvGrpSpPr>
          <p:grpSpPr>
            <a:xfrm>
              <a:off x="-2776707" y="1883003"/>
              <a:ext cx="614785" cy="2465378"/>
              <a:chOff x="393378" y="5074316"/>
              <a:chExt cx="614785" cy="2465378"/>
            </a:xfrm>
          </p:grpSpPr>
          <p:sp>
            <p:nvSpPr>
              <p:cNvPr id="5" name="テキスト ボックス 4"/>
              <p:cNvSpPr txBox="1"/>
              <p:nvPr/>
            </p:nvSpPr>
            <p:spPr>
              <a:xfrm>
                <a:off x="622360" y="5074316"/>
                <a:ext cx="370884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622360" y="6162529"/>
                <a:ext cx="370884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613416" y="7279272"/>
                <a:ext cx="394747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91423" tIns="45712" rIns="91423" bIns="45712" rtlCol="0">
                <a:spAutoFit/>
              </a:bodyPr>
              <a:lstStyle/>
              <a:p>
                <a:pPr algn="r"/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 rot="16200000">
                <a:off x="-269542" y="6048692"/>
                <a:ext cx="1618211" cy="292372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Average </a:t>
                </a:r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ta 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value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グループ化 8"/>
          <p:cNvGrpSpPr/>
          <p:nvPr/>
        </p:nvGrpSpPr>
        <p:grpSpPr>
          <a:xfrm>
            <a:off x="3269969" y="5013981"/>
            <a:ext cx="3366061" cy="818982"/>
            <a:chOff x="3241114" y="4459374"/>
            <a:chExt cx="3366061" cy="818982"/>
          </a:xfrm>
        </p:grpSpPr>
        <p:grpSp>
          <p:nvGrpSpPr>
            <p:cNvPr id="10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2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7" name="直線コネクタ 46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円/楕円 47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5" name="直線コネクタ 44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円/楕円 45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3" name="直線コネクタ 42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円/楕円 43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1" name="直線コネクタ 40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二等辺三角形 41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9" name="直線コネクタ 38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正方形/長方形 39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7" name="テキスト ボックス 16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8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7" name="直線コネクタ 36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円/楕円 37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9" name="テキスト ボックス 18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5" name="直線コネクタ 34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円/楕円 35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1" name="テキスト ボックス 20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3" name="直線コネクタ 32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二等辺三角形 33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3" name="テキスト ボックス 22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1" name="直線コネクタ 30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正方形/長方形 31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5" name="テキスト ボックス 24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9" name="直線コネクタ 28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円/楕円 29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7" name="テキスト ボックス 26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正方形/長方形 27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1" name="テキスト ボックス 10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/>
          <p:cNvSpPr txBox="1"/>
          <p:nvPr/>
        </p:nvSpPr>
        <p:spPr>
          <a:xfrm>
            <a:off x="217612" y="377542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162484" y="390242"/>
            <a:ext cx="15802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EST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966778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11788" y="1479197"/>
            <a:ext cx="9780844" cy="3486330"/>
            <a:chOff x="-10543" y="6116917"/>
            <a:chExt cx="9672548" cy="3486330"/>
          </a:xfrm>
        </p:grpSpPr>
        <p:graphicFrame>
          <p:nvGraphicFramePr>
            <p:cNvPr id="3" name="グラフ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2916119"/>
                </p:ext>
              </p:extLst>
            </p:nvPr>
          </p:nvGraphicFramePr>
          <p:xfrm>
            <a:off x="184443" y="6116917"/>
            <a:ext cx="9477562" cy="34863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4" name="グループ化 3"/>
            <p:cNvGrpSpPr/>
            <p:nvPr/>
          </p:nvGrpSpPr>
          <p:grpSpPr>
            <a:xfrm>
              <a:off x="-10543" y="6472953"/>
              <a:ext cx="614785" cy="2392109"/>
              <a:chOff x="393378" y="5106880"/>
              <a:chExt cx="614785" cy="2392109"/>
            </a:xfrm>
          </p:grpSpPr>
          <p:sp>
            <p:nvSpPr>
              <p:cNvPr id="5" name="テキスト ボックス 4"/>
              <p:cNvSpPr txBox="1"/>
              <p:nvPr/>
            </p:nvSpPr>
            <p:spPr>
              <a:xfrm>
                <a:off x="622360" y="5106880"/>
                <a:ext cx="370884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622360" y="6162529"/>
                <a:ext cx="370884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613416" y="7238567"/>
                <a:ext cx="394747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91423" tIns="45712" rIns="91423" bIns="45712" rtlCol="0">
                <a:spAutoFit/>
              </a:bodyPr>
              <a:lstStyle/>
              <a:p>
                <a:pPr algn="r"/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 rot="16200000">
                <a:off x="-269542" y="6048692"/>
                <a:ext cx="1618211" cy="292372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Average </a:t>
                </a:r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ta 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value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グループ化 8"/>
          <p:cNvGrpSpPr/>
          <p:nvPr/>
        </p:nvGrpSpPr>
        <p:grpSpPr>
          <a:xfrm>
            <a:off x="3345248" y="5022122"/>
            <a:ext cx="3366061" cy="818982"/>
            <a:chOff x="3241114" y="4459374"/>
            <a:chExt cx="3366061" cy="818982"/>
          </a:xfrm>
        </p:grpSpPr>
        <p:grpSp>
          <p:nvGrpSpPr>
            <p:cNvPr id="10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2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7" name="直線コネクタ 46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円/楕円 47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5" name="直線コネクタ 44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円/楕円 45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3" name="直線コネクタ 42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円/楕円 43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1" name="直線コネクタ 40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二等辺三角形 41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9" name="直線コネクタ 38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正方形/長方形 39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7" name="テキスト ボックス 16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8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7" name="直線コネクタ 36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円/楕円 37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9" name="テキスト ボックス 18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5" name="直線コネクタ 34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円/楕円 35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1" name="テキスト ボックス 20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3" name="直線コネクタ 32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二等辺三角形 33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3" name="テキスト ボックス 22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1" name="直線コネクタ 30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正方形/長方形 31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5" name="テキスト ボックス 24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9" name="直線コネクタ 28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円/楕円 29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7" name="テキスト ボックス 26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正方形/長方形 27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1" name="テキスト ボックス 10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/>
          <p:cNvSpPr txBox="1"/>
          <p:nvPr/>
        </p:nvSpPr>
        <p:spPr>
          <a:xfrm>
            <a:off x="217612" y="377542"/>
            <a:ext cx="355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289484" y="390242"/>
            <a:ext cx="13382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19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85414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6318670"/>
              </p:ext>
            </p:extLst>
          </p:nvPr>
        </p:nvGraphicFramePr>
        <p:xfrm>
          <a:off x="1561813" y="1285646"/>
          <a:ext cx="6647813" cy="35367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グループ化 2"/>
          <p:cNvGrpSpPr/>
          <p:nvPr/>
        </p:nvGrpSpPr>
        <p:grpSpPr>
          <a:xfrm>
            <a:off x="1427897" y="1584431"/>
            <a:ext cx="558043" cy="2392109"/>
            <a:chOff x="-1069231" y="2415426"/>
            <a:chExt cx="558043" cy="2392109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-901080" y="2415426"/>
              <a:ext cx="374815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-901080" y="3487357"/>
              <a:ext cx="374815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-910119" y="4547113"/>
              <a:ext cx="398931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91423" tIns="45712" rIns="91423" bIns="45712" rtlCol="0">
              <a:spAutoFit/>
            </a:bodyPr>
            <a:lstStyle/>
            <a:p>
              <a:pPr algn="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 rot="16200000">
              <a:off x="-1730601" y="3355689"/>
              <a:ext cx="1618211" cy="2954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Average </a:t>
              </a:r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/>
          <p:cNvGrpSpPr/>
          <p:nvPr/>
        </p:nvGrpSpPr>
        <p:grpSpPr>
          <a:xfrm>
            <a:off x="3345248" y="5022122"/>
            <a:ext cx="3366061" cy="818982"/>
            <a:chOff x="3241114" y="4459374"/>
            <a:chExt cx="3366061" cy="818982"/>
          </a:xfrm>
        </p:grpSpPr>
        <p:grpSp>
          <p:nvGrpSpPr>
            <p:cNvPr id="9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1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6" name="直線コネクタ 4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円/楕円 4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2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4" name="直線コネクタ 4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円/楕円 4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2" name="直線コネクタ 41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円/楕円 42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0" name="直線コネクタ 39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二等辺三角形 40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8" name="直線コネクタ 37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正方形/長方形 38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6" name="テキスト ボックス 15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6" name="直線コネクタ 3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円/楕円 3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8" name="テキスト ボックス 17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4" name="直線コネクタ 3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円/楕円 3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0" name="テキスト ボックス 19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2" name="直線コネクタ 31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二等辺三角形 32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2" name="テキスト ボックス 21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0" name="直線コネクタ 29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正方形/長方形 30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4" name="テキスト ボックス 23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5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8" name="直線コネクタ 27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円/楕円 28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6" name="テキスト ボックス 25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正方形/長方形 26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" name="テキスト ボックス 9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テキスト ボックス 47"/>
          <p:cNvSpPr txBox="1"/>
          <p:nvPr/>
        </p:nvSpPr>
        <p:spPr>
          <a:xfrm>
            <a:off x="217612" y="377542"/>
            <a:ext cx="341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340284" y="390242"/>
            <a:ext cx="12243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KvDMR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0976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8865621"/>
              </p:ext>
            </p:extLst>
          </p:nvPr>
        </p:nvGraphicFramePr>
        <p:xfrm>
          <a:off x="3648445" y="1257408"/>
          <a:ext cx="2393949" cy="363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グループ化 2"/>
          <p:cNvGrpSpPr/>
          <p:nvPr/>
        </p:nvGrpSpPr>
        <p:grpSpPr>
          <a:xfrm>
            <a:off x="3450528" y="1641690"/>
            <a:ext cx="621302" cy="2392109"/>
            <a:chOff x="-1132490" y="2415426"/>
            <a:chExt cx="621302" cy="2392109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-901080" y="2415426"/>
              <a:ext cx="374815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-901080" y="3487357"/>
              <a:ext cx="374815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-910119" y="4547113"/>
              <a:ext cx="398931" cy="2604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91423" tIns="45712" rIns="91423" bIns="45712" rtlCol="0">
              <a:spAutoFit/>
            </a:bodyPr>
            <a:lstStyle/>
            <a:p>
              <a:pPr algn="r"/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 rot="16200000">
              <a:off x="-1793860" y="3355689"/>
              <a:ext cx="1618211" cy="29547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Average </a:t>
              </a:r>
              <a:r>
                <a:rPr lang="en-US" altLang="ja-JP" sz="13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ta </a:t>
              </a:r>
              <a:r>
                <a:rPr lang="en-US" altLang="ja-JP" sz="1300" dirty="0">
                  <a:latin typeface="Arial" panose="020B0604020202020204" pitchFamily="34" charset="0"/>
                  <a:cs typeface="Arial" panose="020B0604020202020204" pitchFamily="34" charset="0"/>
                </a:rPr>
                <a:t>value</a:t>
              </a:r>
              <a:endParaRPr lang="ja-JP" altLang="en-US" sz="13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/>
          <p:cNvGrpSpPr/>
          <p:nvPr/>
        </p:nvGrpSpPr>
        <p:grpSpPr>
          <a:xfrm>
            <a:off x="3345248" y="5022122"/>
            <a:ext cx="3366061" cy="818982"/>
            <a:chOff x="3241114" y="4459374"/>
            <a:chExt cx="3366061" cy="818982"/>
          </a:xfrm>
        </p:grpSpPr>
        <p:grpSp>
          <p:nvGrpSpPr>
            <p:cNvPr id="9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1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6" name="直線コネクタ 4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" name="円/楕円 4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2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4" name="直線コネクタ 4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円/楕円 4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2" name="直線コネクタ 41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" name="円/楕円 42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0" name="直線コネクタ 39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" name="二等辺三角形 40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8" name="直線コネクタ 37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正方形/長方形 38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6" name="テキスト ボックス 15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6" name="直線コネクタ 35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" name="円/楕円 36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8" name="テキスト ボックス 17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4" name="直線コネクタ 33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円/楕円 34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0" name="テキスト ボックス 19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2" name="直線コネクタ 31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二等辺三角形 32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2" name="テキスト ボックス 21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3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0" name="直線コネクタ 29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正方形/長方形 30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4" name="テキスト ボックス 23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5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8" name="直線コネクタ 27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円/楕円 28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6" name="テキスト ボックス 25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正方形/長方形 26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0" name="テキスト ボックス 9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テキスト ボックス 47"/>
          <p:cNvSpPr txBox="1"/>
          <p:nvPr/>
        </p:nvSpPr>
        <p:spPr>
          <a:xfrm>
            <a:off x="217612" y="377542"/>
            <a:ext cx="3841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077011" y="390242"/>
            <a:ext cx="17519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NRPN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334697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834940" y="1365503"/>
            <a:ext cx="8134539" cy="3528000"/>
            <a:chOff x="-1132490" y="2062373"/>
            <a:chExt cx="8134539" cy="3528000"/>
          </a:xfrm>
        </p:grpSpPr>
        <p:graphicFrame>
          <p:nvGraphicFramePr>
            <p:cNvPr id="3" name="グラフ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11215991"/>
                </p:ext>
              </p:extLst>
            </p:nvPr>
          </p:nvGraphicFramePr>
          <p:xfrm>
            <a:off x="-910119" y="2062373"/>
            <a:ext cx="7912168" cy="352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4" name="グループ化 3"/>
            <p:cNvGrpSpPr/>
            <p:nvPr/>
          </p:nvGrpSpPr>
          <p:grpSpPr>
            <a:xfrm>
              <a:off x="-1132490" y="2415426"/>
              <a:ext cx="621302" cy="2392109"/>
              <a:chOff x="-1132490" y="2415426"/>
              <a:chExt cx="621302" cy="2392109"/>
            </a:xfrm>
          </p:grpSpPr>
          <p:sp>
            <p:nvSpPr>
              <p:cNvPr id="5" name="テキスト ボックス 4"/>
              <p:cNvSpPr txBox="1"/>
              <p:nvPr/>
            </p:nvSpPr>
            <p:spPr>
              <a:xfrm>
                <a:off x="-901080" y="2415426"/>
                <a:ext cx="374815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-901080" y="3487357"/>
                <a:ext cx="374815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-910119" y="4547113"/>
                <a:ext cx="398931" cy="26042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91423" tIns="45712" rIns="91423" bIns="45712" rtlCol="0">
                <a:spAutoFit/>
              </a:bodyPr>
              <a:lstStyle/>
              <a:p>
                <a:pPr algn="r"/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 rot="16200000">
                <a:off x="-1793860" y="3355689"/>
                <a:ext cx="1618211" cy="295471"/>
              </a:xfrm>
              <a:prstGeom prst="rect">
                <a:avLst/>
              </a:prstGeom>
              <a:noFill/>
            </p:spPr>
            <p:txBody>
              <a:bodyPr wrap="none" lIns="91423" tIns="45712" rIns="91423" bIns="45712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Average </a:t>
                </a:r>
                <a:r>
                  <a:rPr lang="en-US" altLang="ja-JP" sz="13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eta </a:t>
                </a:r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value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グループ化 8"/>
          <p:cNvGrpSpPr/>
          <p:nvPr/>
        </p:nvGrpSpPr>
        <p:grpSpPr>
          <a:xfrm>
            <a:off x="3345248" y="5022122"/>
            <a:ext cx="3366061" cy="818982"/>
            <a:chOff x="3241114" y="4459374"/>
            <a:chExt cx="3366061" cy="818982"/>
          </a:xfrm>
        </p:grpSpPr>
        <p:grpSp>
          <p:nvGrpSpPr>
            <p:cNvPr id="10" name="グループ化 98"/>
            <p:cNvGrpSpPr/>
            <p:nvPr/>
          </p:nvGrpSpPr>
          <p:grpSpPr>
            <a:xfrm>
              <a:off x="3241114" y="4459374"/>
              <a:ext cx="3366061" cy="818982"/>
              <a:chOff x="1323058" y="4746025"/>
              <a:chExt cx="3366060" cy="818981"/>
            </a:xfrm>
          </p:grpSpPr>
          <p:grpSp>
            <p:nvGrpSpPr>
              <p:cNvPr id="12" name="グループ化 39"/>
              <p:cNvGrpSpPr/>
              <p:nvPr/>
            </p:nvGrpSpPr>
            <p:grpSpPr>
              <a:xfrm>
                <a:off x="1972801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7" name="直線コネクタ 46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円/楕円 47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" name="グループ化 45"/>
              <p:cNvGrpSpPr/>
              <p:nvPr/>
            </p:nvGrpSpPr>
            <p:grpSpPr>
              <a:xfrm>
                <a:off x="2520020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5" name="直線コネクタ 44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円/楕円 45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" name="グループ化 51"/>
              <p:cNvGrpSpPr/>
              <p:nvPr/>
            </p:nvGrpSpPr>
            <p:grpSpPr>
              <a:xfrm>
                <a:off x="3067239" y="5328491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43" name="直線コネクタ 42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" name="円/楕円 43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5" name="グループ化 62"/>
              <p:cNvGrpSpPr/>
              <p:nvPr/>
            </p:nvGrpSpPr>
            <p:grpSpPr>
              <a:xfrm>
                <a:off x="3614458" y="5328491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41" name="直線コネクタ 40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二等辺三角形 41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" name="グループ化 74"/>
              <p:cNvGrpSpPr/>
              <p:nvPr/>
            </p:nvGrpSpPr>
            <p:grpSpPr>
              <a:xfrm>
                <a:off x="4161678" y="5328491"/>
                <a:ext cx="360000" cy="72000"/>
                <a:chOff x="3954539" y="8839856"/>
                <a:chExt cx="360000" cy="72000"/>
              </a:xfrm>
            </p:grpSpPr>
            <p:cxnSp>
              <p:nvCxnSpPr>
                <p:cNvPr id="39" name="直線コネクタ 38"/>
                <p:cNvCxnSpPr/>
                <p:nvPr/>
              </p:nvCxnSpPr>
              <p:spPr>
                <a:xfrm>
                  <a:off x="3954539" y="88853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  <a:prstDash val="sysDot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" name="正方形/長方形 39"/>
                <p:cNvSpPr/>
                <p:nvPr/>
              </p:nvSpPr>
              <p:spPr>
                <a:xfrm>
                  <a:off x="4098539" y="8839856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7" name="テキスト ボックス 16"/>
              <p:cNvSpPr txBox="1"/>
              <p:nvPr/>
            </p:nvSpPr>
            <p:spPr>
              <a:xfrm>
                <a:off x="1512213" y="4936481"/>
                <a:ext cx="407058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8" name="グループ化 38"/>
              <p:cNvGrpSpPr/>
              <p:nvPr/>
            </p:nvGrpSpPr>
            <p:grpSpPr>
              <a:xfrm>
                <a:off x="1972801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7" name="直線コネクタ 36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円/楕円 37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chemeClr val="accent1">
                    <a:lumMod val="50000"/>
                  </a:schemeClr>
                </a:solidFill>
                <a:ln>
                  <a:solidFill>
                    <a:schemeClr val="accent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9" name="テキスト ボックス 18"/>
              <p:cNvSpPr txBox="1"/>
              <p:nvPr/>
            </p:nvSpPr>
            <p:spPr>
              <a:xfrm>
                <a:off x="1925817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1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" name="グループ化 48"/>
              <p:cNvGrpSpPr/>
              <p:nvPr/>
            </p:nvGrpSpPr>
            <p:grpSpPr>
              <a:xfrm>
                <a:off x="3067239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35" name="直線コネクタ 34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33CC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円/楕円 35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33CCCC"/>
                </a:solidFill>
                <a:ln>
                  <a:solidFill>
                    <a:srgbClr val="33CC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1" name="テキスト ボックス 20"/>
              <p:cNvSpPr txBox="1"/>
              <p:nvPr/>
            </p:nvSpPr>
            <p:spPr>
              <a:xfrm>
                <a:off x="3011101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3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2" name="グループ化 61"/>
              <p:cNvGrpSpPr/>
              <p:nvPr/>
            </p:nvGrpSpPr>
            <p:grpSpPr>
              <a:xfrm>
                <a:off x="3614458" y="5077132"/>
                <a:ext cx="360000" cy="72000"/>
                <a:chOff x="2066249" y="8762738"/>
                <a:chExt cx="360000" cy="72000"/>
              </a:xfrm>
            </p:grpSpPr>
            <p:cxnSp>
              <p:nvCxnSpPr>
                <p:cNvPr id="33" name="直線コネクタ 32"/>
                <p:cNvCxnSpPr/>
                <p:nvPr/>
              </p:nvCxnSpPr>
              <p:spPr>
                <a:xfrm>
                  <a:off x="2066249" y="8808263"/>
                  <a:ext cx="360000" cy="0"/>
                </a:xfrm>
                <a:prstGeom prst="line">
                  <a:avLst/>
                </a:prstGeom>
                <a:ln w="19050">
                  <a:solidFill>
                    <a:srgbClr val="92D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二等辺三角形 33"/>
                <p:cNvSpPr/>
                <p:nvPr/>
              </p:nvSpPr>
              <p:spPr>
                <a:xfrm>
                  <a:off x="2210181" y="8762738"/>
                  <a:ext cx="72000" cy="72000"/>
                </a:xfrm>
                <a:prstGeom prst="triangle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3" name="テキスト ボックス 22"/>
              <p:cNvSpPr txBox="1"/>
              <p:nvPr/>
            </p:nvSpPr>
            <p:spPr>
              <a:xfrm>
                <a:off x="3553139" y="4772919"/>
                <a:ext cx="467064" cy="2931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.</a:t>
                </a:r>
              </a:p>
              <a:p>
                <a:pPr>
                  <a:lnSpc>
                    <a:spcPct val="70000"/>
                  </a:lnSpc>
                </a:pPr>
                <a:r>
                  <a:rPr lang="en-US" altLang="ja-JP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ja-JP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4" name="グループ化 75"/>
              <p:cNvGrpSpPr/>
              <p:nvPr/>
            </p:nvGrpSpPr>
            <p:grpSpPr>
              <a:xfrm>
                <a:off x="4161678" y="5077132"/>
                <a:ext cx="360000" cy="72000"/>
                <a:chOff x="3802139" y="8687456"/>
                <a:chExt cx="360000" cy="72000"/>
              </a:xfrm>
            </p:grpSpPr>
            <p:cxnSp>
              <p:nvCxnSpPr>
                <p:cNvPr id="31" name="直線コネクタ 30"/>
                <p:cNvCxnSpPr/>
                <p:nvPr/>
              </p:nvCxnSpPr>
              <p:spPr>
                <a:xfrm>
                  <a:off x="3802139" y="8732981"/>
                  <a:ext cx="360000" cy="0"/>
                </a:xfrm>
                <a:prstGeom prst="line">
                  <a:avLst/>
                </a:prstGeom>
                <a:ln w="19050">
                  <a:solidFill>
                    <a:srgbClr val="FF9999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正方形/長方形 31"/>
                <p:cNvSpPr/>
                <p:nvPr/>
              </p:nvSpPr>
              <p:spPr>
                <a:xfrm>
                  <a:off x="3946139" y="8687456"/>
                  <a:ext cx="72000" cy="72000"/>
                </a:xfrm>
                <a:prstGeom prst="rect">
                  <a:avLst/>
                </a:prstGeom>
                <a:solidFill>
                  <a:srgbClr val="FF9999"/>
                </a:solidFill>
                <a:ln>
                  <a:solidFill>
                    <a:srgbClr val="FF9999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5" name="テキスト ボックス 24"/>
              <p:cNvSpPr txBox="1"/>
              <p:nvPr/>
            </p:nvSpPr>
            <p:spPr>
              <a:xfrm>
                <a:off x="1323058" y="5193719"/>
                <a:ext cx="583131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xBS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グループ化 42"/>
              <p:cNvGrpSpPr/>
              <p:nvPr/>
            </p:nvGrpSpPr>
            <p:grpSpPr>
              <a:xfrm>
                <a:off x="2520020" y="5077132"/>
                <a:ext cx="360000" cy="72000"/>
                <a:chOff x="1043640" y="7077075"/>
                <a:chExt cx="360000" cy="72000"/>
              </a:xfrm>
            </p:grpSpPr>
            <p:cxnSp>
              <p:nvCxnSpPr>
                <p:cNvPr id="29" name="直線コネクタ 28"/>
                <p:cNvCxnSpPr/>
                <p:nvPr/>
              </p:nvCxnSpPr>
              <p:spPr>
                <a:xfrm>
                  <a:off x="1043640" y="7113075"/>
                  <a:ext cx="360000" cy="0"/>
                </a:xfrm>
                <a:prstGeom prst="line">
                  <a:avLst/>
                </a:prstGeom>
                <a:ln w="19050">
                  <a:solidFill>
                    <a:srgbClr val="0066CC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円/楕円 29"/>
                <p:cNvSpPr/>
                <p:nvPr/>
              </p:nvSpPr>
              <p:spPr>
                <a:xfrm>
                  <a:off x="1187572" y="7077075"/>
                  <a:ext cx="72136" cy="72000"/>
                </a:xfrm>
                <a:prstGeom prst="ellipse">
                  <a:avLst/>
                </a:prstGeom>
                <a:solidFill>
                  <a:srgbClr val="0066CC"/>
                </a:solidFill>
                <a:ln>
                  <a:solidFill>
                    <a:srgbClr val="0066CC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27" name="テキスト ボックス 26"/>
              <p:cNvSpPr txBox="1"/>
              <p:nvPr/>
            </p:nvSpPr>
            <p:spPr>
              <a:xfrm>
                <a:off x="2466478" y="4746025"/>
                <a:ext cx="434897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t2</a:t>
                </a:r>
                <a:endParaRPr lang="ja-JP" altLang="en-US" sz="13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正方形/長方形 27"/>
              <p:cNvSpPr/>
              <p:nvPr/>
            </p:nvSpPr>
            <p:spPr>
              <a:xfrm>
                <a:off x="1348707" y="4751981"/>
                <a:ext cx="3340411" cy="813025"/>
              </a:xfrm>
              <a:prstGeom prst="rect">
                <a:avLst/>
              </a:prstGeom>
              <a:noFill/>
              <a:ln w="9525" cmpd="sng">
                <a:solidFill>
                  <a:srgbClr val="0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1" name="テキスト ボックス 10"/>
            <p:cNvSpPr txBox="1"/>
            <p:nvPr/>
          </p:nvSpPr>
          <p:spPr>
            <a:xfrm>
              <a:off x="6023679" y="4486270"/>
              <a:ext cx="460492" cy="293141"/>
            </a:xfrm>
            <a:prstGeom prst="rect">
              <a:avLst/>
            </a:prstGeom>
            <a:noFill/>
          </p:spPr>
          <p:txBody>
            <a:bodyPr wrap="none" lIns="91423" tIns="45712" rIns="91423" bIns="45712" rtlCol="0">
              <a:spAutoFit/>
            </a:bodyPr>
            <a:lstStyle/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.</a:t>
              </a:r>
            </a:p>
            <a:p>
              <a:pPr>
                <a:lnSpc>
                  <a:spcPct val="70000"/>
                </a:lnSpc>
              </a:pPr>
              <a:r>
                <a:rPr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brain</a:t>
              </a:r>
              <a:endParaRPr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テキスト ボックス 48"/>
          <p:cNvSpPr txBox="1"/>
          <p:nvPr/>
        </p:nvSpPr>
        <p:spPr>
          <a:xfrm>
            <a:off x="217612" y="377542"/>
            <a:ext cx="3698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616384" y="390242"/>
            <a:ext cx="2697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NAS </a:t>
            </a:r>
            <a:r>
              <a:rPr lang="en-US" altLang="ja-JP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xon A/B-DMR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46590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83930" y="2006804"/>
            <a:ext cx="9338140" cy="2831528"/>
          </a:xfrm>
          <a:prstGeom prst="rect">
            <a:avLst/>
          </a:prstGeom>
          <a:noFill/>
        </p:spPr>
        <p:txBody>
          <a:bodyPr wrap="square" lIns="91423" tIns="45712" rIns="91423" bIns="45712" rtlCol="0">
            <a:spAutoFit/>
          </a:bodyPr>
          <a:lstStyle/>
          <a:p>
            <a:r>
              <a:rPr kumimoji="1" lang="en-US" altLang="ja-JP" sz="1600" b="1" dirty="0" smtClean="0">
                <a:latin typeface="Arial"/>
                <a:cs typeface="Arial"/>
              </a:rPr>
              <a:t>Figure S4.</a:t>
            </a:r>
            <a:r>
              <a:rPr kumimoji="1" lang="ja-JP" altLang="en-US" sz="1600" b="1" dirty="0" smtClean="0">
                <a:latin typeface="Arial"/>
                <a:cs typeface="Arial"/>
              </a:rPr>
              <a:t> </a:t>
            </a:r>
            <a:r>
              <a:rPr kumimoji="1" lang="en-US" altLang="ja-JP" sz="1600" b="1" dirty="0" smtClean="0">
                <a:latin typeface="Arial"/>
                <a:cs typeface="Arial"/>
              </a:rPr>
              <a:t>Methylation/hydroxymethylation analysis at the </a:t>
            </a:r>
            <a:r>
              <a:rPr kumimoji="1" lang="en-US" altLang="ja-JP" sz="1600" b="1" i="1" dirty="0" smtClean="0">
                <a:latin typeface="Arial"/>
                <a:cs typeface="Arial"/>
              </a:rPr>
              <a:t>MEG3</a:t>
            </a:r>
            <a:r>
              <a:rPr kumimoji="1" lang="en-US" altLang="ja-JP" sz="1600" b="1" dirty="0" smtClean="0">
                <a:latin typeface="Arial"/>
                <a:cs typeface="Arial"/>
              </a:rPr>
              <a:t>-DMR (A), </a:t>
            </a:r>
            <a:r>
              <a:rPr kumimoji="1" lang="en-US" altLang="ja-JP" sz="1600" b="1" i="1" dirty="0" smtClean="0">
                <a:latin typeface="Arial"/>
                <a:cs typeface="Arial"/>
              </a:rPr>
              <a:t>PLAGL1</a:t>
            </a:r>
            <a:r>
              <a:rPr kumimoji="1" lang="en-US" altLang="ja-JP" sz="1600" b="1" dirty="0" smtClean="0">
                <a:latin typeface="Arial"/>
                <a:cs typeface="Arial"/>
              </a:rPr>
              <a:t>-DMR (B), </a:t>
            </a:r>
            <a:r>
              <a:rPr kumimoji="1" lang="en-US" altLang="ja-JP" sz="1600" b="1" i="1" dirty="0" smtClean="0">
                <a:latin typeface="Arial"/>
                <a:cs typeface="Arial"/>
              </a:rPr>
              <a:t>PEG10</a:t>
            </a:r>
            <a:r>
              <a:rPr kumimoji="1" lang="en-US" altLang="ja-JP" sz="1600" b="1" dirty="0" smtClean="0">
                <a:latin typeface="Arial"/>
                <a:cs typeface="Arial"/>
              </a:rPr>
              <a:t>-DMR (C), </a:t>
            </a:r>
            <a:r>
              <a:rPr kumimoji="1" lang="en-US" altLang="ja-JP" sz="1600" b="1" i="1" dirty="0" smtClean="0">
                <a:latin typeface="Arial"/>
                <a:cs typeface="Arial"/>
              </a:rPr>
              <a:t>MEST</a:t>
            </a:r>
            <a:r>
              <a:rPr kumimoji="1" lang="en-US" altLang="ja-JP" sz="1600" b="1" dirty="0" smtClean="0">
                <a:latin typeface="Arial"/>
                <a:cs typeface="Arial"/>
              </a:rPr>
              <a:t>-DMR (D), </a:t>
            </a:r>
            <a:r>
              <a:rPr kumimoji="1" lang="en-US" altLang="ja-JP" sz="1600" b="1" i="1" dirty="0" smtClean="0">
                <a:latin typeface="Arial"/>
                <a:cs typeface="Arial"/>
              </a:rPr>
              <a:t>H19</a:t>
            </a:r>
            <a:r>
              <a:rPr kumimoji="1" lang="en-US" altLang="ja-JP" sz="1600" b="1" dirty="0" smtClean="0">
                <a:latin typeface="Arial"/>
                <a:cs typeface="Arial"/>
              </a:rPr>
              <a:t>-DMR (E), KvDMR1 (F), </a:t>
            </a:r>
            <a:r>
              <a:rPr kumimoji="1" lang="en-US" altLang="ja-JP" sz="1600" b="1" i="1" dirty="0" smtClean="0">
                <a:latin typeface="Arial"/>
                <a:cs typeface="Arial"/>
              </a:rPr>
              <a:t>SNRPN</a:t>
            </a:r>
            <a:r>
              <a:rPr kumimoji="1" lang="en-US" altLang="ja-JP" sz="1600" b="1" dirty="0" smtClean="0">
                <a:latin typeface="Arial"/>
                <a:cs typeface="Arial"/>
              </a:rPr>
              <a:t>-DMR (G)</a:t>
            </a:r>
            <a:r>
              <a:rPr lang="en-US" altLang="ja-JP" sz="1600" b="1" dirty="0" smtClean="0">
                <a:latin typeface="Arial"/>
                <a:cs typeface="Arial"/>
              </a:rPr>
              <a:t>, and </a:t>
            </a:r>
            <a:r>
              <a:rPr lang="en-US" altLang="ja-JP" sz="1600" b="1" i="1" dirty="0">
                <a:latin typeface="Arial"/>
                <a:cs typeface="Arial"/>
              </a:rPr>
              <a:t>GNAS</a:t>
            </a:r>
            <a:r>
              <a:rPr lang="en-US" altLang="ja-JP" sz="1600" b="1" dirty="0">
                <a:latin typeface="Arial"/>
                <a:cs typeface="Arial"/>
              </a:rPr>
              <a:t> exon A/B-</a:t>
            </a:r>
            <a:r>
              <a:rPr lang="en-US" altLang="ja-JP" sz="1600" b="1" dirty="0" smtClean="0">
                <a:latin typeface="Arial"/>
                <a:cs typeface="Arial"/>
              </a:rPr>
              <a:t>DMR (H) by BS/oxBS-array</a:t>
            </a:r>
          </a:p>
          <a:p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Beta values determined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by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BS-array (solid lines) and oxBS-array (dotted lines) of probes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encompassing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each DMR.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Note </a:t>
            </a:r>
            <a:r>
              <a:rPr lang="en-US" altLang="ja-JP" sz="1600" dirty="0" err="1" smtClean="0">
                <a:solidFill>
                  <a:srgbClr val="000000"/>
                </a:solidFill>
                <a:latin typeface="Arial"/>
                <a:cs typeface="Arial"/>
              </a:rPr>
              <a:t>Δ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β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values were remarkably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subtle in the blood samples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from three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KOS14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patients (Pt1–Pt3)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and the normal control. In contrast, numerous probes had relatively high </a:t>
            </a:r>
            <a:r>
              <a:rPr lang="en-US" altLang="ja-JP" sz="1600" dirty="0" err="1" smtClean="0">
                <a:solidFill>
                  <a:srgbClr val="000000"/>
                </a:solidFill>
                <a:latin typeface="Arial"/>
                <a:cs typeface="Arial"/>
              </a:rPr>
              <a:t>Δ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β values in the brain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sample, </a:t>
            </a:r>
            <a:r>
              <a:rPr lang="en-US" altLang="ja-JP" sz="1600" dirty="0" smtClean="0">
                <a:latin typeface="Arial"/>
                <a:cs typeface="Arial"/>
              </a:rPr>
              <a:t>especially </a:t>
            </a:r>
            <a:r>
              <a:rPr lang="en-US" altLang="ja-JP" sz="1600" dirty="0">
                <a:latin typeface="Arial"/>
                <a:cs typeface="Arial"/>
              </a:rPr>
              <a:t>at the </a:t>
            </a:r>
            <a:r>
              <a:rPr lang="en-US" altLang="ja-JP" sz="1600" i="1" dirty="0">
                <a:latin typeface="Arial"/>
                <a:cs typeface="Arial"/>
              </a:rPr>
              <a:t>PEG10</a:t>
            </a:r>
            <a:r>
              <a:rPr lang="en-US" altLang="ja-JP" sz="1600" dirty="0">
                <a:latin typeface="Arial"/>
                <a:cs typeface="Arial"/>
              </a:rPr>
              <a:t>-DMR, </a:t>
            </a:r>
            <a:r>
              <a:rPr lang="en-US" altLang="ja-JP" sz="1600" i="1" dirty="0">
                <a:latin typeface="Arial"/>
                <a:cs typeface="Arial"/>
              </a:rPr>
              <a:t>MEST</a:t>
            </a:r>
            <a:r>
              <a:rPr lang="en-US" altLang="ja-JP" sz="1600" dirty="0">
                <a:latin typeface="Arial"/>
                <a:cs typeface="Arial"/>
              </a:rPr>
              <a:t>-DMR, and </a:t>
            </a:r>
            <a:r>
              <a:rPr lang="en-US" altLang="ja-JP" sz="1600" i="1" dirty="0">
                <a:latin typeface="Arial"/>
                <a:cs typeface="Arial"/>
              </a:rPr>
              <a:t>GNAS</a:t>
            </a:r>
            <a:r>
              <a:rPr lang="en-US" altLang="ja-JP" sz="1600" dirty="0">
                <a:latin typeface="Arial"/>
                <a:cs typeface="Arial"/>
              </a:rPr>
              <a:t> exon A/B-</a:t>
            </a:r>
            <a:r>
              <a:rPr lang="en-US" altLang="ja-JP" sz="1600" dirty="0" smtClean="0">
                <a:latin typeface="Arial"/>
                <a:cs typeface="Arial"/>
              </a:rPr>
              <a:t>DMR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.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The report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by Court </a:t>
            </a:r>
            <a:r>
              <a:rPr lang="en-US" altLang="ja-JP" sz="1600" i="1" dirty="0">
                <a:solidFill>
                  <a:srgbClr val="000000"/>
                </a:solidFill>
                <a:latin typeface="Arial"/>
                <a:cs typeface="Arial"/>
              </a:rPr>
              <a:t>et al.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(Genome </a:t>
            </a:r>
            <a:r>
              <a:rPr lang="en-US" altLang="ja-JP" sz="1600" dirty="0">
                <a:solidFill>
                  <a:srgbClr val="000000"/>
                </a:solidFill>
                <a:latin typeface="Arial"/>
                <a:cs typeface="Arial"/>
              </a:rPr>
              <a:t>Res. 2014;24:554-</a:t>
            </a:r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69) was referred to for information of probe positions for each DMR.  </a:t>
            </a:r>
          </a:p>
          <a:p>
            <a:endParaRPr lang="en-US" altLang="ja-JP" sz="1600" dirty="0">
              <a:solidFill>
                <a:srgbClr val="000000"/>
              </a:solidFill>
              <a:latin typeface="Arial"/>
              <a:cs typeface="Arial"/>
            </a:endParaRPr>
          </a:p>
          <a:p>
            <a:r>
              <a:rPr lang="en-US" altLang="ja-JP" sz="1600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endParaRPr kumimoji="1" lang="ja-JP" altLang="en-US" sz="16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12340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</TotalTime>
  <Words>358</Words>
  <Application>Microsoft Macintosh PowerPoint</Application>
  <PresentationFormat>A4 210x297 mm</PresentationFormat>
  <Paragraphs>125</Paragraphs>
  <Slides>9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0" baseType="lpstr"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ko Matsubara</dc:creator>
  <cp:lastModifiedBy>Yamazawa Kazuki</cp:lastModifiedBy>
  <cp:revision>22</cp:revision>
  <dcterms:created xsi:type="dcterms:W3CDTF">2015-07-14T03:51:24Z</dcterms:created>
  <dcterms:modified xsi:type="dcterms:W3CDTF">2015-07-30T03:24:13Z</dcterms:modified>
</cp:coreProperties>
</file>